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chart8.xml" ContentType="application/vnd.openxmlformats-officedocument.drawingml.chart+xml"/>
  <Override PartName="/ppt/charts/chart9.xml" ContentType="application/vnd.openxmlformats-officedocument.drawingml.chart+xml"/>
  <Override PartName="/ppt/charts/chart10.xml" ContentType="application/vnd.openxmlformats-officedocument.drawingml.chart+xml"/>
  <Override PartName="/ppt/charts/colors1.xml" ContentType="application/vnd.ms-office.chartcolorstyle+xml"/>
  <Override PartName="/ppt/charts/colors2.xml" ContentType="application/vnd.ms-office.chartcolorstyle+xml"/>
  <Override PartName="/ppt/charts/colors3.xml" ContentType="application/vnd.ms-office.chartcolorstyle+xml"/>
  <Override PartName="/ppt/charts/colors4.xml" ContentType="application/vnd.ms-office.chartcolorstyle+xml"/>
  <Override PartName="/ppt/charts/colors5.xml" ContentType="application/vnd.ms-office.chartcolorstyle+xml"/>
  <Override PartName="/ppt/charts/colors6.xml" ContentType="application/vnd.ms-office.chartcolorstyle+xml"/>
  <Override PartName="/ppt/charts/colors7.xml" ContentType="application/vnd.ms-office.chartcolorstyle+xml"/>
  <Override PartName="/ppt/charts/colors8.xml" ContentType="application/vnd.ms-office.chartcolorstyle+xml"/>
  <Override PartName="/ppt/charts/colors9.xml" ContentType="application/vnd.ms-office.chartcolorstyle+xml"/>
  <Override PartName="/ppt/charts/colors10.xml" ContentType="application/vnd.ms-office.chartcolorstyle+xml"/>
  <Override PartName="/ppt/charts/style1.xml" ContentType="application/vnd.ms-office.chartstyle+xml"/>
  <Override PartName="/ppt/charts/style2.xml" ContentType="application/vnd.ms-office.chartstyle+xml"/>
  <Override PartName="/ppt/charts/style3.xml" ContentType="application/vnd.ms-office.chartstyle+xml"/>
  <Override PartName="/ppt/charts/style4.xml" ContentType="application/vnd.ms-office.chartstyle+xml"/>
  <Override PartName="/ppt/charts/style5.xml" ContentType="application/vnd.ms-office.chartstyle+xml"/>
  <Override PartName="/ppt/charts/style6.xml" ContentType="application/vnd.ms-office.chartstyle+xml"/>
  <Override PartName="/ppt/charts/style7.xml" ContentType="application/vnd.ms-office.chartstyle+xml"/>
  <Override PartName="/ppt/charts/style8.xml" ContentType="application/vnd.ms-office.chartstyle+xml"/>
  <Override PartName="/ppt/charts/style9.xml" ContentType="application/vnd.ms-office.chartstyle+xml"/>
  <Override PartName="/ppt/charts/style10.xml" ContentType="application/vnd.ms-office.chartstyle+xml"/>
  <Override PartName="/ppt/notesMasters/notesMaster1.xml" ContentType="application/vnd.openxmlformats-officedocument.presentationml.notesMaster+xml"/>
  <Override PartName="/ppt/presentation.xml" ContentType="application/vnd.openxmlformats-officedocument.presentationml.presentation.main+xml"/>
  <Override PartName="/ppt/presProps.xml" ContentType="application/vnd.openxmlformats-officedocument.presentationml.presPro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 = '1.0' encoding = 'UTF-8' standalone = 'yes'?>
<Relationships xmlns="http://schemas.openxmlformats.org/package/2006/relationships">
   <Relationship Id="rId1" Type="http://schemas.openxmlformats.org/officeDocument/2006/relationships/officeDocument" Target="ppt/presentation.xml"/>
   <Relationship Id="rId2" Type="http://schemas.openxmlformats.org/package/2006/relationships/metadata/thumbnail" Target="docProps/thumbnail.jpeg"/>
   <Relationship Id="rId3" Type="http://schemas.openxmlformats.org/package/2006/relationships/metadata/core-properties" Target="docProps/core.xml"/>
   <Relationship Id="rId4" Type="http://schemas.openxmlformats.org/officeDocument/2006/relationships/extended-properties" Target="docProps/app.xml"/>
</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321" r:id="rId2"/>
    <p:sldId id="313" r:id="rId3"/>
    <p:sldId id="305" r:id="rId4"/>
    <p:sldId id="306" r:id="rId5"/>
    <p:sldId id="304" r:id="rId6"/>
    <p:sldId id="314" r:id="rId7"/>
    <p:sldId id="302" r:id="rId8"/>
    <p:sldId id="320" r:id="rId9"/>
    <p:sldId id="317" r:id="rId10"/>
    <p:sldId id="319" r:id="rId11"/>
    <p:sldId id="318"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CC9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0" d="100"/>
          <a:sy n="70" d="100"/>
        </p:scale>
        <p:origin x="714" y="72"/>
      </p:cViewPr>
      <p:guideLst/>
    </p:cSldViewPr>
  </p:slideViewPr>
  <p:notesTextViewPr>
    <p:cViewPr>
      <p:scale>
        <a:sx n="1" d="1"/>
        <a:sy n="1" d="1"/>
      </p:scale>
      <p:origin x="0" y="0"/>
    </p:cViewPr>
  </p:notesTextViewPr>
  <p:gridSpacing cx="76200" cy="76200"/>
</p:viewPr>
</file>

<file path=ppt/_rels/presentation.xml.rels><?xml version = '1.0' encoding = 'UTF-8' standalone = 'yes'?>
<Relationships xmlns="http://schemas.openxmlformats.org/package/2006/relationships">
   <Relationship Id="rId1" Type="http://schemas.openxmlformats.org/officeDocument/2006/relationships/slideMaster" Target="slideMasters/slideMaster1.xml"/>
   <Relationship Id="rId10" Type="http://schemas.openxmlformats.org/officeDocument/2006/relationships/slide" Target="slides/slide9.xml"/>
   <Relationship Id="rId11" Type="http://schemas.openxmlformats.org/officeDocument/2006/relationships/slide" Target="slides/slide10.xml"/>
   <Relationship Id="rId12" Type="http://schemas.openxmlformats.org/officeDocument/2006/relationships/slide" Target="slides/slide11.xml"/>
   <Relationship Id="rId13" Type="http://schemas.openxmlformats.org/officeDocument/2006/relationships/notesMaster" Target="notesMasters/notesMaster1.xml"/>
   <Relationship Id="rId14" Type="http://schemas.openxmlformats.org/officeDocument/2006/relationships/presProps" Target="presProps.xml"/>
   <Relationship Id="rId15" Type="http://schemas.openxmlformats.org/officeDocument/2006/relationships/viewProps" Target="viewProps.xml"/>
   <Relationship Id="rId16" Type="http://schemas.openxmlformats.org/officeDocument/2006/relationships/theme" Target="theme/theme1.xml"/>
   <Relationship Id="rId17" Type="http://schemas.openxmlformats.org/officeDocument/2006/relationships/tableStyles" Target="tableStyles.xml"/>
   <Relationship Id="rId2" Type="http://schemas.openxmlformats.org/officeDocument/2006/relationships/slide" Target="slides/slide1.xml"/>
   <Relationship Id="rId3" Type="http://schemas.openxmlformats.org/officeDocument/2006/relationships/slide" Target="slides/slide2.xml"/>
   <Relationship Id="rId4" Type="http://schemas.openxmlformats.org/officeDocument/2006/relationships/slide" Target="slides/slide3.xml"/>
   <Relationship Id="rId5" Type="http://schemas.openxmlformats.org/officeDocument/2006/relationships/slide" Target="slides/slide4.xml"/>
   <Relationship Id="rId6" Type="http://schemas.openxmlformats.org/officeDocument/2006/relationships/slide" Target="slides/slide5.xml"/>
   <Relationship Id="rId7" Type="http://schemas.openxmlformats.org/officeDocument/2006/relationships/slide" Target="slides/slide6.xml"/>
   <Relationship Id="rId8" Type="http://schemas.openxmlformats.org/officeDocument/2006/relationships/slide" Target="slides/slide7.xml"/>
   <Relationship Id="rId9" Type="http://schemas.openxmlformats.org/officeDocument/2006/relationships/slide" Target="slides/slide8.xml"/>
</Relationships>
</file>

<file path=ppt/charts/_rels/chart1.xml.rels><?xml version = '1.0' encoding = 'UTF-8' standalone = 'yes'?>
<Relationships xmlns="http://schemas.openxmlformats.org/package/2006/relationships">
   <Relationship Id="rId1" Type="http://schemas.microsoft.com/office/2011/relationships/chartStyle" Target="style1.xml"/>
   <Relationship Id="rId2" Type="http://schemas.microsoft.com/office/2011/relationships/chartColorStyle" Target="colors1.xml"/>
   <Relationship Id="rId3" Type="http://schemas.openxmlformats.org/officeDocument/2006/relationships/oleObject" TargetMode="External" Target="file:///C:/Users/gglinsky/Desktop/2015_2016%20VittorioS/2016_CSC%20VittorioS/HPATs%20BLastocyst%20Cells/Copy1%20of%20HPAT%20region%20and%20labels%20(230385).xlsx"/>
</Relationships>
</file>

<file path=ppt/charts/_rels/chart10.xml.rels><?xml version = '1.0' encoding = 'UTF-8' standalone = 'yes'?>
<Relationships xmlns="http://schemas.openxmlformats.org/package/2006/relationships">
   <Relationship Id="rId1" Type="http://schemas.microsoft.com/office/2011/relationships/chartStyle" Target="style10.xml"/>
   <Relationship Id="rId2" Type="http://schemas.microsoft.com/office/2011/relationships/chartColorStyle" Target="colors10.xml"/>
   <Relationship Id="rId3" Type="http://schemas.openxmlformats.org/officeDocument/2006/relationships/oleObject" TargetMode="External" Target="file:///C:/Users/gglinsky/Desktop/2015_2016%20VittorioS/2016_CSC%20VittorioS/HPATs%20BLastocyst%20Cells/Copy1%20of%20HPAT%20region%20and%20labels%20(230385).xlsx"/>
</Relationships>
</file>

<file path=ppt/charts/_rels/chart2.xml.rels><?xml version = '1.0' encoding = 'UTF-8' standalone = 'yes'?>
<Relationships xmlns="http://schemas.openxmlformats.org/package/2006/relationships">
   <Relationship Id="rId1" Type="http://schemas.microsoft.com/office/2011/relationships/chartStyle" Target="style2.xml"/>
   <Relationship Id="rId2" Type="http://schemas.microsoft.com/office/2011/relationships/chartColorStyle" Target="colors2.xml"/>
   <Relationship Id="rId3" Type="http://schemas.openxmlformats.org/officeDocument/2006/relationships/oleObject" TargetMode="External" Target="file:///C:/Users/gglinsky/Desktop/2015_2016%20VittorioS/2016_CSC%20VittorioS/HPATs%20BLastocyst%20Cells/Copy1%20of%20HPAT%20region%20and%20labels%20(230385).xlsx"/>
</Relationships>
</file>

<file path=ppt/charts/_rels/chart3.xml.rels><?xml version = '1.0' encoding = 'UTF-8' standalone = 'yes'?>
<Relationships xmlns="http://schemas.openxmlformats.org/package/2006/relationships">
   <Relationship Id="rId1" Type="http://schemas.microsoft.com/office/2011/relationships/chartStyle" Target="style3.xml"/>
   <Relationship Id="rId2" Type="http://schemas.microsoft.com/office/2011/relationships/chartColorStyle" Target="colors3.xml"/>
   <Relationship Id="rId3" Type="http://schemas.openxmlformats.org/officeDocument/2006/relationships/oleObject" TargetMode="External" Target="file:///C:/Users/gglinsky/Desktop/2015_2016%20VittorioS/2016_CSC%20VittorioS/HPATs%20BLastocyst%20Cells/Copy1%20of%20HPAT%20region%20and%20labels%20(230385).xlsx"/>
</Relationships>
</file>

<file path=ppt/charts/_rels/chart4.xml.rels><?xml version = '1.0' encoding = 'UTF-8' standalone = 'yes'?>
<Relationships xmlns="http://schemas.openxmlformats.org/package/2006/relationships">
   <Relationship Id="rId1" Type="http://schemas.microsoft.com/office/2011/relationships/chartStyle" Target="style4.xml"/>
   <Relationship Id="rId2" Type="http://schemas.microsoft.com/office/2011/relationships/chartColorStyle" Target="colors4.xml"/>
   <Relationship Id="rId3" Type="http://schemas.openxmlformats.org/officeDocument/2006/relationships/oleObject" TargetMode="External" Target="file:///C:/Users/gglinsky/Desktop/2015_2016%20VittorioS/2016_CSC%20VittorioS/HPATs%20BLastocyst%20Cells/Copy1%20of%20HPAT%20region%20and%20labels%20(230385).xlsx"/>
</Relationships>
</file>

<file path=ppt/charts/_rels/chart5.xml.rels><?xml version = '1.0' encoding = 'UTF-8' standalone = 'yes'?>
<Relationships xmlns="http://schemas.openxmlformats.org/package/2006/relationships">
   <Relationship Id="rId1" Type="http://schemas.microsoft.com/office/2011/relationships/chartStyle" Target="style5.xml"/>
   <Relationship Id="rId2" Type="http://schemas.microsoft.com/office/2011/relationships/chartColorStyle" Target="colors5.xml"/>
   <Relationship Id="rId3" Type="http://schemas.openxmlformats.org/officeDocument/2006/relationships/oleObject" TargetMode="External" Target="file:///C:/Users/gglinsky/Desktop/2015_2016%20VittorioS/2016_CSC%20VittorioS/HPATs%20BLastocyst%20Cells/Copy1%20of%20HPAT%20region%20and%20labels%20(230385).xlsx"/>
</Relationships>
</file>

<file path=ppt/charts/_rels/chart6.xml.rels><?xml version = '1.0' encoding = 'UTF-8' standalone = 'yes'?>
<Relationships xmlns="http://schemas.openxmlformats.org/package/2006/relationships">
   <Relationship Id="rId1" Type="http://schemas.microsoft.com/office/2011/relationships/chartStyle" Target="style6.xml"/>
   <Relationship Id="rId2" Type="http://schemas.microsoft.com/office/2011/relationships/chartColorStyle" Target="colors6.xml"/>
   <Relationship Id="rId3" Type="http://schemas.openxmlformats.org/officeDocument/2006/relationships/oleObject" TargetMode="External" Target="file:///C:/Users/gglinsky/Desktop/2015_2016%20VittorioS/2016_CSC%20VittorioS/HPATs%20BLastocyst%20Cells/Copy1%20of%20HPAT%20region%20and%20labels%20(230385).xlsx"/>
</Relationships>
</file>

<file path=ppt/charts/_rels/chart7.xml.rels><?xml version = '1.0' encoding = 'UTF-8' standalone = 'yes'?>
<Relationships xmlns="http://schemas.openxmlformats.org/package/2006/relationships">
   <Relationship Id="rId1" Type="http://schemas.microsoft.com/office/2011/relationships/chartStyle" Target="style7.xml"/>
   <Relationship Id="rId2" Type="http://schemas.microsoft.com/office/2011/relationships/chartColorStyle" Target="colors7.xml"/>
   <Relationship Id="rId3" Type="http://schemas.openxmlformats.org/officeDocument/2006/relationships/oleObject" TargetMode="External" Target="file:///C:/Users/gglinsky/Desktop/2015_2016%20VittorioS/2016_CSC%20VittorioS/HPATs%20BLastocyst%20Cells/HPATs%20Blastocysts.xlsx"/>
</Relationships>
</file>

<file path=ppt/charts/_rels/chart8.xml.rels><?xml version = '1.0' encoding = 'UTF-8' standalone = 'yes'?>
<Relationships xmlns="http://schemas.openxmlformats.org/package/2006/relationships">
   <Relationship Id="rId1" Type="http://schemas.microsoft.com/office/2011/relationships/chartStyle" Target="style8.xml"/>
   <Relationship Id="rId2" Type="http://schemas.microsoft.com/office/2011/relationships/chartColorStyle" Target="colors8.xml"/>
   <Relationship Id="rId3" Type="http://schemas.openxmlformats.org/officeDocument/2006/relationships/oleObject" TargetMode="External" Target="file:///C:/Users/gglinsky/Desktop/2015_2016%20VittorioS/2016_CSC%20VittorioS/HPATs%20BLastocyst%20Cells/Copy1%20of%20HPAT%20region%20and%20labels%20(230385).xlsx"/>
</Relationships>
</file>

<file path=ppt/charts/_rels/chart9.xml.rels><?xml version = '1.0' encoding = 'UTF-8' standalone = 'yes'?>
<Relationships xmlns="http://schemas.openxmlformats.org/package/2006/relationships">
   <Relationship Id="rId1" Type="http://schemas.microsoft.com/office/2011/relationships/chartStyle" Target="style9.xml"/>
   <Relationship Id="rId2" Type="http://schemas.microsoft.com/office/2011/relationships/chartColorStyle" Target="colors9.xml"/>
   <Relationship Id="rId3" Type="http://schemas.openxmlformats.org/officeDocument/2006/relationships/oleObject" TargetMode="External" Target="file:///C:/Users/gglinsky/Desktop/2015_2016%20VittorioS/2016_CSC%20VittorioS/HPATs%20BLastocyst%20Cells/Copy1%20of%20HPAT%20region%20and%20labels%20(230385).xlsx"/>
</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lumMod val="65000"/>
                    <a:lumOff val="35000"/>
                  </a:sysClr>
                </a:solidFill>
                <a:latin typeface="+mn-lt"/>
                <a:ea typeface="+mn-ea"/>
                <a:cs typeface="+mn-cs"/>
              </a:defRPr>
            </a:pPr>
            <a:r>
              <a:rPr lang="en-US" sz="1800" b="1" i="0" baseline="0">
                <a:effectLst/>
              </a:rPr>
              <a:t>Dynamics of expression changes in the human embryos of the LTR7/HERVH loci associated with the LINC-ROR lincRNA</a:t>
            </a:r>
            <a:endParaRPr lang="en-US">
              <a:effectLst/>
            </a:endParaRPr>
          </a:p>
        </c:rich>
      </c:tx>
      <c:layout/>
      <c:overlay val="0"/>
      <c:spPr>
        <a:noFill/>
        <a:ln>
          <a:noFill/>
        </a:ln>
        <a:effectLst/>
      </c:spPr>
      <c:txPr>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lumMod val="65000"/>
                  <a:lumOff val="35000"/>
                </a:sysClr>
              </a:solidFill>
              <a:latin typeface="+mn-lt"/>
              <a:ea typeface="+mn-ea"/>
              <a:cs typeface="+mn-cs"/>
            </a:defRPr>
          </a:pPr>
          <a:endParaRPr lang="en-US"/>
        </a:p>
      </c:txPr>
    </c:title>
    <c:autoTitleDeleted val="0"/>
    <c:plotArea>
      <c:layout>
        <c:manualLayout>
          <c:layoutTarget val="inner"/>
          <c:xMode val="edge"/>
          <c:yMode val="edge"/>
          <c:x val="0.11989365911358434"/>
          <c:y val="0.14331344180655131"/>
          <c:w val="0.84626775022057188"/>
          <c:h val="0.68081127536328667"/>
        </c:manualLayout>
      </c:layout>
      <c:areaChart>
        <c:grouping val="stacked"/>
        <c:varyColors val="0"/>
        <c:ser>
          <c:idx val="0"/>
          <c:order val="0"/>
          <c:tx>
            <c:strRef>
              <c:f>Sheet1!$E$65</c:f>
              <c:strCache>
                <c:ptCount val="1"/>
                <c:pt idx="0">
                  <c:v>LTR7</c:v>
                </c:pt>
              </c:strCache>
            </c:strRef>
          </c:tx>
          <c:spPr>
            <a:solidFill>
              <a:schemeClr val="accent1"/>
            </a:solidFill>
            <a:ln>
              <a:noFill/>
            </a:ln>
            <a:effectLst/>
          </c:spPr>
          <c:cat>
            <c:strRef>
              <c:f>Sheet1!$F$64:$P$64</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1!$F$65:$P$65</c:f>
              <c:numCache>
                <c:formatCode>General</c:formatCode>
                <c:ptCount val="11"/>
                <c:pt idx="0">
                  <c:v>0</c:v>
                </c:pt>
                <c:pt idx="1">
                  <c:v>0</c:v>
                </c:pt>
                <c:pt idx="2">
                  <c:v>0</c:v>
                </c:pt>
                <c:pt idx="3">
                  <c:v>0.62851792353272007</c:v>
                </c:pt>
                <c:pt idx="4">
                  <c:v>1.0949624925445902</c:v>
                </c:pt>
                <c:pt idx="5">
                  <c:v>0.80106955734266005</c:v>
                </c:pt>
                <c:pt idx="6">
                  <c:v>0</c:v>
                </c:pt>
                <c:pt idx="7">
                  <c:v>0.11438015164681037</c:v>
                </c:pt>
                <c:pt idx="8">
                  <c:v>1.8940951961134602</c:v>
                </c:pt>
                <c:pt idx="9">
                  <c:v>4.5332667632242796</c:v>
                </c:pt>
                <c:pt idx="10">
                  <c:v>1.6553053710758099</c:v>
                </c:pt>
              </c:numCache>
            </c:numRef>
          </c:val>
        </c:ser>
        <c:ser>
          <c:idx val="1"/>
          <c:order val="1"/>
          <c:tx>
            <c:strRef>
              <c:f>Sheet1!$E$66</c:f>
              <c:strCache>
                <c:ptCount val="1"/>
                <c:pt idx="0">
                  <c:v>HERVH-int</c:v>
                </c:pt>
              </c:strCache>
            </c:strRef>
          </c:tx>
          <c:spPr>
            <a:solidFill>
              <a:schemeClr val="accent2"/>
            </a:solidFill>
            <a:ln>
              <a:noFill/>
            </a:ln>
            <a:effectLst/>
          </c:spPr>
          <c:cat>
            <c:strRef>
              <c:f>Sheet1!$F$64:$P$64</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1!$F$66:$P$66</c:f>
              <c:numCache>
                <c:formatCode>General</c:formatCode>
                <c:ptCount val="11"/>
                <c:pt idx="0">
                  <c:v>0</c:v>
                </c:pt>
                <c:pt idx="1">
                  <c:v>0.65571029625230004</c:v>
                </c:pt>
                <c:pt idx="2">
                  <c:v>0.51358644483393001</c:v>
                </c:pt>
                <c:pt idx="3">
                  <c:v>0.67489887333509002</c:v>
                </c:pt>
                <c:pt idx="4">
                  <c:v>0.37314797671467992</c:v>
                </c:pt>
                <c:pt idx="5">
                  <c:v>0.34638123337446003</c:v>
                </c:pt>
                <c:pt idx="6">
                  <c:v>-1.4002646134703398</c:v>
                </c:pt>
                <c:pt idx="7">
                  <c:v>-1.8825741672689</c:v>
                </c:pt>
                <c:pt idx="8">
                  <c:v>0.24353901782951004</c:v>
                </c:pt>
                <c:pt idx="9">
                  <c:v>0.28356899389617007</c:v>
                </c:pt>
                <c:pt idx="10">
                  <c:v>-0.78003010992688981</c:v>
                </c:pt>
              </c:numCache>
            </c:numRef>
          </c:val>
        </c:ser>
        <c:dLbls>
          <c:showLegendKey val="0"/>
          <c:showVal val="0"/>
          <c:showCatName val="0"/>
          <c:showSerName val="0"/>
          <c:showPercent val="0"/>
          <c:showBubbleSize val="0"/>
        </c:dLbls>
        <c:axId val="299921104"/>
        <c:axId val="299923064"/>
      </c:areaChart>
      <c:catAx>
        <c:axId val="299921104"/>
        <c:scaling>
          <c:orientation val="minMax"/>
        </c:scaling>
        <c:delete val="0"/>
        <c:axPos val="b"/>
        <c:numFmt formatCode="General" sourceLinked="1"/>
        <c:majorTickMark val="none"/>
        <c:minorTickMark val="none"/>
        <c:tickLblPos val="low"/>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299923064"/>
        <c:crosses val="autoZero"/>
        <c:auto val="1"/>
        <c:lblAlgn val="ctr"/>
        <c:lblOffset val="100"/>
        <c:noMultiLvlLbl val="0"/>
      </c:catAx>
      <c:valAx>
        <c:axId val="299923064"/>
        <c:scaling>
          <c:orientation val="minMax"/>
        </c:scaling>
        <c:delete val="0"/>
        <c:axPos val="l"/>
        <c:majorGridlines>
          <c:spPr>
            <a:ln w="9525" cap="flat" cmpd="sng" algn="ctr">
              <a:noFill/>
              <a:round/>
            </a:ln>
            <a:effectLst/>
          </c:spPr>
        </c:majorGridlines>
        <c:minorGridlines>
          <c:spPr>
            <a:ln w="9525" cap="flat" cmpd="sng" algn="ctr">
              <a:noFill/>
              <a:round/>
            </a:ln>
            <a:effectLst/>
          </c:spPr>
        </c:minorGridlines>
        <c:title>
          <c:tx>
            <c:rich>
              <a:bodyPr rot="-5400000" spcFirstLastPara="1" vertOverflow="ellipsis" vert="horz" wrap="square" anchor="ctr" anchorCtr="1"/>
              <a:lstStyle/>
              <a:p>
                <a:pPr>
                  <a:defRPr sz="1800" b="1" i="0" u="none" strike="noStrike" kern="1200" baseline="0">
                    <a:solidFill>
                      <a:sysClr val="windowText" lastClr="000000"/>
                    </a:solidFill>
                    <a:latin typeface="+mn-lt"/>
                    <a:ea typeface="+mn-ea"/>
                    <a:cs typeface="+mn-cs"/>
                  </a:defRPr>
                </a:pPr>
                <a:r>
                  <a:rPr lang="en-US" sz="1800" b="1">
                    <a:solidFill>
                      <a:sysClr val="windowText" lastClr="000000"/>
                    </a:solidFill>
                  </a:rPr>
                  <a:t>RELATIVE</a:t>
                </a:r>
                <a:r>
                  <a:rPr lang="en-US" sz="1800" b="1" baseline="0">
                    <a:solidFill>
                      <a:sysClr val="windowText" lastClr="000000"/>
                    </a:solidFill>
                  </a:rPr>
                  <a:t> EXPRESSION</a:t>
                </a:r>
                <a:endParaRPr lang="en-US" sz="1800" b="1">
                  <a:solidFill>
                    <a:sysClr val="windowText" lastClr="000000"/>
                  </a:solidFill>
                </a:endParaRPr>
              </a:p>
            </c:rich>
          </c:tx>
          <c:layout>
            <c:manualLayout>
              <c:xMode val="edge"/>
              <c:yMode val="edge"/>
              <c:x val="2.7436692014945807E-2"/>
              <c:y val="0.30362213413344652"/>
            </c:manualLayout>
          </c:layout>
          <c:overlay val="0"/>
          <c:spPr>
            <a:noFill/>
            <a:ln>
              <a:noFill/>
            </a:ln>
            <a:effectLst/>
          </c:spPr>
          <c:txPr>
            <a:bodyPr rot="-5400000" spcFirstLastPara="1" vertOverflow="ellipsis" vert="horz" wrap="square" anchor="ctr" anchorCtr="1"/>
            <a:lstStyle/>
            <a:p>
              <a:pPr>
                <a:defRPr sz="1800" b="1"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299921104"/>
        <c:crosses val="autoZero"/>
        <c:crossBetween val="midCat"/>
      </c:valAx>
      <c:spPr>
        <a:noFill/>
        <a:ln>
          <a:noFill/>
        </a:ln>
        <a:effectLst/>
      </c:spPr>
    </c:plotArea>
    <c:legend>
      <c:legendPos val="t"/>
      <c:layout/>
      <c:overlay val="0"/>
      <c:spPr>
        <a:noFill/>
        <a:ln>
          <a:noFill/>
        </a:ln>
        <a:effectLst/>
      </c:spPr>
      <c:txPr>
        <a:bodyPr rot="0" spcFirstLastPara="1" vertOverflow="ellipsis" vert="horz" wrap="square" anchor="ctr" anchorCtr="1"/>
        <a:lstStyle/>
        <a:p>
          <a:pPr>
            <a:defRPr sz="1600" b="1" i="0" u="none" strike="noStrike" kern="1200" baseline="0">
              <a:solidFill>
                <a:sysClr val="windowText" lastClr="000000"/>
              </a:solidFill>
              <a:latin typeface="+mn-lt"/>
              <a:ea typeface="+mn-ea"/>
              <a:cs typeface="+mn-cs"/>
            </a:defRPr>
          </a:pPr>
          <a:endParaRPr lang="en-US"/>
        </a:p>
      </c:txPr>
    </c:legend>
    <c:plotVisOnly val="1"/>
    <c:dispBlanksAs val="zero"/>
    <c:showDLblsOverMax val="0"/>
  </c:chart>
  <c:spPr>
    <a:noFill/>
    <a:ln>
      <a:noFill/>
    </a:ln>
    <a:effectLst/>
  </c:spPr>
  <c:txPr>
    <a:bodyPr/>
    <a:lstStyle/>
    <a:p>
      <a:pPr>
        <a:defRPr/>
      </a:pPr>
      <a:endParaRPr lang="en-US"/>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lumMod val="65000"/>
                    <a:lumOff val="35000"/>
                  </a:sysClr>
                </a:solidFill>
                <a:latin typeface="+mn-lt"/>
                <a:ea typeface="+mn-ea"/>
                <a:cs typeface="+mn-cs"/>
              </a:defRPr>
            </a:pPr>
            <a:r>
              <a:rPr lang="en-US" sz="1800" b="1" i="0" baseline="0">
                <a:effectLst/>
              </a:rPr>
              <a:t>Single cell analysis of the HPAT18 expression in human embryos</a:t>
            </a:r>
            <a:endParaRPr lang="en-US">
              <a:effectLst/>
            </a:endParaRPr>
          </a:p>
        </c:rich>
      </c:tx>
      <c:overlay val="0"/>
      <c:spPr>
        <a:noFill/>
        <a:ln>
          <a:noFill/>
        </a:ln>
        <a:effectLst/>
      </c:spPr>
      <c:txPr>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lumMod val="65000"/>
                  <a:lumOff val="35000"/>
                </a:sysClr>
              </a:solidFill>
              <a:latin typeface="+mn-lt"/>
              <a:ea typeface="+mn-ea"/>
              <a:cs typeface="+mn-cs"/>
            </a:defRPr>
          </a:pPr>
          <a:endParaRPr lang="en-US"/>
        </a:p>
      </c:txPr>
    </c:title>
    <c:autoTitleDeleted val="0"/>
    <c:plotArea>
      <c:layout>
        <c:manualLayout>
          <c:layoutTarget val="inner"/>
          <c:xMode val="edge"/>
          <c:yMode val="edge"/>
          <c:x val="9.3695679373432275E-2"/>
          <c:y val="8.7438604190418046E-2"/>
          <c:w val="0.8901798233484568"/>
          <c:h val="0.70347235141379305"/>
        </c:manualLayout>
      </c:layout>
      <c:barChart>
        <c:barDir val="col"/>
        <c:grouping val="clustered"/>
        <c:varyColors val="0"/>
        <c:ser>
          <c:idx val="0"/>
          <c:order val="0"/>
          <c:tx>
            <c:strRef>
              <c:f>Sheet5!$D$35</c:f>
              <c:strCache>
                <c:ptCount val="1"/>
                <c:pt idx="0">
                  <c:v>HPAT17&amp;18</c:v>
                </c:pt>
              </c:strCache>
            </c:strRef>
          </c:tx>
          <c:spPr>
            <a:solidFill>
              <a:schemeClr val="accent1"/>
            </a:solidFill>
            <a:ln>
              <a:solidFill>
                <a:schemeClr val="accent1"/>
              </a:solidFill>
            </a:ln>
            <a:effectLst/>
          </c:spPr>
          <c:invertIfNegative val="0"/>
          <c:cat>
            <c:strRef>
              <c:f>Sheet5!$E$34:$EV$34</c:f>
              <c:strCache>
                <c:ptCount val="148"/>
                <c:pt idx="0">
                  <c:v>Oocyte</c:v>
                </c:pt>
                <c:pt idx="1">
                  <c:v>Oocyte</c:v>
                </c:pt>
                <c:pt idx="2">
                  <c:v>Oocyte</c:v>
                </c:pt>
                <c:pt idx="3">
                  <c:v>Oocyte</c:v>
                </c:pt>
                <c:pt idx="4">
                  <c:v>Oocyte</c:v>
                </c:pt>
                <c:pt idx="5">
                  <c:v>Oocyte</c:v>
                </c:pt>
                <c:pt idx="6">
                  <c:v>Pronuclei</c:v>
                </c:pt>
                <c:pt idx="7">
                  <c:v>Pronuclei</c:v>
                </c:pt>
                <c:pt idx="8">
                  <c:v>Pronuclei</c:v>
                </c:pt>
                <c:pt idx="9">
                  <c:v>Zygote</c:v>
                </c:pt>
                <c:pt idx="10">
                  <c:v>Zygote</c:v>
                </c:pt>
                <c:pt idx="11">
                  <c:v>Zygote</c:v>
                </c:pt>
                <c:pt idx="12">
                  <c:v>Zygote</c:v>
                </c:pt>
                <c:pt idx="13">
                  <c:v>Zygote</c:v>
                </c:pt>
                <c:pt idx="14">
                  <c:v>2-cell</c:v>
                </c:pt>
                <c:pt idx="15">
                  <c:v>2-cell</c:v>
                </c:pt>
                <c:pt idx="16">
                  <c:v>2-cell</c:v>
                </c:pt>
                <c:pt idx="17">
                  <c:v>2-cell</c:v>
                </c:pt>
                <c:pt idx="18">
                  <c:v>2-cell</c:v>
                </c:pt>
                <c:pt idx="19">
                  <c:v>2-cell</c:v>
                </c:pt>
                <c:pt idx="20">
                  <c:v>2-cell</c:v>
                </c:pt>
                <c:pt idx="21">
                  <c:v>2-cell</c:v>
                </c:pt>
                <c:pt idx="22">
                  <c:v>2-cell</c:v>
                </c:pt>
                <c:pt idx="23">
                  <c:v>4-cell</c:v>
                </c:pt>
                <c:pt idx="24">
                  <c:v>4-cell</c:v>
                </c:pt>
                <c:pt idx="25">
                  <c:v>4-cell</c:v>
                </c:pt>
                <c:pt idx="26">
                  <c:v>4-cell</c:v>
                </c:pt>
                <c:pt idx="27">
                  <c:v>4-cell</c:v>
                </c:pt>
                <c:pt idx="28">
                  <c:v>4-cell</c:v>
                </c:pt>
                <c:pt idx="29">
                  <c:v>4-cell</c:v>
                </c:pt>
                <c:pt idx="30">
                  <c:v>4-cell</c:v>
                </c:pt>
                <c:pt idx="31">
                  <c:v>4-cell</c:v>
                </c:pt>
                <c:pt idx="32">
                  <c:v>4-cell</c:v>
                </c:pt>
                <c:pt idx="33">
                  <c:v>4-cell</c:v>
                </c:pt>
                <c:pt idx="34">
                  <c:v>4-cell</c:v>
                </c:pt>
                <c:pt idx="35">
                  <c:v>4-cell</c:v>
                </c:pt>
                <c:pt idx="36">
                  <c:v>4-cell</c:v>
                </c:pt>
                <c:pt idx="37">
                  <c:v>4-cell</c:v>
                </c:pt>
                <c:pt idx="38">
                  <c:v>4-cell</c:v>
                </c:pt>
                <c:pt idx="39">
                  <c:v>8-cell</c:v>
                </c:pt>
                <c:pt idx="40">
                  <c:v>8-cell</c:v>
                </c:pt>
                <c:pt idx="41">
                  <c:v>8-cell</c:v>
                </c:pt>
                <c:pt idx="42">
                  <c:v>8-cell</c:v>
                </c:pt>
                <c:pt idx="43">
                  <c:v>8-cell</c:v>
                </c:pt>
                <c:pt idx="44">
                  <c:v>8-cell</c:v>
                </c:pt>
                <c:pt idx="45">
                  <c:v>8-cell</c:v>
                </c:pt>
                <c:pt idx="46">
                  <c:v>8-cell</c:v>
                </c:pt>
                <c:pt idx="47">
                  <c:v>8-cell</c:v>
                </c:pt>
                <c:pt idx="48">
                  <c:v>8-cell</c:v>
                </c:pt>
                <c:pt idx="49">
                  <c:v>8-cell</c:v>
                </c:pt>
                <c:pt idx="50">
                  <c:v>8-cell</c:v>
                </c:pt>
                <c:pt idx="51">
                  <c:v>8-cell</c:v>
                </c:pt>
                <c:pt idx="52">
                  <c:v>8-cell</c:v>
                </c:pt>
                <c:pt idx="53">
                  <c:v>8-cell</c:v>
                </c:pt>
                <c:pt idx="54">
                  <c:v>8-cell</c:v>
                </c:pt>
                <c:pt idx="55">
                  <c:v>8-cell</c:v>
                </c:pt>
                <c:pt idx="56">
                  <c:v>8-cell</c:v>
                </c:pt>
                <c:pt idx="57">
                  <c:v>8-cell</c:v>
                </c:pt>
                <c:pt idx="58">
                  <c:v>8-cell</c:v>
                </c:pt>
                <c:pt idx="59">
                  <c:v>8-cell</c:v>
                </c:pt>
                <c:pt idx="60">
                  <c:v>8-cell</c:v>
                </c:pt>
                <c:pt idx="61">
                  <c:v>8-cell</c:v>
                </c:pt>
                <c:pt idx="62">
                  <c:v>8-cell</c:v>
                </c:pt>
                <c:pt idx="63">
                  <c:v>8-cell</c:v>
                </c:pt>
                <c:pt idx="64">
                  <c:v>8-cell</c:v>
                </c:pt>
                <c:pt idx="65">
                  <c:v>Morulae</c:v>
                </c:pt>
                <c:pt idx="66">
                  <c:v>Morulae</c:v>
                </c:pt>
                <c:pt idx="67">
                  <c:v>Morulae</c:v>
                </c:pt>
                <c:pt idx="68">
                  <c:v>Morulae</c:v>
                </c:pt>
                <c:pt idx="69">
                  <c:v>Morulae</c:v>
                </c:pt>
                <c:pt idx="70">
                  <c:v>Morulae</c:v>
                </c:pt>
                <c:pt idx="71">
                  <c:v>Morulae</c:v>
                </c:pt>
                <c:pt idx="72">
                  <c:v>Morulae</c:v>
                </c:pt>
                <c:pt idx="73">
                  <c:v>Morulae</c:v>
                </c:pt>
                <c:pt idx="74">
                  <c:v>Morulae</c:v>
                </c:pt>
                <c:pt idx="75">
                  <c:v>Morulae</c:v>
                </c:pt>
                <c:pt idx="76">
                  <c:v>Morulae</c:v>
                </c:pt>
                <c:pt idx="77">
                  <c:v>Morulae</c:v>
                </c:pt>
                <c:pt idx="78">
                  <c:v>Morulae</c:v>
                </c:pt>
                <c:pt idx="79">
                  <c:v>Morulae</c:v>
                </c:pt>
                <c:pt idx="80">
                  <c:v>Morulae</c:v>
                </c:pt>
                <c:pt idx="81">
                  <c:v>Morulae</c:v>
                </c:pt>
                <c:pt idx="82">
                  <c:v>Morulae</c:v>
                </c:pt>
                <c:pt idx="83">
                  <c:v>Morulae</c:v>
                </c:pt>
                <c:pt idx="84">
                  <c:v>Late_blastocyst</c:v>
                </c:pt>
                <c:pt idx="85">
                  <c:v>Late_blastocyst</c:v>
                </c:pt>
                <c:pt idx="86">
                  <c:v>Late_blastocyst</c:v>
                </c:pt>
                <c:pt idx="87">
                  <c:v>Late_blastocyst</c:v>
                </c:pt>
                <c:pt idx="88">
                  <c:v>Late_blastocyst</c:v>
                </c:pt>
                <c:pt idx="89">
                  <c:v>Late_blastocyst</c:v>
                </c:pt>
                <c:pt idx="90">
                  <c:v>Late_blastocyst</c:v>
                </c:pt>
                <c:pt idx="91">
                  <c:v>Late_blastocyst</c:v>
                </c:pt>
                <c:pt idx="92">
                  <c:v>Late_blastocyst</c:v>
                </c:pt>
                <c:pt idx="93">
                  <c:v>Late_blastocyst</c:v>
                </c:pt>
                <c:pt idx="94">
                  <c:v>Late_blastocyst</c:v>
                </c:pt>
                <c:pt idx="95">
                  <c:v>Late_blastocyst</c:v>
                </c:pt>
                <c:pt idx="96">
                  <c:v>Late_blastocyst</c:v>
                </c:pt>
                <c:pt idx="97">
                  <c:v>Late_blastocyst</c:v>
                </c:pt>
                <c:pt idx="98">
                  <c:v>Late_blastocyst</c:v>
                </c:pt>
                <c:pt idx="99">
                  <c:v>Late_blastocyst</c:v>
                </c:pt>
                <c:pt idx="100">
                  <c:v>Late_blastocyst</c:v>
                </c:pt>
                <c:pt idx="101">
                  <c:v>Late_blastocyst</c:v>
                </c:pt>
                <c:pt idx="102">
                  <c:v>Late_blastocyst</c:v>
                </c:pt>
                <c:pt idx="103">
                  <c:v>Late_blastocyst</c:v>
                </c:pt>
                <c:pt idx="104">
                  <c:v>Late_blastocyst</c:v>
                </c:pt>
                <c:pt idx="105">
                  <c:v>Late_blastocyst</c:v>
                </c:pt>
                <c:pt idx="106">
                  <c:v>Late_blastocyst</c:v>
                </c:pt>
                <c:pt idx="107">
                  <c:v>Late_blastocyst</c:v>
                </c:pt>
                <c:pt idx="108">
                  <c:v>Late_blastocyst</c:v>
                </c:pt>
                <c:pt idx="109">
                  <c:v>Late_blastocyst</c:v>
                </c:pt>
                <c:pt idx="110">
                  <c:v>Late_blastocyst</c:v>
                </c:pt>
                <c:pt idx="111">
                  <c:v>Late_blastocyst</c:v>
                </c:pt>
                <c:pt idx="112">
                  <c:v>Late_blastocyst</c:v>
                </c:pt>
                <c:pt idx="113">
                  <c:v>Late_blastocyst</c:v>
                </c:pt>
                <c:pt idx="114">
                  <c:v>hESC_P0</c:v>
                </c:pt>
                <c:pt idx="115">
                  <c:v>hESC_P0</c:v>
                </c:pt>
                <c:pt idx="116">
                  <c:v>hESC_P0</c:v>
                </c:pt>
                <c:pt idx="117">
                  <c:v>hESC_P0</c:v>
                </c:pt>
                <c:pt idx="118">
                  <c:v>hESC_P0</c:v>
                </c:pt>
                <c:pt idx="119">
                  <c:v>hESC_P0</c:v>
                </c:pt>
                <c:pt idx="120">
                  <c:v>hESC_P0</c:v>
                </c:pt>
                <c:pt idx="121">
                  <c:v>hESC_P0</c:v>
                </c:pt>
                <c:pt idx="122">
                  <c:v>hESC_P10</c:v>
                </c:pt>
                <c:pt idx="123">
                  <c:v>hESC_P10</c:v>
                </c:pt>
                <c:pt idx="124">
                  <c:v>hESC_P10</c:v>
                </c:pt>
                <c:pt idx="125">
                  <c:v>hESC_P10</c:v>
                </c:pt>
                <c:pt idx="126">
                  <c:v>hESC_P10</c:v>
                </c:pt>
                <c:pt idx="127">
                  <c:v>hESC_P10</c:v>
                </c:pt>
                <c:pt idx="128">
                  <c:v>hESC_P10</c:v>
                </c:pt>
                <c:pt idx="129">
                  <c:v>hESC_P10</c:v>
                </c:pt>
                <c:pt idx="130">
                  <c:v>hESC_P10</c:v>
                </c:pt>
                <c:pt idx="131">
                  <c:v>hESC_P10</c:v>
                </c:pt>
                <c:pt idx="132">
                  <c:v>hESC_P10</c:v>
                </c:pt>
                <c:pt idx="133">
                  <c:v>hESC_P10</c:v>
                </c:pt>
                <c:pt idx="134">
                  <c:v>hESC_P10</c:v>
                </c:pt>
                <c:pt idx="135">
                  <c:v>hESC_P10</c:v>
                </c:pt>
                <c:pt idx="136">
                  <c:v>hESC_P10</c:v>
                </c:pt>
                <c:pt idx="137">
                  <c:v>hESC_P10</c:v>
                </c:pt>
                <c:pt idx="138">
                  <c:v>hESC_P10</c:v>
                </c:pt>
                <c:pt idx="139">
                  <c:v>hESC_P10</c:v>
                </c:pt>
                <c:pt idx="140">
                  <c:v>hESC_P10</c:v>
                </c:pt>
                <c:pt idx="141">
                  <c:v>hESC_P10</c:v>
                </c:pt>
                <c:pt idx="142">
                  <c:v>hESC_P10</c:v>
                </c:pt>
                <c:pt idx="143">
                  <c:v>hESC_P10</c:v>
                </c:pt>
                <c:pt idx="144">
                  <c:v>hESC_P10</c:v>
                </c:pt>
                <c:pt idx="145">
                  <c:v>hESC_P10</c:v>
                </c:pt>
                <c:pt idx="146">
                  <c:v>hESC_P10</c:v>
                </c:pt>
                <c:pt idx="147">
                  <c:v>hESC_P10</c:v>
                </c:pt>
              </c:strCache>
            </c:strRef>
          </c:cat>
          <c:val>
            <c:numRef>
              <c:f>Sheet5!$E$35:$EV$35</c:f>
              <c:numCache>
                <c:formatCode>General</c:formatCode>
                <c:ptCount val="148"/>
                <c:pt idx="0">
                  <c:v>0.1114</c:v>
                </c:pt>
                <c:pt idx="1">
                  <c:v>0.1444</c:v>
                </c:pt>
                <c:pt idx="2">
                  <c:v>0.1166</c:v>
                </c:pt>
                <c:pt idx="3">
                  <c:v>4.1000000000000003E-3</c:v>
                </c:pt>
                <c:pt idx="4">
                  <c:v>0.1263</c:v>
                </c:pt>
                <c:pt idx="5">
                  <c:v>0.12970000000000001</c:v>
                </c:pt>
                <c:pt idx="6">
                  <c:v>1.9599999999999999E-2</c:v>
                </c:pt>
                <c:pt idx="7">
                  <c:v>1.24E-2</c:v>
                </c:pt>
                <c:pt idx="8">
                  <c:v>1.7100000000000001E-2</c:v>
                </c:pt>
                <c:pt idx="9">
                  <c:v>3.3500000000000002E-2</c:v>
                </c:pt>
                <c:pt idx="10">
                  <c:v>0.1139</c:v>
                </c:pt>
                <c:pt idx="11">
                  <c:v>9.6799999999999997E-2</c:v>
                </c:pt>
                <c:pt idx="12">
                  <c:v>4.7999999999999996E-3</c:v>
                </c:pt>
                <c:pt idx="13">
                  <c:v>0</c:v>
                </c:pt>
                <c:pt idx="14">
                  <c:v>0.1366</c:v>
                </c:pt>
                <c:pt idx="15">
                  <c:v>0.14710000000000001</c:v>
                </c:pt>
                <c:pt idx="16">
                  <c:v>0.12590000000000001</c:v>
                </c:pt>
                <c:pt idx="17">
                  <c:v>0.1106</c:v>
                </c:pt>
                <c:pt idx="18">
                  <c:v>3.2899999999999999E-2</c:v>
                </c:pt>
                <c:pt idx="19">
                  <c:v>1.8100000000000002E-2</c:v>
                </c:pt>
                <c:pt idx="20">
                  <c:v>0</c:v>
                </c:pt>
                <c:pt idx="21">
                  <c:v>2.0299999999999999E-2</c:v>
                </c:pt>
                <c:pt idx="22">
                  <c:v>5.7999999999999996E-3</c:v>
                </c:pt>
                <c:pt idx="23">
                  <c:v>0.32819999999999999</c:v>
                </c:pt>
                <c:pt idx="24">
                  <c:v>9.8900000000000002E-2</c:v>
                </c:pt>
                <c:pt idx="25">
                  <c:v>0.22450000000000001</c:v>
                </c:pt>
                <c:pt idx="26">
                  <c:v>2.3999999999999998E-3</c:v>
                </c:pt>
                <c:pt idx="27">
                  <c:v>2.5999999999999999E-3</c:v>
                </c:pt>
                <c:pt idx="28">
                  <c:v>0</c:v>
                </c:pt>
                <c:pt idx="29">
                  <c:v>0.1182</c:v>
                </c:pt>
                <c:pt idx="30">
                  <c:v>0.1082</c:v>
                </c:pt>
                <c:pt idx="31">
                  <c:v>0.14449999999999999</c:v>
                </c:pt>
                <c:pt idx="32">
                  <c:v>3.04E-2</c:v>
                </c:pt>
                <c:pt idx="33">
                  <c:v>0.17879999999999999</c:v>
                </c:pt>
                <c:pt idx="34">
                  <c:v>5.7700000000000001E-2</c:v>
                </c:pt>
                <c:pt idx="35">
                  <c:v>3.8999999999999998E-3</c:v>
                </c:pt>
                <c:pt idx="36">
                  <c:v>1.8E-3</c:v>
                </c:pt>
                <c:pt idx="37">
                  <c:v>0</c:v>
                </c:pt>
                <c:pt idx="38">
                  <c:v>0</c:v>
                </c:pt>
                <c:pt idx="39">
                  <c:v>4.5499999999999999E-2</c:v>
                </c:pt>
                <c:pt idx="40">
                  <c:v>6.8099999999999994E-2</c:v>
                </c:pt>
                <c:pt idx="41">
                  <c:v>0.15160000000000001</c:v>
                </c:pt>
                <c:pt idx="42">
                  <c:v>0</c:v>
                </c:pt>
                <c:pt idx="43">
                  <c:v>2.12E-2</c:v>
                </c:pt>
                <c:pt idx="44">
                  <c:v>8.6499999999999994E-2</c:v>
                </c:pt>
                <c:pt idx="45">
                  <c:v>0.1772</c:v>
                </c:pt>
                <c:pt idx="46">
                  <c:v>0.3407</c:v>
                </c:pt>
                <c:pt idx="47">
                  <c:v>0.38950000000000001</c:v>
                </c:pt>
                <c:pt idx="48">
                  <c:v>0.18920000000000001</c:v>
                </c:pt>
                <c:pt idx="49">
                  <c:v>0.13669999999999999</c:v>
                </c:pt>
                <c:pt idx="50">
                  <c:v>9.5999999999999992E-3</c:v>
                </c:pt>
                <c:pt idx="51">
                  <c:v>1.8E-3</c:v>
                </c:pt>
                <c:pt idx="52">
                  <c:v>0</c:v>
                </c:pt>
                <c:pt idx="53">
                  <c:v>0.31890000000000002</c:v>
                </c:pt>
                <c:pt idx="54">
                  <c:v>1.8E-3</c:v>
                </c:pt>
                <c:pt idx="55">
                  <c:v>0.1094</c:v>
                </c:pt>
                <c:pt idx="56">
                  <c:v>2.3E-3</c:v>
                </c:pt>
                <c:pt idx="57">
                  <c:v>7.1000000000000004E-3</c:v>
                </c:pt>
                <c:pt idx="58">
                  <c:v>0.17230000000000001</c:v>
                </c:pt>
                <c:pt idx="59">
                  <c:v>8.5000000000000006E-3</c:v>
                </c:pt>
                <c:pt idx="60">
                  <c:v>0</c:v>
                </c:pt>
                <c:pt idx="61">
                  <c:v>0</c:v>
                </c:pt>
                <c:pt idx="62">
                  <c:v>7.0000000000000001E-3</c:v>
                </c:pt>
                <c:pt idx="63">
                  <c:v>0</c:v>
                </c:pt>
                <c:pt idx="64">
                  <c:v>0</c:v>
                </c:pt>
                <c:pt idx="65">
                  <c:v>0</c:v>
                </c:pt>
                <c:pt idx="66">
                  <c:v>0</c:v>
                </c:pt>
                <c:pt idx="67">
                  <c:v>1.6500000000000001E-2</c:v>
                </c:pt>
                <c:pt idx="68">
                  <c:v>0.23280000000000001</c:v>
                </c:pt>
                <c:pt idx="69">
                  <c:v>0</c:v>
                </c:pt>
                <c:pt idx="70">
                  <c:v>2.5999999999999999E-3</c:v>
                </c:pt>
                <c:pt idx="71">
                  <c:v>0</c:v>
                </c:pt>
                <c:pt idx="72">
                  <c:v>2.5999999999999999E-3</c:v>
                </c:pt>
                <c:pt idx="73">
                  <c:v>3.8999999999999998E-3</c:v>
                </c:pt>
                <c:pt idx="74">
                  <c:v>0</c:v>
                </c:pt>
                <c:pt idx="75">
                  <c:v>0</c:v>
                </c:pt>
                <c:pt idx="76">
                  <c:v>1.9E-3</c:v>
                </c:pt>
                <c:pt idx="77">
                  <c:v>0</c:v>
                </c:pt>
                <c:pt idx="78">
                  <c:v>0</c:v>
                </c:pt>
                <c:pt idx="79">
                  <c:v>2.8999999999999998E-3</c:v>
                </c:pt>
                <c:pt idx="80">
                  <c:v>2.0999999999999999E-3</c:v>
                </c:pt>
                <c:pt idx="81">
                  <c:v>0</c:v>
                </c:pt>
                <c:pt idx="82">
                  <c:v>0</c:v>
                </c:pt>
                <c:pt idx="83">
                  <c:v>0</c:v>
                </c:pt>
                <c:pt idx="84">
                  <c:v>0</c:v>
                </c:pt>
                <c:pt idx="85">
                  <c:v>0</c:v>
                </c:pt>
                <c:pt idx="86">
                  <c:v>0</c:v>
                </c:pt>
                <c:pt idx="87">
                  <c:v>0</c:v>
                </c:pt>
                <c:pt idx="88">
                  <c:v>0</c:v>
                </c:pt>
                <c:pt idx="89">
                  <c:v>3.2000000000000002E-3</c:v>
                </c:pt>
                <c:pt idx="90">
                  <c:v>2.3999999999999998E-3</c:v>
                </c:pt>
                <c:pt idx="91">
                  <c:v>0</c:v>
                </c:pt>
                <c:pt idx="92">
                  <c:v>8.5000000000000006E-3</c:v>
                </c:pt>
                <c:pt idx="93">
                  <c:v>0</c:v>
                </c:pt>
                <c:pt idx="94">
                  <c:v>0</c:v>
                </c:pt>
                <c:pt idx="95">
                  <c:v>6.8999999999999999E-3</c:v>
                </c:pt>
                <c:pt idx="96">
                  <c:v>2.5999999999999999E-3</c:v>
                </c:pt>
                <c:pt idx="97">
                  <c:v>1.0699999999999999E-2</c:v>
                </c:pt>
                <c:pt idx="98">
                  <c:v>0</c:v>
                </c:pt>
                <c:pt idx="99">
                  <c:v>3.0000000000000001E-3</c:v>
                </c:pt>
                <c:pt idx="100">
                  <c:v>3.0000000000000001E-3</c:v>
                </c:pt>
                <c:pt idx="101">
                  <c:v>0</c:v>
                </c:pt>
                <c:pt idx="102">
                  <c:v>8.3000000000000001E-3</c:v>
                </c:pt>
                <c:pt idx="103">
                  <c:v>3.3999999999999998E-3</c:v>
                </c:pt>
                <c:pt idx="104">
                  <c:v>2.2000000000000001E-3</c:v>
                </c:pt>
                <c:pt idx="105">
                  <c:v>2.2000000000000001E-3</c:v>
                </c:pt>
                <c:pt idx="106">
                  <c:v>1.6000000000000001E-3</c:v>
                </c:pt>
                <c:pt idx="107">
                  <c:v>0</c:v>
                </c:pt>
                <c:pt idx="108">
                  <c:v>2.5999999999999999E-3</c:v>
                </c:pt>
                <c:pt idx="109">
                  <c:v>1.03E-2</c:v>
                </c:pt>
                <c:pt idx="110">
                  <c:v>2.0799999999999999E-2</c:v>
                </c:pt>
                <c:pt idx="111">
                  <c:v>0</c:v>
                </c:pt>
                <c:pt idx="112">
                  <c:v>0</c:v>
                </c:pt>
                <c:pt idx="113">
                  <c:v>0</c:v>
                </c:pt>
                <c:pt idx="114">
                  <c:v>3.7957999999999998</c:v>
                </c:pt>
                <c:pt idx="115">
                  <c:v>0.99609999999999999</c:v>
                </c:pt>
                <c:pt idx="116">
                  <c:v>3.9199999999999999E-2</c:v>
                </c:pt>
                <c:pt idx="117">
                  <c:v>3.5065</c:v>
                </c:pt>
                <c:pt idx="118">
                  <c:v>3.222</c:v>
                </c:pt>
                <c:pt idx="119">
                  <c:v>7.4595000000000002</c:v>
                </c:pt>
                <c:pt idx="120">
                  <c:v>5.9470000000000001</c:v>
                </c:pt>
                <c:pt idx="121">
                  <c:v>0.50729999999999997</c:v>
                </c:pt>
                <c:pt idx="122">
                  <c:v>0.2492</c:v>
                </c:pt>
                <c:pt idx="123">
                  <c:v>1.0834999999999999</c:v>
                </c:pt>
                <c:pt idx="124">
                  <c:v>1.7600000000000001E-2</c:v>
                </c:pt>
                <c:pt idx="125">
                  <c:v>0.34810000000000002</c:v>
                </c:pt>
                <c:pt idx="126">
                  <c:v>1.4999999999999999E-2</c:v>
                </c:pt>
                <c:pt idx="127">
                  <c:v>0.1641</c:v>
                </c:pt>
                <c:pt idx="128">
                  <c:v>3.8699999999999998E-2</c:v>
                </c:pt>
                <c:pt idx="129">
                  <c:v>1.84E-2</c:v>
                </c:pt>
                <c:pt idx="130">
                  <c:v>7.1000000000000004E-3</c:v>
                </c:pt>
                <c:pt idx="131">
                  <c:v>0.86229999999999996</c:v>
                </c:pt>
                <c:pt idx="132">
                  <c:v>3.8999999999999998E-3</c:v>
                </c:pt>
                <c:pt idx="133">
                  <c:v>6.7999999999999996E-3</c:v>
                </c:pt>
                <c:pt idx="134">
                  <c:v>0.22090000000000001</c:v>
                </c:pt>
                <c:pt idx="135">
                  <c:v>1.06E-2</c:v>
                </c:pt>
                <c:pt idx="136">
                  <c:v>1.06E-2</c:v>
                </c:pt>
                <c:pt idx="137">
                  <c:v>0</c:v>
                </c:pt>
                <c:pt idx="138">
                  <c:v>0.01</c:v>
                </c:pt>
                <c:pt idx="139">
                  <c:v>0.1042</c:v>
                </c:pt>
                <c:pt idx="140">
                  <c:v>1.5245</c:v>
                </c:pt>
                <c:pt idx="141">
                  <c:v>7.3499999999999996E-2</c:v>
                </c:pt>
                <c:pt idx="142">
                  <c:v>7.4999999999999997E-3</c:v>
                </c:pt>
                <c:pt idx="143">
                  <c:v>0</c:v>
                </c:pt>
                <c:pt idx="144">
                  <c:v>8.8000000000000005E-3</c:v>
                </c:pt>
                <c:pt idx="145">
                  <c:v>7.3000000000000001E-3</c:v>
                </c:pt>
                <c:pt idx="146">
                  <c:v>7.3000000000000001E-3</c:v>
                </c:pt>
                <c:pt idx="147">
                  <c:v>8.5000000000000006E-3</c:v>
                </c:pt>
              </c:numCache>
            </c:numRef>
          </c:val>
        </c:ser>
        <c:dLbls>
          <c:showLegendKey val="0"/>
          <c:showVal val="0"/>
          <c:showCatName val="0"/>
          <c:showSerName val="0"/>
          <c:showPercent val="0"/>
          <c:showBubbleSize val="0"/>
        </c:dLbls>
        <c:gapWidth val="150"/>
        <c:axId val="302055736"/>
        <c:axId val="302832152"/>
      </c:barChart>
      <c:catAx>
        <c:axId val="302055736"/>
        <c:scaling>
          <c:orientation val="minMax"/>
        </c:scaling>
        <c:delete val="0"/>
        <c:axPos val="b"/>
        <c:title>
          <c:tx>
            <c:rich>
              <a:bodyPr rot="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r>
                  <a:rPr lang="en-US" sz="1400" b="1">
                    <a:solidFill>
                      <a:sysClr val="windowText" lastClr="000000"/>
                    </a:solidFill>
                  </a:rPr>
                  <a:t>EMBRYOGENESIS</a:t>
                </a:r>
                <a:r>
                  <a:rPr lang="en-US" sz="1400" b="1" baseline="0">
                    <a:solidFill>
                      <a:sysClr val="windowText" lastClr="000000"/>
                    </a:solidFill>
                  </a:rPr>
                  <a:t> STAGE</a:t>
                </a:r>
                <a:endParaRPr lang="en-US" sz="1400" b="1">
                  <a:solidFill>
                    <a:sysClr val="windowText" lastClr="000000"/>
                  </a:solidFill>
                </a:endParaRPr>
              </a:p>
            </c:rich>
          </c:tx>
          <c:overlay val="0"/>
          <c:spPr>
            <a:noFill/>
            <a:ln>
              <a:noFill/>
            </a:ln>
            <a:effectLst/>
          </c:spPr>
          <c:txPr>
            <a:bodyPr rot="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mn-lt"/>
                <a:ea typeface="+mn-ea"/>
                <a:cs typeface="+mn-cs"/>
              </a:defRPr>
            </a:pPr>
            <a:endParaRPr lang="en-US"/>
          </a:p>
        </c:txPr>
        <c:crossAx val="302832152"/>
        <c:crosses val="autoZero"/>
        <c:auto val="1"/>
        <c:lblAlgn val="ctr"/>
        <c:lblOffset val="100"/>
        <c:noMultiLvlLbl val="0"/>
      </c:catAx>
      <c:valAx>
        <c:axId val="302832152"/>
        <c:scaling>
          <c:orientation val="minMax"/>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r>
                  <a:rPr lang="en-US" sz="1400" b="1">
                    <a:solidFill>
                      <a:sysClr val="windowText" lastClr="000000"/>
                    </a:solidFill>
                  </a:rPr>
                  <a:t>HPAT18</a:t>
                </a:r>
                <a:r>
                  <a:rPr lang="en-US" sz="1400" b="1" baseline="0">
                    <a:solidFill>
                      <a:sysClr val="windowText" lastClr="000000"/>
                    </a:solidFill>
                  </a:rPr>
                  <a:t> EXPRESSION</a:t>
                </a:r>
                <a:endParaRPr lang="en-US" sz="1400" b="1">
                  <a:solidFill>
                    <a:sysClr val="windowText" lastClr="000000"/>
                  </a:solidFill>
                </a:endParaRPr>
              </a:p>
            </c:rich>
          </c:tx>
          <c:layout>
            <c:manualLayout>
              <c:xMode val="edge"/>
              <c:yMode val="edge"/>
              <c:x val="1.4658633889191808E-2"/>
              <c:y val="0.28331019810434233"/>
            </c:manualLayout>
          </c:layout>
          <c:overlay val="0"/>
          <c:spPr>
            <a:noFill/>
            <a:ln>
              <a:noFill/>
            </a:ln>
            <a:effectLst/>
          </c:spPr>
          <c:txPr>
            <a:bodyPr rot="-54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mn-lt"/>
                <a:ea typeface="+mn-ea"/>
                <a:cs typeface="+mn-cs"/>
              </a:defRPr>
            </a:pPr>
            <a:endParaRPr lang="en-US"/>
          </a:p>
        </c:txPr>
        <c:crossAx val="302055736"/>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solidFill>
                <a:latin typeface="+mn-lt"/>
                <a:ea typeface="+mn-ea"/>
                <a:cs typeface="+mn-cs"/>
              </a:defRPr>
            </a:pPr>
            <a:r>
              <a:rPr lang="en-US" sz="1800" b="1" i="0" baseline="0">
                <a:solidFill>
                  <a:sysClr val="windowText" lastClr="000000"/>
                </a:solidFill>
                <a:effectLst/>
              </a:rPr>
              <a:t>Dynamics of expression changes in the human embryos of the LTR7/HERVH loci associated with the HPAT14 lincRNA</a:t>
            </a:r>
            <a:endParaRPr lang="en-US">
              <a:solidFill>
                <a:sysClr val="windowText" lastClr="000000"/>
              </a:solidFill>
              <a:effectLst/>
            </a:endParaRPr>
          </a:p>
        </c:rich>
      </c:tx>
      <c:overlay val="0"/>
      <c:spPr>
        <a:noFill/>
        <a:ln>
          <a:noFill/>
        </a:ln>
        <a:effectLst/>
      </c:spPr>
      <c:txPr>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0.13455229300277613"/>
          <c:y val="0.12623057952556085"/>
          <c:w val="0.83160911633138024"/>
          <c:h val="0.69789413764427721"/>
        </c:manualLayout>
      </c:layout>
      <c:areaChart>
        <c:grouping val="stacked"/>
        <c:varyColors val="0"/>
        <c:ser>
          <c:idx val="0"/>
          <c:order val="0"/>
          <c:tx>
            <c:strRef>
              <c:f>Sheet1!$E$37</c:f>
              <c:strCache>
                <c:ptCount val="1"/>
                <c:pt idx="0">
                  <c:v>LTR7</c:v>
                </c:pt>
              </c:strCache>
            </c:strRef>
          </c:tx>
          <c:spPr>
            <a:solidFill>
              <a:schemeClr val="accent1"/>
            </a:solidFill>
            <a:ln>
              <a:noFill/>
            </a:ln>
            <a:effectLst/>
          </c:spPr>
          <c:cat>
            <c:strRef>
              <c:f>Sheet1!$F$36:$P$36</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1!$F$37:$P$37</c:f>
              <c:numCache>
                <c:formatCode>General</c:formatCode>
                <c:ptCount val="11"/>
                <c:pt idx="0">
                  <c:v>0</c:v>
                </c:pt>
                <c:pt idx="1">
                  <c:v>0</c:v>
                </c:pt>
                <c:pt idx="2">
                  <c:v>0</c:v>
                </c:pt>
                <c:pt idx="3">
                  <c:v>0</c:v>
                </c:pt>
                <c:pt idx="4">
                  <c:v>0</c:v>
                </c:pt>
                <c:pt idx="5">
                  <c:v>0</c:v>
                </c:pt>
                <c:pt idx="6">
                  <c:v>0</c:v>
                </c:pt>
                <c:pt idx="7">
                  <c:v>0</c:v>
                </c:pt>
                <c:pt idx="8">
                  <c:v>0.56292224216625986</c:v>
                </c:pt>
                <c:pt idx="9">
                  <c:v>4.0982956403699768</c:v>
                </c:pt>
                <c:pt idx="10">
                  <c:v>3.5884648911534498</c:v>
                </c:pt>
              </c:numCache>
            </c:numRef>
          </c:val>
        </c:ser>
        <c:ser>
          <c:idx val="1"/>
          <c:order val="1"/>
          <c:tx>
            <c:strRef>
              <c:f>Sheet1!$E$38</c:f>
              <c:strCache>
                <c:ptCount val="1"/>
                <c:pt idx="0">
                  <c:v>LTR7</c:v>
                </c:pt>
              </c:strCache>
            </c:strRef>
          </c:tx>
          <c:spPr>
            <a:solidFill>
              <a:schemeClr val="accent2"/>
            </a:solidFill>
            <a:ln>
              <a:noFill/>
            </a:ln>
            <a:effectLst/>
          </c:spPr>
          <c:cat>
            <c:strRef>
              <c:f>Sheet1!$F$36:$P$36</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1!$F$38:$P$38</c:f>
              <c:numCache>
                <c:formatCode>General</c:formatCode>
                <c:ptCount val="11"/>
                <c:pt idx="0">
                  <c:v>0</c:v>
                </c:pt>
                <c:pt idx="1">
                  <c:v>-0.40026154006933012</c:v>
                </c:pt>
                <c:pt idx="2">
                  <c:v>1.0399725430391777</c:v>
                </c:pt>
                <c:pt idx="3">
                  <c:v>1.4662898620005489</c:v>
                </c:pt>
                <c:pt idx="4">
                  <c:v>-2.17262014512914</c:v>
                </c:pt>
                <c:pt idx="5">
                  <c:v>-2.6071498759261797</c:v>
                </c:pt>
                <c:pt idx="6">
                  <c:v>-2.5763171706218899</c:v>
                </c:pt>
                <c:pt idx="7">
                  <c:v>-2.8058866578133004</c:v>
                </c:pt>
                <c:pt idx="8">
                  <c:v>-2.9047039733448101</c:v>
                </c:pt>
                <c:pt idx="9">
                  <c:v>3.0314061939800698</c:v>
                </c:pt>
                <c:pt idx="10">
                  <c:v>2.3591686820455697</c:v>
                </c:pt>
              </c:numCache>
            </c:numRef>
          </c:val>
        </c:ser>
        <c:dLbls>
          <c:showLegendKey val="0"/>
          <c:showVal val="0"/>
          <c:showCatName val="0"/>
          <c:showSerName val="0"/>
          <c:showPercent val="0"/>
          <c:showBubbleSize val="0"/>
        </c:dLbls>
        <c:axId val="299921496"/>
        <c:axId val="299923848"/>
      </c:areaChart>
      <c:catAx>
        <c:axId val="299921496"/>
        <c:scaling>
          <c:orientation val="minMax"/>
        </c:scaling>
        <c:delete val="0"/>
        <c:axPos val="b"/>
        <c:numFmt formatCode="General" sourceLinked="1"/>
        <c:majorTickMark val="none"/>
        <c:minorTickMark val="none"/>
        <c:tickLblPos val="low"/>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299923848"/>
        <c:crosses val="autoZero"/>
        <c:auto val="1"/>
        <c:lblAlgn val="ctr"/>
        <c:lblOffset val="100"/>
        <c:noMultiLvlLbl val="0"/>
      </c:catAx>
      <c:valAx>
        <c:axId val="299923848"/>
        <c:scaling>
          <c:orientation val="minMax"/>
        </c:scaling>
        <c:delete val="0"/>
        <c:axPos val="l"/>
        <c:majorGridlines>
          <c:spPr>
            <a:ln w="9525" cap="flat" cmpd="sng" algn="ctr">
              <a:noFill/>
              <a:round/>
            </a:ln>
            <a:effectLst/>
          </c:spPr>
        </c:majorGridlines>
        <c:minorGridlines>
          <c:spPr>
            <a:ln w="9525" cap="flat" cmpd="sng" algn="ctr">
              <a:noFill/>
              <a:round/>
            </a:ln>
            <a:effectLst/>
          </c:spPr>
        </c:minorGridlines>
        <c:title>
          <c:tx>
            <c:rich>
              <a:bodyPr rot="-5400000" spcFirstLastPara="1" vertOverflow="ellipsis" vert="horz" wrap="square" anchor="ctr" anchorCtr="1"/>
              <a:lstStyle/>
              <a:p>
                <a:pPr>
                  <a:defRPr sz="1800" b="1" i="0" u="none" strike="noStrike" kern="1200" baseline="0">
                    <a:solidFill>
                      <a:sysClr val="windowText" lastClr="000000"/>
                    </a:solidFill>
                    <a:latin typeface="+mn-lt"/>
                    <a:ea typeface="+mn-ea"/>
                    <a:cs typeface="+mn-cs"/>
                  </a:defRPr>
                </a:pPr>
                <a:r>
                  <a:rPr lang="en-US" sz="1800" b="1">
                    <a:solidFill>
                      <a:sysClr val="windowText" lastClr="000000"/>
                    </a:solidFill>
                  </a:rPr>
                  <a:t>Relative</a:t>
                </a:r>
                <a:r>
                  <a:rPr lang="en-US" sz="1800" b="1" baseline="0">
                    <a:solidFill>
                      <a:sysClr val="windowText" lastClr="000000"/>
                    </a:solidFill>
                  </a:rPr>
                  <a:t> expression</a:t>
                </a:r>
                <a:endParaRPr lang="en-US" sz="1800" b="1">
                  <a:solidFill>
                    <a:sysClr val="windowText" lastClr="000000"/>
                  </a:solidFill>
                </a:endParaRPr>
              </a:p>
            </c:rich>
          </c:tx>
          <c:layout>
            <c:manualLayout>
              <c:xMode val="edge"/>
              <c:yMode val="edge"/>
              <c:x val="2.5970828626026628E-2"/>
              <c:y val="0.29911943025324728"/>
            </c:manualLayout>
          </c:layout>
          <c:overlay val="0"/>
          <c:spPr>
            <a:noFill/>
            <a:ln>
              <a:noFill/>
            </a:ln>
            <a:effectLst/>
          </c:spPr>
          <c:txPr>
            <a:bodyPr rot="-5400000" spcFirstLastPara="1" vertOverflow="ellipsis" vert="horz" wrap="square" anchor="ctr" anchorCtr="1"/>
            <a:lstStyle/>
            <a:p>
              <a:pPr>
                <a:defRPr sz="1800" b="1"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299921496"/>
        <c:crosses val="autoZero"/>
        <c:crossBetween val="midCat"/>
      </c:valAx>
      <c:spPr>
        <a:noFill/>
        <a:ln>
          <a:noFill/>
        </a:ln>
        <a:effectLst/>
      </c:spPr>
    </c:plotArea>
    <c:legend>
      <c:legendPos val="t"/>
      <c:overlay val="0"/>
      <c:spPr>
        <a:noFill/>
        <a:ln>
          <a:noFill/>
        </a:ln>
        <a:effectLst/>
      </c:spPr>
      <c:txPr>
        <a:bodyPr rot="0" spcFirstLastPara="1" vertOverflow="ellipsis" vert="horz" wrap="square" anchor="ctr" anchorCtr="1"/>
        <a:lstStyle/>
        <a:p>
          <a:pPr>
            <a:defRPr sz="1600" b="1" i="0" u="none" strike="noStrike" kern="1200" baseline="0">
              <a:solidFill>
                <a:sysClr val="windowText" lastClr="000000"/>
              </a:solidFill>
              <a:latin typeface="+mn-lt"/>
              <a:ea typeface="+mn-ea"/>
              <a:cs typeface="+mn-cs"/>
            </a:defRPr>
          </a:pPr>
          <a:endParaRPr lang="en-US"/>
        </a:p>
      </c:txPr>
    </c:legend>
    <c:plotVisOnly val="1"/>
    <c:dispBlanksAs val="zero"/>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lumMod val="65000"/>
                    <a:lumOff val="35000"/>
                  </a:sysClr>
                </a:solidFill>
                <a:latin typeface="+mn-lt"/>
                <a:ea typeface="+mn-ea"/>
                <a:cs typeface="+mn-cs"/>
              </a:defRPr>
            </a:pPr>
            <a:r>
              <a:rPr lang="en-US" sz="1800" b="1" i="0" baseline="0">
                <a:effectLst/>
              </a:rPr>
              <a:t>Dynamics of expression changes in the human embryos of the LTR7/HERVH loci associated with the HPAT6 lincRNA</a:t>
            </a:r>
            <a:endParaRPr lang="en-US">
              <a:effectLst/>
            </a:endParaRPr>
          </a:p>
        </c:rich>
      </c:tx>
      <c:overlay val="0"/>
      <c:spPr>
        <a:noFill/>
        <a:ln>
          <a:noFill/>
        </a:ln>
        <a:effectLst/>
      </c:spPr>
      <c:txPr>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lumMod val="65000"/>
                  <a:lumOff val="35000"/>
                </a:sysClr>
              </a:solidFill>
              <a:latin typeface="+mn-lt"/>
              <a:ea typeface="+mn-ea"/>
              <a:cs typeface="+mn-cs"/>
            </a:defRPr>
          </a:pPr>
          <a:endParaRPr lang="en-US"/>
        </a:p>
      </c:txPr>
    </c:title>
    <c:autoTitleDeleted val="0"/>
    <c:plotArea>
      <c:layout>
        <c:manualLayout>
          <c:layoutTarget val="inner"/>
          <c:xMode val="edge"/>
          <c:yMode val="edge"/>
          <c:x val="0.1374840197806145"/>
          <c:y val="0.14331344180655131"/>
          <c:w val="0.82867738955354187"/>
          <c:h val="0.68081127536328667"/>
        </c:manualLayout>
      </c:layout>
      <c:areaChart>
        <c:grouping val="stacked"/>
        <c:varyColors val="0"/>
        <c:ser>
          <c:idx val="0"/>
          <c:order val="0"/>
          <c:tx>
            <c:strRef>
              <c:f>Sheet1!$E$50</c:f>
              <c:strCache>
                <c:ptCount val="1"/>
                <c:pt idx="0">
                  <c:v>LTR7</c:v>
                </c:pt>
              </c:strCache>
            </c:strRef>
          </c:tx>
          <c:spPr>
            <a:solidFill>
              <a:schemeClr val="accent1"/>
            </a:solidFill>
            <a:ln>
              <a:noFill/>
            </a:ln>
            <a:effectLst/>
          </c:spPr>
          <c:cat>
            <c:strRef>
              <c:f>Sheet1!$F$49:$P$49</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1!$F$50:$P$50</c:f>
              <c:numCache>
                <c:formatCode>General</c:formatCode>
                <c:ptCount val="11"/>
                <c:pt idx="0">
                  <c:v>0</c:v>
                </c:pt>
                <c:pt idx="1">
                  <c:v>1.1714776529550202</c:v>
                </c:pt>
                <c:pt idx="2">
                  <c:v>1.8898259165293192</c:v>
                </c:pt>
                <c:pt idx="3">
                  <c:v>1.03352631822949</c:v>
                </c:pt>
                <c:pt idx="4">
                  <c:v>-0.81007710644807984</c:v>
                </c:pt>
                <c:pt idx="5">
                  <c:v>-1.6233808620082799</c:v>
                </c:pt>
                <c:pt idx="6">
                  <c:v>-1.8338239874187696</c:v>
                </c:pt>
                <c:pt idx="7">
                  <c:v>-1.3563344277447098</c:v>
                </c:pt>
                <c:pt idx="8">
                  <c:v>3.8867775345674804</c:v>
                </c:pt>
                <c:pt idx="9">
                  <c:v>7.04017664831321</c:v>
                </c:pt>
                <c:pt idx="10">
                  <c:v>5.8599937713192798</c:v>
                </c:pt>
              </c:numCache>
            </c:numRef>
          </c:val>
        </c:ser>
        <c:ser>
          <c:idx val="1"/>
          <c:order val="1"/>
          <c:tx>
            <c:strRef>
              <c:f>Sheet1!$E$51</c:f>
              <c:strCache>
                <c:ptCount val="1"/>
                <c:pt idx="0">
                  <c:v>HERVH-int</c:v>
                </c:pt>
              </c:strCache>
            </c:strRef>
          </c:tx>
          <c:spPr>
            <a:solidFill>
              <a:schemeClr val="accent2"/>
            </a:solidFill>
            <a:ln>
              <a:noFill/>
            </a:ln>
            <a:effectLst/>
          </c:spPr>
          <c:cat>
            <c:strRef>
              <c:f>Sheet1!$F$49:$P$49</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1!$F$51:$P$51</c:f>
              <c:numCache>
                <c:formatCode>General</c:formatCode>
                <c:ptCount val="11"/>
                <c:pt idx="0">
                  <c:v>0</c:v>
                </c:pt>
                <c:pt idx="1">
                  <c:v>0.86414645036258997</c:v>
                </c:pt>
                <c:pt idx="2">
                  <c:v>1.6189973173825689</c:v>
                </c:pt>
                <c:pt idx="3">
                  <c:v>1.5007236741844241</c:v>
                </c:pt>
                <c:pt idx="4">
                  <c:v>0.19809275077799993</c:v>
                </c:pt>
                <c:pt idx="5">
                  <c:v>-1.5974201745658698</c:v>
                </c:pt>
                <c:pt idx="6">
                  <c:v>-1.7796271201841498</c:v>
                </c:pt>
                <c:pt idx="7">
                  <c:v>-1.6178998074158302</c:v>
                </c:pt>
                <c:pt idx="8">
                  <c:v>2.411101937447671</c:v>
                </c:pt>
                <c:pt idx="9">
                  <c:v>5.6063103573294599</c:v>
                </c:pt>
                <c:pt idx="10">
                  <c:v>4.3652301236089102</c:v>
                </c:pt>
              </c:numCache>
            </c:numRef>
          </c:val>
        </c:ser>
        <c:ser>
          <c:idx val="2"/>
          <c:order val="2"/>
          <c:tx>
            <c:strRef>
              <c:f>Sheet1!$E$52</c:f>
              <c:strCache>
                <c:ptCount val="1"/>
                <c:pt idx="0">
                  <c:v>LTR7</c:v>
                </c:pt>
              </c:strCache>
            </c:strRef>
          </c:tx>
          <c:spPr>
            <a:solidFill>
              <a:schemeClr val="accent3"/>
            </a:solidFill>
            <a:ln>
              <a:noFill/>
            </a:ln>
            <a:effectLst/>
          </c:spPr>
          <c:cat>
            <c:strRef>
              <c:f>Sheet1!$F$49:$P$49</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1!$F$52:$P$52</c:f>
              <c:numCache>
                <c:formatCode>General</c:formatCode>
                <c:ptCount val="11"/>
                <c:pt idx="0">
                  <c:v>0</c:v>
                </c:pt>
                <c:pt idx="1">
                  <c:v>0</c:v>
                </c:pt>
                <c:pt idx="2">
                  <c:v>0</c:v>
                </c:pt>
                <c:pt idx="3">
                  <c:v>0</c:v>
                </c:pt>
                <c:pt idx="4">
                  <c:v>0</c:v>
                </c:pt>
                <c:pt idx="5">
                  <c:v>0</c:v>
                </c:pt>
                <c:pt idx="6">
                  <c:v>0</c:v>
                </c:pt>
                <c:pt idx="7">
                  <c:v>0.6224959705428601</c:v>
                </c:pt>
                <c:pt idx="8">
                  <c:v>1.8140040055661601</c:v>
                </c:pt>
                <c:pt idx="9">
                  <c:v>4.9124536687894969</c:v>
                </c:pt>
                <c:pt idx="10">
                  <c:v>5.0761710912745794</c:v>
                </c:pt>
              </c:numCache>
            </c:numRef>
          </c:val>
        </c:ser>
        <c:dLbls>
          <c:showLegendKey val="0"/>
          <c:showVal val="0"/>
          <c:showCatName val="0"/>
          <c:showSerName val="0"/>
          <c:showPercent val="0"/>
          <c:showBubbleSize val="0"/>
        </c:dLbls>
        <c:axId val="299922280"/>
        <c:axId val="299920712"/>
      </c:areaChart>
      <c:catAx>
        <c:axId val="299922280"/>
        <c:scaling>
          <c:orientation val="minMax"/>
        </c:scaling>
        <c:delete val="0"/>
        <c:axPos val="b"/>
        <c:numFmt formatCode="General" sourceLinked="1"/>
        <c:majorTickMark val="none"/>
        <c:minorTickMark val="none"/>
        <c:tickLblPos val="low"/>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299920712"/>
        <c:crosses val="autoZero"/>
        <c:auto val="1"/>
        <c:lblAlgn val="ctr"/>
        <c:lblOffset val="100"/>
        <c:noMultiLvlLbl val="0"/>
      </c:catAx>
      <c:valAx>
        <c:axId val="299920712"/>
        <c:scaling>
          <c:orientation val="minMax"/>
        </c:scaling>
        <c:delete val="0"/>
        <c:axPos val="l"/>
        <c:majorGridlines>
          <c:spPr>
            <a:ln w="9525" cap="flat" cmpd="sng" algn="ctr">
              <a:noFill/>
              <a:round/>
            </a:ln>
            <a:effectLst/>
          </c:spPr>
        </c:majorGridlines>
        <c:minorGridlines>
          <c:spPr>
            <a:ln w="9525" cap="flat" cmpd="sng" algn="ctr">
              <a:noFill/>
              <a:round/>
            </a:ln>
            <a:effectLst/>
          </c:spPr>
        </c:minorGridlines>
        <c:title>
          <c:tx>
            <c:rich>
              <a:bodyPr rot="-5400000" spcFirstLastPara="1" vertOverflow="ellipsis" vert="horz" wrap="square" anchor="ctr" anchorCtr="1"/>
              <a:lstStyle/>
              <a:p>
                <a:pPr>
                  <a:defRPr sz="1800" b="1" i="0" u="none" strike="noStrike" kern="1200" baseline="0">
                    <a:solidFill>
                      <a:sysClr val="windowText" lastClr="000000"/>
                    </a:solidFill>
                    <a:latin typeface="+mn-lt"/>
                    <a:ea typeface="+mn-ea"/>
                    <a:cs typeface="+mn-cs"/>
                  </a:defRPr>
                </a:pPr>
                <a:r>
                  <a:rPr lang="en-US" sz="1800" b="1">
                    <a:solidFill>
                      <a:sysClr val="windowText" lastClr="000000"/>
                    </a:solidFill>
                  </a:rPr>
                  <a:t>Relative</a:t>
                </a:r>
                <a:r>
                  <a:rPr lang="en-US" sz="1800" b="1" baseline="0">
                    <a:solidFill>
                      <a:sysClr val="windowText" lastClr="000000"/>
                    </a:solidFill>
                  </a:rPr>
                  <a:t> expression</a:t>
                </a:r>
                <a:endParaRPr lang="en-US" sz="1800" b="1">
                  <a:solidFill>
                    <a:sysClr val="windowText" lastClr="000000"/>
                  </a:solidFill>
                </a:endParaRPr>
              </a:p>
            </c:rich>
          </c:tx>
          <c:layout>
            <c:manualLayout>
              <c:xMode val="edge"/>
              <c:yMode val="edge"/>
              <c:x val="2.6249342669921273E-2"/>
              <c:y val="0.32583513406507442"/>
            </c:manualLayout>
          </c:layout>
          <c:overlay val="0"/>
          <c:spPr>
            <a:noFill/>
            <a:ln>
              <a:noFill/>
            </a:ln>
            <a:effectLst/>
          </c:spPr>
          <c:txPr>
            <a:bodyPr rot="-5400000" spcFirstLastPara="1" vertOverflow="ellipsis" vert="horz" wrap="square" anchor="ctr" anchorCtr="1"/>
            <a:lstStyle/>
            <a:p>
              <a:pPr>
                <a:defRPr sz="1800" b="1"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299922280"/>
        <c:crosses val="autoZero"/>
        <c:crossBetween val="midCat"/>
      </c:valAx>
      <c:spPr>
        <a:noFill/>
        <a:ln>
          <a:noFill/>
        </a:ln>
        <a:effectLst/>
      </c:spPr>
    </c:plotArea>
    <c:legend>
      <c:legendPos val="t"/>
      <c:overlay val="0"/>
      <c:spPr>
        <a:noFill/>
        <a:ln>
          <a:noFill/>
        </a:ln>
        <a:effectLst/>
      </c:spPr>
      <c:txPr>
        <a:bodyPr rot="0" spcFirstLastPara="1" vertOverflow="ellipsis" vert="horz" wrap="square" anchor="ctr" anchorCtr="1"/>
        <a:lstStyle/>
        <a:p>
          <a:pPr>
            <a:defRPr sz="1600" b="1" i="0" u="none" strike="noStrike" kern="1200" baseline="0">
              <a:solidFill>
                <a:schemeClr val="tx1">
                  <a:lumMod val="65000"/>
                  <a:lumOff val="35000"/>
                </a:schemeClr>
              </a:solidFill>
              <a:latin typeface="+mn-lt"/>
              <a:ea typeface="+mn-ea"/>
              <a:cs typeface="+mn-cs"/>
            </a:defRPr>
          </a:pPr>
          <a:endParaRPr lang="en-US"/>
        </a:p>
      </c:txPr>
    </c:legend>
    <c:plotVisOnly val="1"/>
    <c:dispBlanksAs val="zero"/>
    <c:showDLblsOverMax val="0"/>
  </c:chart>
  <c:spPr>
    <a:noFill/>
    <a:ln>
      <a:noFill/>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solidFill>
                <a:latin typeface="+mn-lt"/>
                <a:ea typeface="+mn-ea"/>
                <a:cs typeface="+mn-cs"/>
              </a:defRPr>
            </a:pPr>
            <a:r>
              <a:rPr lang="en-US" sz="1800" b="1" i="0" baseline="0">
                <a:solidFill>
                  <a:sysClr val="windowText" lastClr="000000"/>
                </a:solidFill>
                <a:effectLst/>
              </a:rPr>
              <a:t>Dynamics of expression changes in the human embryos of the LTR7/HERVH loci associated with the HPAT17 &amp; 18 lincRNAs</a:t>
            </a:r>
            <a:endParaRPr lang="en-US">
              <a:solidFill>
                <a:sysClr val="windowText" lastClr="000000"/>
              </a:solidFill>
              <a:effectLst/>
            </a:endParaRPr>
          </a:p>
        </c:rich>
      </c:tx>
      <c:overlay val="0"/>
      <c:spPr>
        <a:noFill/>
        <a:ln>
          <a:noFill/>
        </a:ln>
        <a:effectLst/>
      </c:spPr>
      <c:txPr>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0.13894988316953369"/>
          <c:y val="0.14331344180655131"/>
          <c:w val="0.82721152616462268"/>
          <c:h val="0.68081127536328667"/>
        </c:manualLayout>
      </c:layout>
      <c:areaChart>
        <c:grouping val="stacked"/>
        <c:varyColors val="0"/>
        <c:ser>
          <c:idx val="0"/>
          <c:order val="0"/>
          <c:tx>
            <c:strRef>
              <c:f>Sheet1!$E$57</c:f>
              <c:strCache>
                <c:ptCount val="1"/>
                <c:pt idx="0">
                  <c:v>LTR7</c:v>
                </c:pt>
              </c:strCache>
            </c:strRef>
          </c:tx>
          <c:spPr>
            <a:solidFill>
              <a:schemeClr val="accent1"/>
            </a:solidFill>
            <a:ln>
              <a:noFill/>
            </a:ln>
            <a:effectLst/>
          </c:spPr>
          <c:cat>
            <c:strRef>
              <c:f>Sheet1!$F$56:$P$56</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1!$F$57:$P$57</c:f>
              <c:numCache>
                <c:formatCode>General</c:formatCode>
                <c:ptCount val="11"/>
                <c:pt idx="0">
                  <c:v>0</c:v>
                </c:pt>
                <c:pt idx="1">
                  <c:v>-6.4450123850610108E-2</c:v>
                </c:pt>
                <c:pt idx="2">
                  <c:v>-0.41648147478311026</c:v>
                </c:pt>
                <c:pt idx="3">
                  <c:v>-0.75786475706244039</c:v>
                </c:pt>
                <c:pt idx="4">
                  <c:v>-1.0344476193984202</c:v>
                </c:pt>
                <c:pt idx="5">
                  <c:v>0.46407374293397963</c:v>
                </c:pt>
                <c:pt idx="6">
                  <c:v>-0.70324845927533053</c:v>
                </c:pt>
                <c:pt idx="7">
                  <c:v>-1.0344476193984202</c:v>
                </c:pt>
                <c:pt idx="8">
                  <c:v>-1.0344476193984202</c:v>
                </c:pt>
                <c:pt idx="9">
                  <c:v>5.1860090533990499</c:v>
                </c:pt>
                <c:pt idx="10">
                  <c:v>-0.55213440908116995</c:v>
                </c:pt>
              </c:numCache>
            </c:numRef>
          </c:val>
        </c:ser>
        <c:ser>
          <c:idx val="1"/>
          <c:order val="1"/>
          <c:tx>
            <c:strRef>
              <c:f>Sheet1!$E$58</c:f>
              <c:strCache>
                <c:ptCount val="1"/>
                <c:pt idx="0">
                  <c:v>HERVH-int</c:v>
                </c:pt>
              </c:strCache>
            </c:strRef>
          </c:tx>
          <c:spPr>
            <a:solidFill>
              <a:schemeClr val="accent2"/>
            </a:solidFill>
            <a:ln>
              <a:noFill/>
            </a:ln>
            <a:effectLst/>
          </c:spPr>
          <c:cat>
            <c:strRef>
              <c:f>Sheet1!$F$56:$P$56</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1!$F$58:$P$58</c:f>
              <c:numCache>
                <c:formatCode>General</c:formatCode>
                <c:ptCount val="11"/>
                <c:pt idx="0">
                  <c:v>0</c:v>
                </c:pt>
                <c:pt idx="1">
                  <c:v>-0.28581117520279964</c:v>
                </c:pt>
                <c:pt idx="2">
                  <c:v>0.1784723304233502</c:v>
                </c:pt>
                <c:pt idx="3">
                  <c:v>0.52032586698785011</c:v>
                </c:pt>
                <c:pt idx="4">
                  <c:v>2.2455484676460191E-2</c:v>
                </c:pt>
                <c:pt idx="5">
                  <c:v>2.9307019739501783E-3</c:v>
                </c:pt>
                <c:pt idx="6">
                  <c:v>-1.0291287397914002</c:v>
                </c:pt>
                <c:pt idx="7">
                  <c:v>-1.5513440289185598</c:v>
                </c:pt>
                <c:pt idx="8">
                  <c:v>-1.5513440289185598</c:v>
                </c:pt>
                <c:pt idx="9">
                  <c:v>3.9556300867794771</c:v>
                </c:pt>
                <c:pt idx="10">
                  <c:v>0.17403552397654032</c:v>
                </c:pt>
              </c:numCache>
            </c:numRef>
          </c:val>
        </c:ser>
        <c:dLbls>
          <c:showLegendKey val="0"/>
          <c:showVal val="0"/>
          <c:showCatName val="0"/>
          <c:showSerName val="0"/>
          <c:showPercent val="0"/>
          <c:showBubbleSize val="0"/>
        </c:dLbls>
        <c:axId val="302056912"/>
        <c:axId val="302060048"/>
      </c:areaChart>
      <c:catAx>
        <c:axId val="302056912"/>
        <c:scaling>
          <c:orientation val="minMax"/>
        </c:scaling>
        <c:delete val="0"/>
        <c:axPos val="b"/>
        <c:numFmt formatCode="General" sourceLinked="1"/>
        <c:majorTickMark val="none"/>
        <c:minorTickMark val="none"/>
        <c:tickLblPos val="low"/>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302060048"/>
        <c:crosses val="autoZero"/>
        <c:auto val="1"/>
        <c:lblAlgn val="ctr"/>
        <c:lblOffset val="100"/>
        <c:noMultiLvlLbl val="0"/>
      </c:catAx>
      <c:valAx>
        <c:axId val="302060048"/>
        <c:scaling>
          <c:orientation val="minMax"/>
        </c:scaling>
        <c:delete val="0"/>
        <c:axPos val="l"/>
        <c:majorGridlines>
          <c:spPr>
            <a:ln w="9525" cap="flat" cmpd="sng" algn="ctr">
              <a:noFill/>
              <a:round/>
            </a:ln>
            <a:effectLst/>
          </c:spPr>
        </c:majorGridlines>
        <c:minorGridlines>
          <c:spPr>
            <a:ln w="9525" cap="flat" cmpd="sng" algn="ctr">
              <a:noFill/>
              <a:round/>
            </a:ln>
            <a:effectLst/>
          </c:spPr>
        </c:minorGridlines>
        <c:title>
          <c:tx>
            <c:rich>
              <a:bodyPr rot="-5400000" spcFirstLastPara="1" vertOverflow="ellipsis" vert="horz" wrap="square" anchor="ctr" anchorCtr="1"/>
              <a:lstStyle/>
              <a:p>
                <a:pPr>
                  <a:defRPr sz="1800" b="1" i="0" u="none" strike="noStrike" kern="1200" baseline="0">
                    <a:solidFill>
                      <a:sysClr val="windowText" lastClr="000000"/>
                    </a:solidFill>
                    <a:latin typeface="+mn-lt"/>
                    <a:ea typeface="+mn-ea"/>
                    <a:cs typeface="+mn-cs"/>
                  </a:defRPr>
                </a:pPr>
                <a:r>
                  <a:rPr lang="en-US" sz="1800" b="1">
                    <a:solidFill>
                      <a:sysClr val="windowText" lastClr="000000"/>
                    </a:solidFill>
                  </a:rPr>
                  <a:t>Relative</a:t>
                </a:r>
                <a:r>
                  <a:rPr lang="en-US" sz="1800" b="1" baseline="0">
                    <a:solidFill>
                      <a:sysClr val="windowText" lastClr="000000"/>
                    </a:solidFill>
                  </a:rPr>
                  <a:t> expression</a:t>
                </a:r>
                <a:endParaRPr lang="en-US" sz="1800" b="1">
                  <a:solidFill>
                    <a:sysClr val="windowText" lastClr="000000"/>
                  </a:solidFill>
                </a:endParaRPr>
              </a:p>
            </c:rich>
          </c:tx>
          <c:layout>
            <c:manualLayout>
              <c:xMode val="edge"/>
              <c:yMode val="edge"/>
              <c:x val="3.8313398360726128E-2"/>
              <c:y val="0.32793018408010038"/>
            </c:manualLayout>
          </c:layout>
          <c:overlay val="0"/>
          <c:spPr>
            <a:noFill/>
            <a:ln>
              <a:noFill/>
            </a:ln>
            <a:effectLst/>
          </c:spPr>
          <c:txPr>
            <a:bodyPr rot="-5400000" spcFirstLastPara="1" vertOverflow="ellipsis" vert="horz" wrap="square" anchor="ctr" anchorCtr="1"/>
            <a:lstStyle/>
            <a:p>
              <a:pPr>
                <a:defRPr sz="1800" b="1"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302056912"/>
        <c:crosses val="autoZero"/>
        <c:crossBetween val="midCat"/>
      </c:valAx>
      <c:spPr>
        <a:noFill/>
        <a:ln>
          <a:noFill/>
        </a:ln>
        <a:effectLst/>
      </c:spPr>
    </c:plotArea>
    <c:legend>
      <c:legendPos val="t"/>
      <c:overlay val="0"/>
      <c:spPr>
        <a:noFill/>
        <a:ln>
          <a:noFill/>
        </a:ln>
        <a:effectLst/>
      </c:spPr>
      <c:txPr>
        <a:bodyPr rot="0" spcFirstLastPara="1" vertOverflow="ellipsis" vert="horz" wrap="square" anchor="ctr" anchorCtr="1"/>
        <a:lstStyle/>
        <a:p>
          <a:pPr>
            <a:defRPr sz="1600" b="1" i="0" u="none" strike="noStrike" kern="1200" baseline="0">
              <a:solidFill>
                <a:sysClr val="windowText" lastClr="000000"/>
              </a:solidFill>
              <a:latin typeface="+mn-lt"/>
              <a:ea typeface="+mn-ea"/>
              <a:cs typeface="+mn-cs"/>
            </a:defRPr>
          </a:pPr>
          <a:endParaRPr lang="en-US"/>
        </a:p>
      </c:txPr>
    </c:legend>
    <c:plotVisOnly val="1"/>
    <c:dispBlanksAs val="zero"/>
    <c:showDLblsOverMax val="0"/>
  </c:chart>
  <c:spPr>
    <a:noFill/>
    <a:ln>
      <a:noFill/>
    </a:ln>
    <a:effectLst/>
  </c:spPr>
  <c:txPr>
    <a:bodyPr/>
    <a:lstStyle/>
    <a:p>
      <a:pPr>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solidFill>
                <a:latin typeface="+mn-lt"/>
                <a:ea typeface="+mn-ea"/>
                <a:cs typeface="+mn-cs"/>
              </a:defRPr>
            </a:pPr>
            <a:r>
              <a:rPr lang="en-US" sz="1800" b="1" i="0" baseline="0">
                <a:solidFill>
                  <a:sysClr val="windowText" lastClr="000000"/>
                </a:solidFill>
                <a:effectLst/>
              </a:rPr>
              <a:t>Dynamics of expression changes in the human embryos of the LTR7/HERVH loci associated with the HPAT1 lincRNA</a:t>
            </a:r>
            <a:endParaRPr lang="en-US">
              <a:solidFill>
                <a:sysClr val="windowText" lastClr="000000"/>
              </a:solidFill>
              <a:effectLst/>
            </a:endParaRPr>
          </a:p>
        </c:rich>
      </c:tx>
      <c:overlay val="0"/>
      <c:spPr>
        <a:noFill/>
        <a:ln>
          <a:noFill/>
        </a:ln>
        <a:effectLst/>
      </c:spPr>
      <c:txPr>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0.12868883944709941"/>
          <c:y val="0.14331344180655131"/>
          <c:w val="0.83747256988705698"/>
          <c:h val="0.68081127536328667"/>
        </c:manualLayout>
      </c:layout>
      <c:areaChart>
        <c:grouping val="stacked"/>
        <c:varyColors val="0"/>
        <c:ser>
          <c:idx val="0"/>
          <c:order val="0"/>
          <c:tx>
            <c:strRef>
              <c:f>Sheet1!$E$43</c:f>
              <c:strCache>
                <c:ptCount val="1"/>
                <c:pt idx="0">
                  <c:v>LTR7</c:v>
                </c:pt>
              </c:strCache>
            </c:strRef>
          </c:tx>
          <c:spPr>
            <a:solidFill>
              <a:schemeClr val="accent1"/>
            </a:solidFill>
            <a:ln>
              <a:noFill/>
            </a:ln>
            <a:effectLst/>
          </c:spPr>
          <c:cat>
            <c:strRef>
              <c:f>Sheet1!$F$42:$P$42</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1!$F$43:$P$43</c:f>
              <c:numCache>
                <c:formatCode>General</c:formatCode>
                <c:ptCount val="11"/>
                <c:pt idx="0">
                  <c:v>0</c:v>
                </c:pt>
                <c:pt idx="1">
                  <c:v>0</c:v>
                </c:pt>
                <c:pt idx="2">
                  <c:v>0</c:v>
                </c:pt>
                <c:pt idx="3">
                  <c:v>0</c:v>
                </c:pt>
                <c:pt idx="4">
                  <c:v>0</c:v>
                </c:pt>
                <c:pt idx="5">
                  <c:v>0.2249661573396704</c:v>
                </c:pt>
                <c:pt idx="6">
                  <c:v>0</c:v>
                </c:pt>
                <c:pt idx="7">
                  <c:v>0.24026212540166014</c:v>
                </c:pt>
                <c:pt idx="8">
                  <c:v>1.8442123949290901</c:v>
                </c:pt>
                <c:pt idx="9">
                  <c:v>0.37633529796403042</c:v>
                </c:pt>
                <c:pt idx="10">
                  <c:v>2.1614341508001802</c:v>
                </c:pt>
              </c:numCache>
            </c:numRef>
          </c:val>
        </c:ser>
        <c:ser>
          <c:idx val="1"/>
          <c:order val="1"/>
          <c:tx>
            <c:strRef>
              <c:f>Sheet1!$E$44</c:f>
              <c:strCache>
                <c:ptCount val="1"/>
                <c:pt idx="0">
                  <c:v>HERVH-int</c:v>
                </c:pt>
              </c:strCache>
            </c:strRef>
          </c:tx>
          <c:spPr>
            <a:solidFill>
              <a:schemeClr val="accent2"/>
            </a:solidFill>
            <a:ln>
              <a:noFill/>
            </a:ln>
            <a:effectLst/>
          </c:spPr>
          <c:cat>
            <c:strRef>
              <c:f>Sheet1!$F$42:$P$42</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1!$F$44:$P$44</c:f>
              <c:numCache>
                <c:formatCode>General</c:formatCode>
                <c:ptCount val="11"/>
                <c:pt idx="0">
                  <c:v>0</c:v>
                </c:pt>
                <c:pt idx="1">
                  <c:v>-1.2141352241290093E-2</c:v>
                </c:pt>
                <c:pt idx="2">
                  <c:v>1.0513826761921399</c:v>
                </c:pt>
                <c:pt idx="3">
                  <c:v>1.3989807304934498</c:v>
                </c:pt>
                <c:pt idx="4">
                  <c:v>0.2159249216606498</c:v>
                </c:pt>
                <c:pt idx="5">
                  <c:v>-0.86923781127022037</c:v>
                </c:pt>
                <c:pt idx="6">
                  <c:v>-1.2970756602919304</c:v>
                </c:pt>
                <c:pt idx="7">
                  <c:v>-1.6748194287067499</c:v>
                </c:pt>
                <c:pt idx="8">
                  <c:v>1.5695001010250897</c:v>
                </c:pt>
                <c:pt idx="9">
                  <c:v>3.3454003473448788</c:v>
                </c:pt>
                <c:pt idx="10">
                  <c:v>1.4182331917924598</c:v>
                </c:pt>
              </c:numCache>
            </c:numRef>
          </c:val>
        </c:ser>
        <c:ser>
          <c:idx val="2"/>
          <c:order val="2"/>
          <c:tx>
            <c:strRef>
              <c:f>Sheet1!$E$45</c:f>
              <c:strCache>
                <c:ptCount val="1"/>
                <c:pt idx="0">
                  <c:v>LTR7</c:v>
                </c:pt>
              </c:strCache>
            </c:strRef>
          </c:tx>
          <c:spPr>
            <a:solidFill>
              <a:schemeClr val="accent3"/>
            </a:solidFill>
            <a:ln>
              <a:noFill/>
            </a:ln>
            <a:effectLst/>
          </c:spPr>
          <c:cat>
            <c:strRef>
              <c:f>Sheet1!$F$42:$P$42</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1!$F$45:$P$45</c:f>
              <c:numCache>
                <c:formatCode>General</c:formatCode>
                <c:ptCount val="11"/>
                <c:pt idx="0">
                  <c:v>0</c:v>
                </c:pt>
                <c:pt idx="1">
                  <c:v>-0.46292419843665034</c:v>
                </c:pt>
                <c:pt idx="2">
                  <c:v>0.11457306643635956</c:v>
                </c:pt>
                <c:pt idx="3">
                  <c:v>0.34090577174365988</c:v>
                </c:pt>
                <c:pt idx="4">
                  <c:v>-0.46292419843665034</c:v>
                </c:pt>
                <c:pt idx="5">
                  <c:v>9.9139245466060011E-2</c:v>
                </c:pt>
                <c:pt idx="6">
                  <c:v>-0.21493843406644064</c:v>
                </c:pt>
                <c:pt idx="7">
                  <c:v>0.27844235680817953</c:v>
                </c:pt>
                <c:pt idx="8">
                  <c:v>3.4657044982019358</c:v>
                </c:pt>
                <c:pt idx="9">
                  <c:v>3.0060646081999494</c:v>
                </c:pt>
                <c:pt idx="10">
                  <c:v>2.6614263525699098</c:v>
                </c:pt>
              </c:numCache>
            </c:numRef>
          </c:val>
        </c:ser>
        <c:dLbls>
          <c:showLegendKey val="0"/>
          <c:showVal val="0"/>
          <c:showCatName val="0"/>
          <c:showSerName val="0"/>
          <c:showPercent val="0"/>
          <c:showBubbleSize val="0"/>
        </c:dLbls>
        <c:axId val="302058872"/>
        <c:axId val="302056520"/>
      </c:areaChart>
      <c:catAx>
        <c:axId val="302058872"/>
        <c:scaling>
          <c:orientation val="minMax"/>
        </c:scaling>
        <c:delete val="0"/>
        <c:axPos val="b"/>
        <c:numFmt formatCode="General" sourceLinked="1"/>
        <c:majorTickMark val="none"/>
        <c:minorTickMark val="none"/>
        <c:tickLblPos val="low"/>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302056520"/>
        <c:crosses val="autoZero"/>
        <c:auto val="1"/>
        <c:lblAlgn val="ctr"/>
        <c:lblOffset val="100"/>
        <c:noMultiLvlLbl val="0"/>
      </c:catAx>
      <c:valAx>
        <c:axId val="302056520"/>
        <c:scaling>
          <c:orientation val="minMax"/>
        </c:scaling>
        <c:delete val="0"/>
        <c:axPos val="l"/>
        <c:majorGridlines>
          <c:spPr>
            <a:ln w="9525" cap="flat" cmpd="sng" algn="ctr">
              <a:noFill/>
              <a:round/>
            </a:ln>
            <a:effectLst/>
          </c:spPr>
        </c:majorGridlines>
        <c:minorGridlines>
          <c:spPr>
            <a:ln w="9525" cap="flat" cmpd="sng" algn="ctr">
              <a:noFill/>
              <a:round/>
            </a:ln>
            <a:effectLst/>
          </c:spPr>
        </c:minorGridlines>
        <c:title>
          <c:tx>
            <c:rich>
              <a:bodyPr rot="-5400000" spcFirstLastPara="1" vertOverflow="ellipsis" vert="horz" wrap="square" anchor="ctr" anchorCtr="1"/>
              <a:lstStyle/>
              <a:p>
                <a:pPr>
                  <a:defRPr sz="1800" b="1" i="0" u="none" strike="noStrike" kern="1200" baseline="0">
                    <a:solidFill>
                      <a:sysClr val="windowText" lastClr="000000"/>
                    </a:solidFill>
                    <a:latin typeface="+mn-lt"/>
                    <a:ea typeface="+mn-ea"/>
                    <a:cs typeface="+mn-cs"/>
                  </a:defRPr>
                </a:pPr>
                <a:r>
                  <a:rPr lang="en-US" sz="1800" b="1">
                    <a:solidFill>
                      <a:sysClr val="windowText" lastClr="000000"/>
                    </a:solidFill>
                  </a:rPr>
                  <a:t>RELATIVE</a:t>
                </a:r>
                <a:r>
                  <a:rPr lang="en-US" sz="1800" b="1" baseline="0">
                    <a:solidFill>
                      <a:sysClr val="windowText" lastClr="000000"/>
                    </a:solidFill>
                  </a:rPr>
                  <a:t> EXPRESSION</a:t>
                </a:r>
                <a:endParaRPr lang="en-US" sz="1800" b="1">
                  <a:solidFill>
                    <a:sysClr val="windowText" lastClr="000000"/>
                  </a:solidFill>
                </a:endParaRPr>
              </a:p>
            </c:rich>
          </c:tx>
          <c:layout>
            <c:manualLayout>
              <c:xMode val="edge"/>
              <c:yMode val="edge"/>
              <c:x val="3.1834282181703345E-2"/>
              <c:y val="0.30564149776359451"/>
            </c:manualLayout>
          </c:layout>
          <c:overlay val="0"/>
          <c:spPr>
            <a:noFill/>
            <a:ln>
              <a:noFill/>
            </a:ln>
            <a:effectLst/>
          </c:spPr>
          <c:txPr>
            <a:bodyPr rot="-5400000" spcFirstLastPara="1" vertOverflow="ellipsis" vert="horz" wrap="square" anchor="ctr" anchorCtr="1"/>
            <a:lstStyle/>
            <a:p>
              <a:pPr>
                <a:defRPr sz="1800" b="1"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302058872"/>
        <c:crosses val="autoZero"/>
        <c:crossBetween val="midCat"/>
      </c:valAx>
      <c:spPr>
        <a:noFill/>
        <a:ln>
          <a:noFill/>
        </a:ln>
        <a:effectLst/>
      </c:spPr>
    </c:plotArea>
    <c:legend>
      <c:legendPos val="t"/>
      <c:overlay val="0"/>
      <c:spPr>
        <a:noFill/>
        <a:ln>
          <a:noFill/>
        </a:ln>
        <a:effectLst/>
      </c:spPr>
      <c:txPr>
        <a:bodyPr rot="0" spcFirstLastPara="1" vertOverflow="ellipsis" vert="horz" wrap="square" anchor="ctr" anchorCtr="1"/>
        <a:lstStyle/>
        <a:p>
          <a:pPr>
            <a:defRPr sz="1600" b="1" i="0" u="none" strike="noStrike" kern="1200" baseline="0">
              <a:solidFill>
                <a:sysClr val="windowText" lastClr="000000"/>
              </a:solidFill>
              <a:latin typeface="+mn-lt"/>
              <a:ea typeface="+mn-ea"/>
              <a:cs typeface="+mn-cs"/>
            </a:defRPr>
          </a:pPr>
          <a:endParaRPr lang="en-US"/>
        </a:p>
      </c:txPr>
    </c:legend>
    <c:plotVisOnly val="1"/>
    <c:dispBlanksAs val="zero"/>
    <c:showDLblsOverMax val="0"/>
  </c:chart>
  <c:spPr>
    <a:noFill/>
    <a:ln>
      <a:noFill/>
    </a:ln>
    <a:effectLst/>
  </c:spPr>
  <c:txPr>
    <a:bodyPr/>
    <a:lstStyle/>
    <a:p>
      <a:pPr>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solidFill>
                <a:latin typeface="+mn-lt"/>
                <a:ea typeface="+mn-ea"/>
                <a:cs typeface="+mn-cs"/>
              </a:defRPr>
            </a:pPr>
            <a:r>
              <a:rPr lang="en-US" sz="1800" b="1" i="0" baseline="0">
                <a:solidFill>
                  <a:sysClr val="windowText" lastClr="000000"/>
                </a:solidFill>
                <a:effectLst/>
              </a:rPr>
              <a:t>Dynamics of expression changes in the human embryos of the LTR7/HERVH loci associated with the HPAT4 lincRNA</a:t>
            </a:r>
            <a:endParaRPr lang="en-US">
              <a:solidFill>
                <a:sysClr val="windowText" lastClr="000000"/>
              </a:solidFill>
              <a:effectLst/>
            </a:endParaRPr>
          </a:p>
        </c:rich>
      </c:tx>
      <c:overlay val="0"/>
      <c:spPr>
        <a:noFill/>
        <a:ln>
          <a:noFill/>
        </a:ln>
        <a:effectLst/>
      </c:spPr>
      <c:txPr>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0.12868883944709941"/>
          <c:y val="0.14331344180655131"/>
          <c:w val="0.83747256988705698"/>
          <c:h val="0.68081127536328667"/>
        </c:manualLayout>
      </c:layout>
      <c:areaChart>
        <c:grouping val="stacked"/>
        <c:varyColors val="0"/>
        <c:ser>
          <c:idx val="0"/>
          <c:order val="0"/>
          <c:tx>
            <c:strRef>
              <c:f>Sheet1!$E$31</c:f>
              <c:strCache>
                <c:ptCount val="1"/>
                <c:pt idx="0">
                  <c:v>HERVH-int</c:v>
                </c:pt>
              </c:strCache>
            </c:strRef>
          </c:tx>
          <c:spPr>
            <a:solidFill>
              <a:schemeClr val="accent1"/>
            </a:solidFill>
            <a:ln>
              <a:noFill/>
            </a:ln>
            <a:effectLst/>
          </c:spPr>
          <c:cat>
            <c:strRef>
              <c:f>Sheet1!$F$30:$P$30</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1!$F$31:$P$31</c:f>
              <c:numCache>
                <c:formatCode>General</c:formatCode>
                <c:ptCount val="11"/>
                <c:pt idx="0">
                  <c:v>0</c:v>
                </c:pt>
                <c:pt idx="1">
                  <c:v>0.83865066732156412</c:v>
                </c:pt>
                <c:pt idx="2">
                  <c:v>0.34303048052212198</c:v>
                </c:pt>
                <c:pt idx="3">
                  <c:v>0.88948082729869404</c:v>
                </c:pt>
                <c:pt idx="4">
                  <c:v>0.443647362475936</c:v>
                </c:pt>
                <c:pt idx="5">
                  <c:v>-1.6856897713994958</c:v>
                </c:pt>
                <c:pt idx="6">
                  <c:v>-3.5459475249775361</c:v>
                </c:pt>
                <c:pt idx="7">
                  <c:v>-4.5877623109170562</c:v>
                </c:pt>
                <c:pt idx="8">
                  <c:v>-3.0866821211003463</c:v>
                </c:pt>
                <c:pt idx="9">
                  <c:v>0.66010131209131395</c:v>
                </c:pt>
                <c:pt idx="10">
                  <c:v>-3.4903627948884259</c:v>
                </c:pt>
              </c:numCache>
            </c:numRef>
          </c:val>
        </c:ser>
        <c:ser>
          <c:idx val="1"/>
          <c:order val="1"/>
          <c:tx>
            <c:strRef>
              <c:f>Sheet1!$E$32</c:f>
              <c:strCache>
                <c:ptCount val="1"/>
                <c:pt idx="0">
                  <c:v>LTR7</c:v>
                </c:pt>
              </c:strCache>
            </c:strRef>
          </c:tx>
          <c:spPr>
            <a:solidFill>
              <a:schemeClr val="accent2"/>
            </a:solidFill>
            <a:ln>
              <a:noFill/>
            </a:ln>
            <a:effectLst/>
          </c:spPr>
          <c:cat>
            <c:strRef>
              <c:f>Sheet1!$F$30:$P$30</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1!$F$32:$P$32</c:f>
              <c:numCache>
                <c:formatCode>General</c:formatCode>
                <c:ptCount val="11"/>
                <c:pt idx="0">
                  <c:v>0</c:v>
                </c:pt>
                <c:pt idx="1">
                  <c:v>1.5831544810769791</c:v>
                </c:pt>
                <c:pt idx="2">
                  <c:v>0.51218288755878194</c:v>
                </c:pt>
                <c:pt idx="3">
                  <c:v>-0.77668807340769086</c:v>
                </c:pt>
                <c:pt idx="4">
                  <c:v>-0.79168448693861104</c:v>
                </c:pt>
                <c:pt idx="5">
                  <c:v>-2.8595940468097711</c:v>
                </c:pt>
                <c:pt idx="6">
                  <c:v>-4.022983214749301</c:v>
                </c:pt>
                <c:pt idx="7">
                  <c:v>-4.022983214749301</c:v>
                </c:pt>
                <c:pt idx="8">
                  <c:v>-4.022983214749301</c:v>
                </c:pt>
                <c:pt idx="9">
                  <c:v>1.518232428977508</c:v>
                </c:pt>
                <c:pt idx="10">
                  <c:v>-2.6031934249171709</c:v>
                </c:pt>
              </c:numCache>
            </c:numRef>
          </c:val>
        </c:ser>
        <c:dLbls>
          <c:showLegendKey val="0"/>
          <c:showVal val="0"/>
          <c:showCatName val="0"/>
          <c:showSerName val="0"/>
          <c:showPercent val="0"/>
          <c:showBubbleSize val="0"/>
        </c:dLbls>
        <c:axId val="302060440"/>
        <c:axId val="302057696"/>
      </c:areaChart>
      <c:catAx>
        <c:axId val="302060440"/>
        <c:scaling>
          <c:orientation val="minMax"/>
        </c:scaling>
        <c:delete val="0"/>
        <c:axPos val="b"/>
        <c:numFmt formatCode="General" sourceLinked="1"/>
        <c:majorTickMark val="none"/>
        <c:minorTickMark val="none"/>
        <c:tickLblPos val="low"/>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302057696"/>
        <c:crosses val="autoZero"/>
        <c:auto val="1"/>
        <c:lblAlgn val="ctr"/>
        <c:lblOffset val="100"/>
        <c:noMultiLvlLbl val="0"/>
      </c:catAx>
      <c:valAx>
        <c:axId val="302057696"/>
        <c:scaling>
          <c:orientation val="minMax"/>
        </c:scaling>
        <c:delete val="0"/>
        <c:axPos val="l"/>
        <c:majorGridlines>
          <c:spPr>
            <a:ln w="9525" cap="flat" cmpd="sng" algn="ctr">
              <a:noFill/>
              <a:round/>
            </a:ln>
            <a:effectLst/>
          </c:spPr>
        </c:majorGridlines>
        <c:minorGridlines>
          <c:spPr>
            <a:ln w="9525" cap="flat" cmpd="sng" algn="ctr">
              <a:noFill/>
              <a:round/>
            </a:ln>
            <a:effectLst/>
          </c:spPr>
        </c:minorGridlines>
        <c:title>
          <c:tx>
            <c:rich>
              <a:bodyPr rot="-5400000" spcFirstLastPara="1" vertOverflow="ellipsis" vert="horz" wrap="square" anchor="ctr" anchorCtr="1"/>
              <a:lstStyle/>
              <a:p>
                <a:pPr>
                  <a:defRPr sz="1800" b="1" i="0" u="none" strike="noStrike" kern="1200" baseline="0">
                    <a:solidFill>
                      <a:sysClr val="windowText" lastClr="000000"/>
                    </a:solidFill>
                    <a:latin typeface="+mn-lt"/>
                    <a:ea typeface="+mn-ea"/>
                    <a:cs typeface="+mn-cs"/>
                  </a:defRPr>
                </a:pPr>
                <a:r>
                  <a:rPr lang="en-US" sz="1800" b="1">
                    <a:solidFill>
                      <a:sysClr val="windowText" lastClr="000000"/>
                    </a:solidFill>
                  </a:rPr>
                  <a:t>Relative</a:t>
                </a:r>
                <a:r>
                  <a:rPr lang="en-US" sz="1800" b="1" baseline="0">
                    <a:solidFill>
                      <a:sysClr val="windowText" lastClr="000000"/>
                    </a:solidFill>
                  </a:rPr>
                  <a:t> expression</a:t>
                </a:r>
                <a:endParaRPr lang="en-US" sz="1800" b="1">
                  <a:solidFill>
                    <a:sysClr val="windowText" lastClr="000000"/>
                  </a:solidFill>
                </a:endParaRPr>
              </a:p>
            </c:rich>
          </c:tx>
          <c:layout>
            <c:manualLayout>
              <c:xMode val="edge"/>
              <c:yMode val="edge"/>
              <c:x val="2.5831513892922257E-2"/>
              <c:y val="0.30564149776359451"/>
            </c:manualLayout>
          </c:layout>
          <c:overlay val="0"/>
          <c:spPr>
            <a:noFill/>
            <a:ln>
              <a:noFill/>
            </a:ln>
            <a:effectLst/>
          </c:spPr>
          <c:txPr>
            <a:bodyPr rot="-5400000" spcFirstLastPara="1" vertOverflow="ellipsis" vert="horz" wrap="square" anchor="ctr" anchorCtr="1"/>
            <a:lstStyle/>
            <a:p>
              <a:pPr>
                <a:defRPr sz="1800" b="1"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302060440"/>
        <c:crosses val="autoZero"/>
        <c:crossBetween val="midCat"/>
      </c:valAx>
      <c:spPr>
        <a:noFill/>
        <a:ln>
          <a:noFill/>
        </a:ln>
        <a:effectLst/>
      </c:spPr>
    </c:plotArea>
    <c:legend>
      <c:legendPos val="t"/>
      <c:overlay val="0"/>
      <c:spPr>
        <a:noFill/>
        <a:ln>
          <a:noFill/>
        </a:ln>
        <a:effectLst/>
      </c:spPr>
      <c:txPr>
        <a:bodyPr rot="0" spcFirstLastPara="1" vertOverflow="ellipsis" vert="horz" wrap="square" anchor="ctr" anchorCtr="1"/>
        <a:lstStyle/>
        <a:p>
          <a:pPr>
            <a:defRPr sz="1600" b="1" i="0" u="none" strike="noStrike" kern="1200" baseline="0">
              <a:solidFill>
                <a:sysClr val="windowText" lastClr="000000"/>
              </a:solidFill>
              <a:latin typeface="+mn-lt"/>
              <a:ea typeface="+mn-ea"/>
              <a:cs typeface="+mn-cs"/>
            </a:defRPr>
          </a:pPr>
          <a:endParaRPr lang="en-US"/>
        </a:p>
      </c:txPr>
    </c:legend>
    <c:plotVisOnly val="1"/>
    <c:dispBlanksAs val="zero"/>
    <c:showDLblsOverMax val="0"/>
  </c:chart>
  <c:spPr>
    <a:noFill/>
    <a:ln>
      <a:noFill/>
    </a:ln>
    <a:effectLst/>
  </c:spPr>
  <c:txPr>
    <a:bodyPr/>
    <a:lstStyle/>
    <a:p>
      <a:pPr>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800" b="1" i="0" u="none" strike="noStrike" kern="1200" spc="0" baseline="0">
                <a:solidFill>
                  <a:sysClr val="windowText" lastClr="000000"/>
                </a:solidFill>
                <a:latin typeface="+mn-lt"/>
                <a:ea typeface="+mn-ea"/>
                <a:cs typeface="+mn-cs"/>
              </a:defRPr>
            </a:pPr>
            <a:r>
              <a:rPr lang="en-US" sz="1800" b="1">
                <a:solidFill>
                  <a:sysClr val="windowText" lastClr="000000"/>
                </a:solidFill>
              </a:rPr>
              <a:t>Single cell analysis of the HPAT3 expression in human embryos</a:t>
            </a:r>
          </a:p>
        </c:rich>
      </c:tx>
      <c:overlay val="0"/>
      <c:spPr>
        <a:noFill/>
        <a:ln>
          <a:noFill/>
        </a:ln>
        <a:effectLst/>
      </c:spPr>
      <c:txPr>
        <a:bodyPr rot="0" spcFirstLastPara="1" vertOverflow="ellipsis" vert="horz" wrap="square" anchor="ctr" anchorCtr="1"/>
        <a:lstStyle/>
        <a:p>
          <a:pPr>
            <a:defRPr sz="1800" b="1" i="0" u="none" strike="noStrike" kern="1200" spc="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9.9113141107472505E-2"/>
          <c:y val="0.12109137858933935"/>
          <c:w val="0.88476236161441657"/>
          <c:h val="0.6965831413347835"/>
        </c:manualLayout>
      </c:layout>
      <c:barChart>
        <c:barDir val="col"/>
        <c:grouping val="clustered"/>
        <c:varyColors val="0"/>
        <c:ser>
          <c:idx val="0"/>
          <c:order val="0"/>
          <c:tx>
            <c:strRef>
              <c:f>Sheet9!$A$9</c:f>
              <c:strCache>
                <c:ptCount val="1"/>
                <c:pt idx="0">
                  <c:v>HPAT3</c:v>
                </c:pt>
              </c:strCache>
            </c:strRef>
          </c:tx>
          <c:spPr>
            <a:solidFill>
              <a:srgbClr val="0070C0"/>
            </a:solidFill>
            <a:ln>
              <a:solidFill>
                <a:schemeClr val="accent1"/>
              </a:solidFill>
            </a:ln>
            <a:effectLst/>
          </c:spPr>
          <c:invertIfNegative val="0"/>
          <c:cat>
            <c:strRef>
              <c:f>Sheet9!$B$8:$ES$8</c:f>
              <c:strCache>
                <c:ptCount val="148"/>
                <c:pt idx="0">
                  <c:v>Oocyte</c:v>
                </c:pt>
                <c:pt idx="1">
                  <c:v>Oocyte</c:v>
                </c:pt>
                <c:pt idx="2">
                  <c:v>Oocyte</c:v>
                </c:pt>
                <c:pt idx="3">
                  <c:v>Oocyte</c:v>
                </c:pt>
                <c:pt idx="4">
                  <c:v>Oocyte</c:v>
                </c:pt>
                <c:pt idx="5">
                  <c:v>Oocyte</c:v>
                </c:pt>
                <c:pt idx="6">
                  <c:v>Pronuclei</c:v>
                </c:pt>
                <c:pt idx="7">
                  <c:v>Pronuclei</c:v>
                </c:pt>
                <c:pt idx="8">
                  <c:v>Pronuclei</c:v>
                </c:pt>
                <c:pt idx="9">
                  <c:v>Zygote</c:v>
                </c:pt>
                <c:pt idx="10">
                  <c:v>Zygote</c:v>
                </c:pt>
                <c:pt idx="11">
                  <c:v>Zygote</c:v>
                </c:pt>
                <c:pt idx="12">
                  <c:v>Zygote</c:v>
                </c:pt>
                <c:pt idx="13">
                  <c:v>Zygote</c:v>
                </c:pt>
                <c:pt idx="14">
                  <c:v>2-cell</c:v>
                </c:pt>
                <c:pt idx="15">
                  <c:v>2-cell</c:v>
                </c:pt>
                <c:pt idx="16">
                  <c:v>2-cell</c:v>
                </c:pt>
                <c:pt idx="17">
                  <c:v>2-cell</c:v>
                </c:pt>
                <c:pt idx="18">
                  <c:v>2-cell</c:v>
                </c:pt>
                <c:pt idx="19">
                  <c:v>2-cell</c:v>
                </c:pt>
                <c:pt idx="20">
                  <c:v>2-cell</c:v>
                </c:pt>
                <c:pt idx="21">
                  <c:v>2-cell</c:v>
                </c:pt>
                <c:pt idx="22">
                  <c:v>2-cell</c:v>
                </c:pt>
                <c:pt idx="23">
                  <c:v>4-cell</c:v>
                </c:pt>
                <c:pt idx="24">
                  <c:v>4-cell</c:v>
                </c:pt>
                <c:pt idx="25">
                  <c:v>4-cell</c:v>
                </c:pt>
                <c:pt idx="26">
                  <c:v>4-cell</c:v>
                </c:pt>
                <c:pt idx="27">
                  <c:v>4-cell</c:v>
                </c:pt>
                <c:pt idx="28">
                  <c:v>4-cell</c:v>
                </c:pt>
                <c:pt idx="29">
                  <c:v>4-cell</c:v>
                </c:pt>
                <c:pt idx="30">
                  <c:v>4-cell</c:v>
                </c:pt>
                <c:pt idx="31">
                  <c:v>4-cell</c:v>
                </c:pt>
                <c:pt idx="32">
                  <c:v>4-cell</c:v>
                </c:pt>
                <c:pt idx="33">
                  <c:v>4-cell</c:v>
                </c:pt>
                <c:pt idx="34">
                  <c:v>4-cell</c:v>
                </c:pt>
                <c:pt idx="35">
                  <c:v>4-cell</c:v>
                </c:pt>
                <c:pt idx="36">
                  <c:v>4-cell</c:v>
                </c:pt>
                <c:pt idx="37">
                  <c:v>4-cell</c:v>
                </c:pt>
                <c:pt idx="38">
                  <c:v>4-cell</c:v>
                </c:pt>
                <c:pt idx="39">
                  <c:v>8-cell</c:v>
                </c:pt>
                <c:pt idx="40">
                  <c:v>8-cell</c:v>
                </c:pt>
                <c:pt idx="41">
                  <c:v>8-cell</c:v>
                </c:pt>
                <c:pt idx="42">
                  <c:v>8-cell</c:v>
                </c:pt>
                <c:pt idx="43">
                  <c:v>8-cell</c:v>
                </c:pt>
                <c:pt idx="44">
                  <c:v>8-cell</c:v>
                </c:pt>
                <c:pt idx="45">
                  <c:v>8-cell</c:v>
                </c:pt>
                <c:pt idx="46">
                  <c:v>8-cell</c:v>
                </c:pt>
                <c:pt idx="47">
                  <c:v>8-cell</c:v>
                </c:pt>
                <c:pt idx="48">
                  <c:v>8-cell</c:v>
                </c:pt>
                <c:pt idx="49">
                  <c:v>8-cell</c:v>
                </c:pt>
                <c:pt idx="50">
                  <c:v>8-cell</c:v>
                </c:pt>
                <c:pt idx="51">
                  <c:v>8-cell</c:v>
                </c:pt>
                <c:pt idx="52">
                  <c:v>8-cell</c:v>
                </c:pt>
                <c:pt idx="53">
                  <c:v>8-cell</c:v>
                </c:pt>
                <c:pt idx="54">
                  <c:v>8-cell</c:v>
                </c:pt>
                <c:pt idx="55">
                  <c:v>8-cell</c:v>
                </c:pt>
                <c:pt idx="56">
                  <c:v>8-cell</c:v>
                </c:pt>
                <c:pt idx="57">
                  <c:v>8-cell</c:v>
                </c:pt>
                <c:pt idx="58">
                  <c:v>8-cell</c:v>
                </c:pt>
                <c:pt idx="59">
                  <c:v>8-cell</c:v>
                </c:pt>
                <c:pt idx="60">
                  <c:v>8-cell</c:v>
                </c:pt>
                <c:pt idx="61">
                  <c:v>8-cell</c:v>
                </c:pt>
                <c:pt idx="62">
                  <c:v>8-cell</c:v>
                </c:pt>
                <c:pt idx="63">
                  <c:v>8-cell</c:v>
                </c:pt>
                <c:pt idx="64">
                  <c:v>8-cell</c:v>
                </c:pt>
                <c:pt idx="65">
                  <c:v>Morulae</c:v>
                </c:pt>
                <c:pt idx="66">
                  <c:v>Morulae</c:v>
                </c:pt>
                <c:pt idx="67">
                  <c:v>Morulae</c:v>
                </c:pt>
                <c:pt idx="68">
                  <c:v>Morulae</c:v>
                </c:pt>
                <c:pt idx="69">
                  <c:v>Morulae</c:v>
                </c:pt>
                <c:pt idx="70">
                  <c:v>Morulae</c:v>
                </c:pt>
                <c:pt idx="71">
                  <c:v>Morulae</c:v>
                </c:pt>
                <c:pt idx="72">
                  <c:v>Morulae</c:v>
                </c:pt>
                <c:pt idx="73">
                  <c:v>Morulae</c:v>
                </c:pt>
                <c:pt idx="74">
                  <c:v>Morulae</c:v>
                </c:pt>
                <c:pt idx="75">
                  <c:v>Morulae</c:v>
                </c:pt>
                <c:pt idx="76">
                  <c:v>Morulae</c:v>
                </c:pt>
                <c:pt idx="77">
                  <c:v>Morulae</c:v>
                </c:pt>
                <c:pt idx="78">
                  <c:v>Morulae</c:v>
                </c:pt>
                <c:pt idx="79">
                  <c:v>Morulae</c:v>
                </c:pt>
                <c:pt idx="80">
                  <c:v>Morulae</c:v>
                </c:pt>
                <c:pt idx="81">
                  <c:v>Morulae</c:v>
                </c:pt>
                <c:pt idx="82">
                  <c:v>Morulae</c:v>
                </c:pt>
                <c:pt idx="83">
                  <c:v>Morulae</c:v>
                </c:pt>
                <c:pt idx="84">
                  <c:v>Late_blastocyst</c:v>
                </c:pt>
                <c:pt idx="85">
                  <c:v>Late_blastocyst</c:v>
                </c:pt>
                <c:pt idx="86">
                  <c:v>Late_blastocyst</c:v>
                </c:pt>
                <c:pt idx="87">
                  <c:v>Late_blastocyst</c:v>
                </c:pt>
                <c:pt idx="88">
                  <c:v>Late_blastocyst</c:v>
                </c:pt>
                <c:pt idx="89">
                  <c:v>Late_blastocyst</c:v>
                </c:pt>
                <c:pt idx="90">
                  <c:v>Late_blastocyst</c:v>
                </c:pt>
                <c:pt idx="91">
                  <c:v>Late_blastocyst</c:v>
                </c:pt>
                <c:pt idx="92">
                  <c:v>Late_blastocyst</c:v>
                </c:pt>
                <c:pt idx="93">
                  <c:v>Late_blastocyst</c:v>
                </c:pt>
                <c:pt idx="94">
                  <c:v>Late_blastocyst</c:v>
                </c:pt>
                <c:pt idx="95">
                  <c:v>Late_blastocyst</c:v>
                </c:pt>
                <c:pt idx="96">
                  <c:v>Late_blastocyst</c:v>
                </c:pt>
                <c:pt idx="97">
                  <c:v>Late_blastocyst</c:v>
                </c:pt>
                <c:pt idx="98">
                  <c:v>Late_blastocyst</c:v>
                </c:pt>
                <c:pt idx="99">
                  <c:v>Late_blastocyst</c:v>
                </c:pt>
                <c:pt idx="100">
                  <c:v>Late_blastocyst</c:v>
                </c:pt>
                <c:pt idx="101">
                  <c:v>Late_blastocyst</c:v>
                </c:pt>
                <c:pt idx="102">
                  <c:v>Late_blastocyst</c:v>
                </c:pt>
                <c:pt idx="103">
                  <c:v>Late_blastocyst</c:v>
                </c:pt>
                <c:pt idx="104">
                  <c:v>Late_blastocyst</c:v>
                </c:pt>
                <c:pt idx="105">
                  <c:v>Late_blastocyst</c:v>
                </c:pt>
                <c:pt idx="106">
                  <c:v>Late_blastocyst</c:v>
                </c:pt>
                <c:pt idx="107">
                  <c:v>Late_blastocyst</c:v>
                </c:pt>
                <c:pt idx="108">
                  <c:v>Late_blastocyst</c:v>
                </c:pt>
                <c:pt idx="109">
                  <c:v>Late_blastocyst</c:v>
                </c:pt>
                <c:pt idx="110">
                  <c:v>Late_blastocyst</c:v>
                </c:pt>
                <c:pt idx="111">
                  <c:v>Late_blastocyst</c:v>
                </c:pt>
                <c:pt idx="112">
                  <c:v>Late_blastocyst</c:v>
                </c:pt>
                <c:pt idx="113">
                  <c:v>Late_blastocyst</c:v>
                </c:pt>
                <c:pt idx="114">
                  <c:v>hESC_P0</c:v>
                </c:pt>
                <c:pt idx="115">
                  <c:v>hESC_P0</c:v>
                </c:pt>
                <c:pt idx="116">
                  <c:v>hESC_P0</c:v>
                </c:pt>
                <c:pt idx="117">
                  <c:v>hESC_P0</c:v>
                </c:pt>
                <c:pt idx="118">
                  <c:v>hESC_P0</c:v>
                </c:pt>
                <c:pt idx="119">
                  <c:v>hESC_P0</c:v>
                </c:pt>
                <c:pt idx="120">
                  <c:v>hESC_P0</c:v>
                </c:pt>
                <c:pt idx="121">
                  <c:v>hESC_P0</c:v>
                </c:pt>
                <c:pt idx="122">
                  <c:v>hESC_P10</c:v>
                </c:pt>
                <c:pt idx="123">
                  <c:v>hESC_P10</c:v>
                </c:pt>
                <c:pt idx="124">
                  <c:v>hESC_P10</c:v>
                </c:pt>
                <c:pt idx="125">
                  <c:v>hESC_P10</c:v>
                </c:pt>
                <c:pt idx="126">
                  <c:v>hESC_P10</c:v>
                </c:pt>
                <c:pt idx="127">
                  <c:v>hESC_P10</c:v>
                </c:pt>
                <c:pt idx="128">
                  <c:v>hESC_P10</c:v>
                </c:pt>
                <c:pt idx="129">
                  <c:v>hESC_P10</c:v>
                </c:pt>
                <c:pt idx="130">
                  <c:v>hESC_P10</c:v>
                </c:pt>
                <c:pt idx="131">
                  <c:v>hESC_P10</c:v>
                </c:pt>
                <c:pt idx="132">
                  <c:v>hESC_P10</c:v>
                </c:pt>
                <c:pt idx="133">
                  <c:v>hESC_P10</c:v>
                </c:pt>
                <c:pt idx="134">
                  <c:v>hESC_P10</c:v>
                </c:pt>
                <c:pt idx="135">
                  <c:v>hESC_P10</c:v>
                </c:pt>
                <c:pt idx="136">
                  <c:v>hESC_P10</c:v>
                </c:pt>
                <c:pt idx="137">
                  <c:v>hESC_P10</c:v>
                </c:pt>
                <c:pt idx="138">
                  <c:v>hESC_P10</c:v>
                </c:pt>
                <c:pt idx="139">
                  <c:v>hESC_P10</c:v>
                </c:pt>
                <c:pt idx="140">
                  <c:v>hESC_P10</c:v>
                </c:pt>
                <c:pt idx="141">
                  <c:v>hESC_P10</c:v>
                </c:pt>
                <c:pt idx="142">
                  <c:v>hESC_P10</c:v>
                </c:pt>
                <c:pt idx="143">
                  <c:v>hESC_P10</c:v>
                </c:pt>
                <c:pt idx="144">
                  <c:v>hESC_P10</c:v>
                </c:pt>
                <c:pt idx="145">
                  <c:v>hESC_P10</c:v>
                </c:pt>
                <c:pt idx="146">
                  <c:v>hESC_P10</c:v>
                </c:pt>
                <c:pt idx="147">
                  <c:v>hESC_P10</c:v>
                </c:pt>
              </c:strCache>
            </c:strRef>
          </c:cat>
          <c:val>
            <c:numRef>
              <c:f>Sheet9!$B$9:$ES$9</c:f>
              <c:numCache>
                <c:formatCode>General</c:formatCode>
                <c:ptCount val="148"/>
                <c:pt idx="0">
                  <c:v>5.4100000000000002E-2</c:v>
                </c:pt>
                <c:pt idx="1">
                  <c:v>1.1599999999999999E-2</c:v>
                </c:pt>
                <c:pt idx="2">
                  <c:v>0.1603</c:v>
                </c:pt>
                <c:pt idx="3">
                  <c:v>0</c:v>
                </c:pt>
                <c:pt idx="4">
                  <c:v>0</c:v>
                </c:pt>
                <c:pt idx="5">
                  <c:v>0</c:v>
                </c:pt>
                <c:pt idx="6">
                  <c:v>1.4E-2</c:v>
                </c:pt>
                <c:pt idx="7">
                  <c:v>5.3499999999999999E-2</c:v>
                </c:pt>
                <c:pt idx="8">
                  <c:v>0.19520000000000001</c:v>
                </c:pt>
                <c:pt idx="9">
                  <c:v>0.36080000000000001</c:v>
                </c:pt>
                <c:pt idx="10">
                  <c:v>0.14630000000000001</c:v>
                </c:pt>
                <c:pt idx="11">
                  <c:v>0.13880000000000001</c:v>
                </c:pt>
                <c:pt idx="12">
                  <c:v>0.4375</c:v>
                </c:pt>
                <c:pt idx="13">
                  <c:v>0.31869999999999998</c:v>
                </c:pt>
                <c:pt idx="14">
                  <c:v>0.2379</c:v>
                </c:pt>
                <c:pt idx="15">
                  <c:v>0.20910000000000001</c:v>
                </c:pt>
                <c:pt idx="16">
                  <c:v>0.2354</c:v>
                </c:pt>
                <c:pt idx="17">
                  <c:v>0.48149999999999998</c:v>
                </c:pt>
                <c:pt idx="18">
                  <c:v>5.1200000000000002E-2</c:v>
                </c:pt>
                <c:pt idx="19">
                  <c:v>3.9100000000000003E-2</c:v>
                </c:pt>
                <c:pt idx="20">
                  <c:v>0</c:v>
                </c:pt>
                <c:pt idx="21">
                  <c:v>0</c:v>
                </c:pt>
                <c:pt idx="22">
                  <c:v>3.6299999999999999E-2</c:v>
                </c:pt>
                <c:pt idx="23">
                  <c:v>0.22109999999999999</c:v>
                </c:pt>
                <c:pt idx="24">
                  <c:v>0.1055</c:v>
                </c:pt>
                <c:pt idx="25">
                  <c:v>0.57210000000000005</c:v>
                </c:pt>
                <c:pt idx="26">
                  <c:v>1.6899999999999998E-2</c:v>
                </c:pt>
                <c:pt idx="27">
                  <c:v>4.5999999999999999E-2</c:v>
                </c:pt>
                <c:pt idx="28">
                  <c:v>0.1023</c:v>
                </c:pt>
                <c:pt idx="29">
                  <c:v>5.8799999999999998E-2</c:v>
                </c:pt>
                <c:pt idx="30">
                  <c:v>0.14449999999999999</c:v>
                </c:pt>
                <c:pt idx="31">
                  <c:v>0.25430000000000003</c:v>
                </c:pt>
                <c:pt idx="32">
                  <c:v>4.7300000000000002E-2</c:v>
                </c:pt>
                <c:pt idx="33">
                  <c:v>0.2198</c:v>
                </c:pt>
                <c:pt idx="34">
                  <c:v>0.69420000000000004</c:v>
                </c:pt>
                <c:pt idx="35">
                  <c:v>3.1800000000000002E-2</c:v>
                </c:pt>
                <c:pt idx="36">
                  <c:v>0</c:v>
                </c:pt>
                <c:pt idx="37">
                  <c:v>0</c:v>
                </c:pt>
                <c:pt idx="38">
                  <c:v>7.3000000000000001E-3</c:v>
                </c:pt>
                <c:pt idx="39">
                  <c:v>1.12E-2</c:v>
                </c:pt>
                <c:pt idx="40">
                  <c:v>2.35E-2</c:v>
                </c:pt>
                <c:pt idx="41">
                  <c:v>1.61E-2</c:v>
                </c:pt>
                <c:pt idx="42">
                  <c:v>1.9400000000000001E-2</c:v>
                </c:pt>
                <c:pt idx="43">
                  <c:v>1.0999999999999999E-2</c:v>
                </c:pt>
                <c:pt idx="44">
                  <c:v>5.67E-2</c:v>
                </c:pt>
                <c:pt idx="45">
                  <c:v>5.5999999999999999E-3</c:v>
                </c:pt>
                <c:pt idx="46">
                  <c:v>8.3599999999999994E-2</c:v>
                </c:pt>
                <c:pt idx="47">
                  <c:v>0.44009999999999999</c:v>
                </c:pt>
                <c:pt idx="48">
                  <c:v>1.7545999999999999</c:v>
                </c:pt>
                <c:pt idx="49">
                  <c:v>2.3900000000000001E-2</c:v>
                </c:pt>
                <c:pt idx="50">
                  <c:v>0</c:v>
                </c:pt>
                <c:pt idx="51">
                  <c:v>0</c:v>
                </c:pt>
                <c:pt idx="52">
                  <c:v>1.9699999999999999E-2</c:v>
                </c:pt>
                <c:pt idx="53">
                  <c:v>1.46E-2</c:v>
                </c:pt>
                <c:pt idx="54">
                  <c:v>0.77300000000000002</c:v>
                </c:pt>
                <c:pt idx="55">
                  <c:v>0.03</c:v>
                </c:pt>
                <c:pt idx="56">
                  <c:v>5.3E-3</c:v>
                </c:pt>
                <c:pt idx="57">
                  <c:v>4.1000000000000003E-3</c:v>
                </c:pt>
                <c:pt idx="58">
                  <c:v>9.1000000000000004E-3</c:v>
                </c:pt>
                <c:pt idx="59">
                  <c:v>6.9500000000000006E-2</c:v>
                </c:pt>
                <c:pt idx="60">
                  <c:v>0</c:v>
                </c:pt>
                <c:pt idx="61">
                  <c:v>1.6899999999999998E-2</c:v>
                </c:pt>
                <c:pt idx="62">
                  <c:v>0</c:v>
                </c:pt>
                <c:pt idx="63">
                  <c:v>3.2899999999999999E-2</c:v>
                </c:pt>
                <c:pt idx="64">
                  <c:v>0</c:v>
                </c:pt>
                <c:pt idx="65">
                  <c:v>1.2E-2</c:v>
                </c:pt>
                <c:pt idx="66">
                  <c:v>0</c:v>
                </c:pt>
                <c:pt idx="67">
                  <c:v>0</c:v>
                </c:pt>
                <c:pt idx="68">
                  <c:v>1.37E-2</c:v>
                </c:pt>
                <c:pt idx="69">
                  <c:v>2.1000000000000001E-2</c:v>
                </c:pt>
                <c:pt idx="70">
                  <c:v>0</c:v>
                </c:pt>
                <c:pt idx="71">
                  <c:v>7.3000000000000001E-3</c:v>
                </c:pt>
                <c:pt idx="72">
                  <c:v>0</c:v>
                </c:pt>
                <c:pt idx="73">
                  <c:v>4.5999999999999999E-3</c:v>
                </c:pt>
                <c:pt idx="74">
                  <c:v>0</c:v>
                </c:pt>
                <c:pt idx="75">
                  <c:v>0</c:v>
                </c:pt>
                <c:pt idx="76">
                  <c:v>0</c:v>
                </c:pt>
                <c:pt idx="77">
                  <c:v>5.3E-3</c:v>
                </c:pt>
                <c:pt idx="78">
                  <c:v>0</c:v>
                </c:pt>
                <c:pt idx="79">
                  <c:v>6.7000000000000002E-3</c:v>
                </c:pt>
                <c:pt idx="80">
                  <c:v>9.5999999999999992E-3</c:v>
                </c:pt>
                <c:pt idx="81">
                  <c:v>0</c:v>
                </c:pt>
                <c:pt idx="82">
                  <c:v>0</c:v>
                </c:pt>
                <c:pt idx="83">
                  <c:v>0</c:v>
                </c:pt>
                <c:pt idx="84">
                  <c:v>1.5900000000000001E-2</c:v>
                </c:pt>
                <c:pt idx="85">
                  <c:v>8.3000000000000001E-3</c:v>
                </c:pt>
                <c:pt idx="86">
                  <c:v>1.0699999999999999E-2</c:v>
                </c:pt>
                <c:pt idx="87">
                  <c:v>4.8999999999999998E-3</c:v>
                </c:pt>
                <c:pt idx="88">
                  <c:v>2.1000000000000001E-2</c:v>
                </c:pt>
                <c:pt idx="89">
                  <c:v>3.6799999999999999E-2</c:v>
                </c:pt>
                <c:pt idx="90">
                  <c:v>0</c:v>
                </c:pt>
                <c:pt idx="91">
                  <c:v>1.89E-2</c:v>
                </c:pt>
                <c:pt idx="92">
                  <c:v>1.66E-2</c:v>
                </c:pt>
                <c:pt idx="93">
                  <c:v>1.9900000000000001E-2</c:v>
                </c:pt>
                <c:pt idx="94">
                  <c:v>9.9000000000000008E-3</c:v>
                </c:pt>
                <c:pt idx="95">
                  <c:v>0</c:v>
                </c:pt>
                <c:pt idx="96">
                  <c:v>7.8200000000000006E-2</c:v>
                </c:pt>
                <c:pt idx="97">
                  <c:v>0.92390000000000005</c:v>
                </c:pt>
                <c:pt idx="98">
                  <c:v>8.48E-2</c:v>
                </c:pt>
                <c:pt idx="99">
                  <c:v>3.5099999999999999E-2</c:v>
                </c:pt>
                <c:pt idx="100">
                  <c:v>0</c:v>
                </c:pt>
                <c:pt idx="101">
                  <c:v>1.2800000000000001E-2</c:v>
                </c:pt>
                <c:pt idx="102">
                  <c:v>1.9199999999999998E-2</c:v>
                </c:pt>
                <c:pt idx="103">
                  <c:v>0</c:v>
                </c:pt>
                <c:pt idx="104">
                  <c:v>5.1999999999999998E-3</c:v>
                </c:pt>
                <c:pt idx="105">
                  <c:v>5.1000000000000004E-3</c:v>
                </c:pt>
                <c:pt idx="106">
                  <c:v>3.5999999999999999E-3</c:v>
                </c:pt>
                <c:pt idx="107">
                  <c:v>0</c:v>
                </c:pt>
                <c:pt idx="108">
                  <c:v>1.78E-2</c:v>
                </c:pt>
                <c:pt idx="109">
                  <c:v>8.4582999999999995</c:v>
                </c:pt>
                <c:pt idx="110">
                  <c:v>6.4488000000000003</c:v>
                </c:pt>
                <c:pt idx="111">
                  <c:v>0</c:v>
                </c:pt>
                <c:pt idx="112">
                  <c:v>4.4999999999999997E-3</c:v>
                </c:pt>
                <c:pt idx="113">
                  <c:v>0</c:v>
                </c:pt>
                <c:pt idx="114">
                  <c:v>0.91369999999999996</c:v>
                </c:pt>
                <c:pt idx="115">
                  <c:v>1.1701999999999999</c:v>
                </c:pt>
                <c:pt idx="116">
                  <c:v>2.8818000000000001</c:v>
                </c:pt>
                <c:pt idx="117">
                  <c:v>3.3313000000000001</c:v>
                </c:pt>
                <c:pt idx="118">
                  <c:v>1.5542</c:v>
                </c:pt>
                <c:pt idx="119">
                  <c:v>3.0977000000000001</c:v>
                </c:pt>
                <c:pt idx="120">
                  <c:v>2.2349000000000001</c:v>
                </c:pt>
                <c:pt idx="121">
                  <c:v>1.6201000000000001</c:v>
                </c:pt>
                <c:pt idx="122">
                  <c:v>6.7799999999999999E-2</c:v>
                </c:pt>
                <c:pt idx="123">
                  <c:v>8.4599999999999995E-2</c:v>
                </c:pt>
                <c:pt idx="124">
                  <c:v>4.5999999999999999E-2</c:v>
                </c:pt>
                <c:pt idx="125">
                  <c:v>4.6199999999999998E-2</c:v>
                </c:pt>
                <c:pt idx="126">
                  <c:v>0.16420000000000001</c:v>
                </c:pt>
                <c:pt idx="127">
                  <c:v>1.6199999999999999E-2</c:v>
                </c:pt>
                <c:pt idx="128">
                  <c:v>3.2199999999999999E-2</c:v>
                </c:pt>
                <c:pt idx="129">
                  <c:v>0.45789999999999997</c:v>
                </c:pt>
                <c:pt idx="130">
                  <c:v>5.4999999999999997E-3</c:v>
                </c:pt>
                <c:pt idx="131">
                  <c:v>4.2000000000000003E-2</c:v>
                </c:pt>
                <c:pt idx="132">
                  <c:v>0</c:v>
                </c:pt>
                <c:pt idx="133">
                  <c:v>3.1699999999999999E-2</c:v>
                </c:pt>
                <c:pt idx="134">
                  <c:v>6.2899999999999998E-2</c:v>
                </c:pt>
                <c:pt idx="135">
                  <c:v>2.47E-2</c:v>
                </c:pt>
                <c:pt idx="136">
                  <c:v>5.5599999999999997E-2</c:v>
                </c:pt>
                <c:pt idx="137">
                  <c:v>2.53E-2</c:v>
                </c:pt>
                <c:pt idx="138">
                  <c:v>5.8400000000000001E-2</c:v>
                </c:pt>
                <c:pt idx="139">
                  <c:v>6.1899999999999997E-2</c:v>
                </c:pt>
                <c:pt idx="140">
                  <c:v>0.57110000000000005</c:v>
                </c:pt>
                <c:pt idx="141">
                  <c:v>3.0599999999999999E-2</c:v>
                </c:pt>
                <c:pt idx="142">
                  <c:v>6.3799999999999996E-2</c:v>
                </c:pt>
                <c:pt idx="143">
                  <c:v>2.64E-2</c:v>
                </c:pt>
                <c:pt idx="144">
                  <c:v>5.6599999999999998E-2</c:v>
                </c:pt>
                <c:pt idx="145">
                  <c:v>3.4000000000000002E-2</c:v>
                </c:pt>
                <c:pt idx="146">
                  <c:v>1.1299999999999999E-2</c:v>
                </c:pt>
                <c:pt idx="147">
                  <c:v>6.6E-3</c:v>
                </c:pt>
              </c:numCache>
            </c:numRef>
          </c:val>
        </c:ser>
        <c:dLbls>
          <c:showLegendKey val="0"/>
          <c:showVal val="0"/>
          <c:showCatName val="0"/>
          <c:showSerName val="0"/>
          <c:showPercent val="0"/>
          <c:showBubbleSize val="0"/>
        </c:dLbls>
        <c:gapWidth val="150"/>
        <c:axId val="302061224"/>
        <c:axId val="302057304"/>
      </c:barChart>
      <c:catAx>
        <c:axId val="302061224"/>
        <c:scaling>
          <c:orientation val="minMax"/>
        </c:scaling>
        <c:delete val="0"/>
        <c:axPos val="b"/>
        <c:title>
          <c:tx>
            <c:rich>
              <a:bodyPr rot="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r>
                  <a:rPr lang="en-US" sz="1400" b="1">
                    <a:solidFill>
                      <a:sysClr val="windowText" lastClr="000000"/>
                    </a:solidFill>
                  </a:rPr>
                  <a:t>EMBRYOGENESIS</a:t>
                </a:r>
                <a:r>
                  <a:rPr lang="en-US" sz="1400" b="1" baseline="0">
                    <a:solidFill>
                      <a:sysClr val="windowText" lastClr="000000"/>
                    </a:solidFill>
                  </a:rPr>
                  <a:t> STAGE</a:t>
                </a:r>
                <a:endParaRPr lang="en-US" sz="1400" b="1">
                  <a:solidFill>
                    <a:sysClr val="windowText" lastClr="000000"/>
                  </a:solidFill>
                </a:endParaRPr>
              </a:p>
            </c:rich>
          </c:tx>
          <c:overlay val="0"/>
          <c:spPr>
            <a:noFill/>
            <a:ln>
              <a:noFill/>
            </a:ln>
            <a:effectLst/>
          </c:spPr>
          <c:txPr>
            <a:bodyPr rot="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mn-lt"/>
                <a:ea typeface="+mn-ea"/>
                <a:cs typeface="+mn-cs"/>
              </a:defRPr>
            </a:pPr>
            <a:endParaRPr lang="en-US"/>
          </a:p>
        </c:txPr>
        <c:crossAx val="302057304"/>
        <c:crosses val="autoZero"/>
        <c:auto val="1"/>
        <c:lblAlgn val="ctr"/>
        <c:lblOffset val="100"/>
        <c:noMultiLvlLbl val="0"/>
      </c:catAx>
      <c:valAx>
        <c:axId val="302057304"/>
        <c:scaling>
          <c:orientation val="minMax"/>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r>
                  <a:rPr lang="en-US" sz="1400" b="1">
                    <a:solidFill>
                      <a:sysClr val="windowText" lastClr="000000"/>
                    </a:solidFill>
                  </a:rPr>
                  <a:t>HPAT3</a:t>
                </a:r>
                <a:r>
                  <a:rPr lang="en-US" sz="1400" b="1" baseline="0">
                    <a:solidFill>
                      <a:sysClr val="windowText" lastClr="000000"/>
                    </a:solidFill>
                  </a:rPr>
                  <a:t> EXPRESSION</a:t>
                </a:r>
                <a:endParaRPr lang="en-US" sz="1400" b="1">
                  <a:solidFill>
                    <a:sysClr val="windowText" lastClr="000000"/>
                  </a:solidFill>
                </a:endParaRPr>
              </a:p>
            </c:rich>
          </c:tx>
          <c:layout>
            <c:manualLayout>
              <c:xMode val="edge"/>
              <c:yMode val="edge"/>
              <c:x val="2.6385541000545253E-2"/>
              <c:y val="0.35794428782450938"/>
            </c:manualLayout>
          </c:layout>
          <c:overlay val="0"/>
          <c:spPr>
            <a:noFill/>
            <a:ln>
              <a:noFill/>
            </a:ln>
            <a:effectLst/>
          </c:spPr>
          <c:txPr>
            <a:bodyPr rot="-54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mn-lt"/>
                <a:ea typeface="+mn-ea"/>
                <a:cs typeface="+mn-cs"/>
              </a:defRPr>
            </a:pPr>
            <a:endParaRPr lang="en-US"/>
          </a:p>
        </c:txPr>
        <c:crossAx val="302061224"/>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lumMod val="65000"/>
                    <a:lumOff val="35000"/>
                  </a:sysClr>
                </a:solidFill>
                <a:latin typeface="+mn-lt"/>
                <a:ea typeface="+mn-ea"/>
                <a:cs typeface="+mn-cs"/>
              </a:defRPr>
            </a:pPr>
            <a:r>
              <a:rPr lang="en-US" sz="1800" b="1" i="0" baseline="0">
                <a:effectLst/>
              </a:rPr>
              <a:t>Single cell analysis of the HPAT4 expression in human embryos</a:t>
            </a:r>
            <a:endParaRPr lang="en-US">
              <a:effectLst/>
            </a:endParaRPr>
          </a:p>
        </c:rich>
      </c:tx>
      <c:overlay val="0"/>
      <c:spPr>
        <a:noFill/>
        <a:ln>
          <a:noFill/>
        </a:ln>
        <a:effectLst/>
      </c:spPr>
      <c:txPr>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lumMod val="65000"/>
                  <a:lumOff val="35000"/>
                </a:sysClr>
              </a:solidFill>
              <a:latin typeface="+mn-lt"/>
              <a:ea typeface="+mn-ea"/>
              <a:cs typeface="+mn-cs"/>
            </a:defRPr>
          </a:pPr>
          <a:endParaRPr lang="en-US"/>
        </a:p>
      </c:txPr>
    </c:title>
    <c:autoTitleDeleted val="0"/>
    <c:plotArea>
      <c:layout>
        <c:manualLayout>
          <c:layoutTarget val="inner"/>
          <c:xMode val="edge"/>
          <c:yMode val="edge"/>
          <c:x val="9.3695679373432275E-2"/>
          <c:y val="7.7573933354640009E-2"/>
          <c:w val="0.8901798233484568"/>
          <c:h val="0.71333702224957107"/>
        </c:manualLayout>
      </c:layout>
      <c:barChart>
        <c:barDir val="col"/>
        <c:grouping val="clustered"/>
        <c:varyColors val="0"/>
        <c:ser>
          <c:idx val="0"/>
          <c:order val="0"/>
          <c:tx>
            <c:strRef>
              <c:f>Sheet5!$D$29</c:f>
              <c:strCache>
                <c:ptCount val="1"/>
                <c:pt idx="0">
                  <c:v>HPAT4</c:v>
                </c:pt>
              </c:strCache>
            </c:strRef>
          </c:tx>
          <c:spPr>
            <a:solidFill>
              <a:schemeClr val="accent1"/>
            </a:solidFill>
            <a:ln>
              <a:solidFill>
                <a:schemeClr val="accent1"/>
              </a:solidFill>
            </a:ln>
            <a:effectLst/>
          </c:spPr>
          <c:invertIfNegative val="0"/>
          <c:cat>
            <c:strRef>
              <c:f>Sheet5!$E$28:$EV$28</c:f>
              <c:strCache>
                <c:ptCount val="148"/>
                <c:pt idx="0">
                  <c:v>Oocyte</c:v>
                </c:pt>
                <c:pt idx="1">
                  <c:v>Oocyte</c:v>
                </c:pt>
                <c:pt idx="2">
                  <c:v>Oocyte</c:v>
                </c:pt>
                <c:pt idx="3">
                  <c:v>Oocyte</c:v>
                </c:pt>
                <c:pt idx="4">
                  <c:v>Oocyte</c:v>
                </c:pt>
                <c:pt idx="5">
                  <c:v>Oocyte</c:v>
                </c:pt>
                <c:pt idx="6">
                  <c:v>Pronuclei</c:v>
                </c:pt>
                <c:pt idx="7">
                  <c:v>Pronuclei</c:v>
                </c:pt>
                <c:pt idx="8">
                  <c:v>Pronuclei</c:v>
                </c:pt>
                <c:pt idx="9">
                  <c:v>Zygote</c:v>
                </c:pt>
                <c:pt idx="10">
                  <c:v>Zygote</c:v>
                </c:pt>
                <c:pt idx="11">
                  <c:v>Zygote</c:v>
                </c:pt>
                <c:pt idx="12">
                  <c:v>Zygote</c:v>
                </c:pt>
                <c:pt idx="13">
                  <c:v>Zygote</c:v>
                </c:pt>
                <c:pt idx="14">
                  <c:v>2-cell</c:v>
                </c:pt>
                <c:pt idx="15">
                  <c:v>2-cell</c:v>
                </c:pt>
                <c:pt idx="16">
                  <c:v>2-cell</c:v>
                </c:pt>
                <c:pt idx="17">
                  <c:v>2-cell</c:v>
                </c:pt>
                <c:pt idx="18">
                  <c:v>2-cell</c:v>
                </c:pt>
                <c:pt idx="19">
                  <c:v>2-cell</c:v>
                </c:pt>
                <c:pt idx="20">
                  <c:v>2-cell</c:v>
                </c:pt>
                <c:pt idx="21">
                  <c:v>2-cell</c:v>
                </c:pt>
                <c:pt idx="22">
                  <c:v>2-cell</c:v>
                </c:pt>
                <c:pt idx="23">
                  <c:v>4-cell</c:v>
                </c:pt>
                <c:pt idx="24">
                  <c:v>4-cell</c:v>
                </c:pt>
                <c:pt idx="25">
                  <c:v>4-cell</c:v>
                </c:pt>
                <c:pt idx="26">
                  <c:v>4-cell</c:v>
                </c:pt>
                <c:pt idx="27">
                  <c:v>4-cell</c:v>
                </c:pt>
                <c:pt idx="28">
                  <c:v>4-cell</c:v>
                </c:pt>
                <c:pt idx="29">
                  <c:v>4-cell</c:v>
                </c:pt>
                <c:pt idx="30">
                  <c:v>4-cell</c:v>
                </c:pt>
                <c:pt idx="31">
                  <c:v>4-cell</c:v>
                </c:pt>
                <c:pt idx="32">
                  <c:v>4-cell</c:v>
                </c:pt>
                <c:pt idx="33">
                  <c:v>4-cell</c:v>
                </c:pt>
                <c:pt idx="34">
                  <c:v>4-cell</c:v>
                </c:pt>
                <c:pt idx="35">
                  <c:v>4-cell</c:v>
                </c:pt>
                <c:pt idx="36">
                  <c:v>4-cell</c:v>
                </c:pt>
                <c:pt idx="37">
                  <c:v>4-cell</c:v>
                </c:pt>
                <c:pt idx="38">
                  <c:v>4-cell</c:v>
                </c:pt>
                <c:pt idx="39">
                  <c:v>8-cell</c:v>
                </c:pt>
                <c:pt idx="40">
                  <c:v>8-cell</c:v>
                </c:pt>
                <c:pt idx="41">
                  <c:v>8-cell</c:v>
                </c:pt>
                <c:pt idx="42">
                  <c:v>8-cell</c:v>
                </c:pt>
                <c:pt idx="43">
                  <c:v>8-cell</c:v>
                </c:pt>
                <c:pt idx="44">
                  <c:v>8-cell</c:v>
                </c:pt>
                <c:pt idx="45">
                  <c:v>8-cell</c:v>
                </c:pt>
                <c:pt idx="46">
                  <c:v>8-cell</c:v>
                </c:pt>
                <c:pt idx="47">
                  <c:v>8-cell</c:v>
                </c:pt>
                <c:pt idx="48">
                  <c:v>8-cell</c:v>
                </c:pt>
                <c:pt idx="49">
                  <c:v>8-cell</c:v>
                </c:pt>
                <c:pt idx="50">
                  <c:v>8-cell</c:v>
                </c:pt>
                <c:pt idx="51">
                  <c:v>8-cell</c:v>
                </c:pt>
                <c:pt idx="52">
                  <c:v>8-cell</c:v>
                </c:pt>
                <c:pt idx="53">
                  <c:v>8-cell</c:v>
                </c:pt>
                <c:pt idx="54">
                  <c:v>8-cell</c:v>
                </c:pt>
                <c:pt idx="55">
                  <c:v>8-cell</c:v>
                </c:pt>
                <c:pt idx="56">
                  <c:v>8-cell</c:v>
                </c:pt>
                <c:pt idx="57">
                  <c:v>8-cell</c:v>
                </c:pt>
                <c:pt idx="58">
                  <c:v>8-cell</c:v>
                </c:pt>
                <c:pt idx="59">
                  <c:v>8-cell</c:v>
                </c:pt>
                <c:pt idx="60">
                  <c:v>8-cell</c:v>
                </c:pt>
                <c:pt idx="61">
                  <c:v>8-cell</c:v>
                </c:pt>
                <c:pt idx="62">
                  <c:v>8-cell</c:v>
                </c:pt>
                <c:pt idx="63">
                  <c:v>8-cell</c:v>
                </c:pt>
                <c:pt idx="64">
                  <c:v>8-cell</c:v>
                </c:pt>
                <c:pt idx="65">
                  <c:v>Morulae</c:v>
                </c:pt>
                <c:pt idx="66">
                  <c:v>Morulae</c:v>
                </c:pt>
                <c:pt idx="67">
                  <c:v>Morulae</c:v>
                </c:pt>
                <c:pt idx="68">
                  <c:v>Morulae</c:v>
                </c:pt>
                <c:pt idx="69">
                  <c:v>Morulae</c:v>
                </c:pt>
                <c:pt idx="70">
                  <c:v>Morulae</c:v>
                </c:pt>
                <c:pt idx="71">
                  <c:v>Morulae</c:v>
                </c:pt>
                <c:pt idx="72">
                  <c:v>Morulae</c:v>
                </c:pt>
                <c:pt idx="73">
                  <c:v>Morulae</c:v>
                </c:pt>
                <c:pt idx="74">
                  <c:v>Morulae</c:v>
                </c:pt>
                <c:pt idx="75">
                  <c:v>Morulae</c:v>
                </c:pt>
                <c:pt idx="76">
                  <c:v>Morulae</c:v>
                </c:pt>
                <c:pt idx="77">
                  <c:v>Morulae</c:v>
                </c:pt>
                <c:pt idx="78">
                  <c:v>Morulae</c:v>
                </c:pt>
                <c:pt idx="79">
                  <c:v>Morulae</c:v>
                </c:pt>
                <c:pt idx="80">
                  <c:v>Morulae</c:v>
                </c:pt>
                <c:pt idx="81">
                  <c:v>Morulae</c:v>
                </c:pt>
                <c:pt idx="82">
                  <c:v>Morulae</c:v>
                </c:pt>
                <c:pt idx="83">
                  <c:v>Morulae</c:v>
                </c:pt>
                <c:pt idx="84">
                  <c:v>Late_blastocyst</c:v>
                </c:pt>
                <c:pt idx="85">
                  <c:v>Late_blastocyst</c:v>
                </c:pt>
                <c:pt idx="86">
                  <c:v>Late_blastocyst</c:v>
                </c:pt>
                <c:pt idx="87">
                  <c:v>Late_blastocyst</c:v>
                </c:pt>
                <c:pt idx="88">
                  <c:v>Late_blastocyst</c:v>
                </c:pt>
                <c:pt idx="89">
                  <c:v>Late_blastocyst</c:v>
                </c:pt>
                <c:pt idx="90">
                  <c:v>Late_blastocyst</c:v>
                </c:pt>
                <c:pt idx="91">
                  <c:v>Late_blastocyst</c:v>
                </c:pt>
                <c:pt idx="92">
                  <c:v>Late_blastocyst</c:v>
                </c:pt>
                <c:pt idx="93">
                  <c:v>Late_blastocyst</c:v>
                </c:pt>
                <c:pt idx="94">
                  <c:v>Late_blastocyst</c:v>
                </c:pt>
                <c:pt idx="95">
                  <c:v>Late_blastocyst</c:v>
                </c:pt>
                <c:pt idx="96">
                  <c:v>Late_blastocyst</c:v>
                </c:pt>
                <c:pt idx="97">
                  <c:v>Late_blastocyst</c:v>
                </c:pt>
                <c:pt idx="98">
                  <c:v>Late_blastocyst</c:v>
                </c:pt>
                <c:pt idx="99">
                  <c:v>Late_blastocyst</c:v>
                </c:pt>
                <c:pt idx="100">
                  <c:v>Late_blastocyst</c:v>
                </c:pt>
                <c:pt idx="101">
                  <c:v>Late_blastocyst</c:v>
                </c:pt>
                <c:pt idx="102">
                  <c:v>Late_blastocyst</c:v>
                </c:pt>
                <c:pt idx="103">
                  <c:v>Late_blastocyst</c:v>
                </c:pt>
                <c:pt idx="104">
                  <c:v>Late_blastocyst</c:v>
                </c:pt>
                <c:pt idx="105">
                  <c:v>Late_blastocyst</c:v>
                </c:pt>
                <c:pt idx="106">
                  <c:v>Late_blastocyst</c:v>
                </c:pt>
                <c:pt idx="107">
                  <c:v>Late_blastocyst</c:v>
                </c:pt>
                <c:pt idx="108">
                  <c:v>Late_blastocyst</c:v>
                </c:pt>
                <c:pt idx="109">
                  <c:v>Late_blastocyst</c:v>
                </c:pt>
                <c:pt idx="110">
                  <c:v>Late_blastocyst</c:v>
                </c:pt>
                <c:pt idx="111">
                  <c:v>Late_blastocyst</c:v>
                </c:pt>
                <c:pt idx="112">
                  <c:v>Late_blastocyst</c:v>
                </c:pt>
                <c:pt idx="113">
                  <c:v>Late_blastocyst</c:v>
                </c:pt>
                <c:pt idx="114">
                  <c:v>hESC_P0</c:v>
                </c:pt>
                <c:pt idx="115">
                  <c:v>hESC_P0</c:v>
                </c:pt>
                <c:pt idx="116">
                  <c:v>hESC_P0</c:v>
                </c:pt>
                <c:pt idx="117">
                  <c:v>hESC_P0</c:v>
                </c:pt>
                <c:pt idx="118">
                  <c:v>hESC_P0</c:v>
                </c:pt>
                <c:pt idx="119">
                  <c:v>hESC_P0</c:v>
                </c:pt>
                <c:pt idx="120">
                  <c:v>hESC_P0</c:v>
                </c:pt>
                <c:pt idx="121">
                  <c:v>hESC_P0</c:v>
                </c:pt>
                <c:pt idx="122">
                  <c:v>hESC_P10</c:v>
                </c:pt>
                <c:pt idx="123">
                  <c:v>hESC_P10</c:v>
                </c:pt>
                <c:pt idx="124">
                  <c:v>hESC_P10</c:v>
                </c:pt>
                <c:pt idx="125">
                  <c:v>hESC_P10</c:v>
                </c:pt>
                <c:pt idx="126">
                  <c:v>hESC_P10</c:v>
                </c:pt>
                <c:pt idx="127">
                  <c:v>hESC_P10</c:v>
                </c:pt>
                <c:pt idx="128">
                  <c:v>hESC_P10</c:v>
                </c:pt>
                <c:pt idx="129">
                  <c:v>hESC_P10</c:v>
                </c:pt>
                <c:pt idx="130">
                  <c:v>hESC_P10</c:v>
                </c:pt>
                <c:pt idx="131">
                  <c:v>hESC_P10</c:v>
                </c:pt>
                <c:pt idx="132">
                  <c:v>hESC_P10</c:v>
                </c:pt>
                <c:pt idx="133">
                  <c:v>hESC_P10</c:v>
                </c:pt>
                <c:pt idx="134">
                  <c:v>hESC_P10</c:v>
                </c:pt>
                <c:pt idx="135">
                  <c:v>hESC_P10</c:v>
                </c:pt>
                <c:pt idx="136">
                  <c:v>hESC_P10</c:v>
                </c:pt>
                <c:pt idx="137">
                  <c:v>hESC_P10</c:v>
                </c:pt>
                <c:pt idx="138">
                  <c:v>hESC_P10</c:v>
                </c:pt>
                <c:pt idx="139">
                  <c:v>hESC_P10</c:v>
                </c:pt>
                <c:pt idx="140">
                  <c:v>hESC_P10</c:v>
                </c:pt>
                <c:pt idx="141">
                  <c:v>hESC_P10</c:v>
                </c:pt>
                <c:pt idx="142">
                  <c:v>hESC_P10</c:v>
                </c:pt>
                <c:pt idx="143">
                  <c:v>hESC_P10</c:v>
                </c:pt>
                <c:pt idx="144">
                  <c:v>hESC_P10</c:v>
                </c:pt>
                <c:pt idx="145">
                  <c:v>hESC_P10</c:v>
                </c:pt>
                <c:pt idx="146">
                  <c:v>hESC_P10</c:v>
                </c:pt>
                <c:pt idx="147">
                  <c:v>hESC_P10</c:v>
                </c:pt>
              </c:strCache>
            </c:strRef>
          </c:cat>
          <c:val>
            <c:numRef>
              <c:f>Sheet5!$E$29:$EV$29</c:f>
              <c:numCache>
                <c:formatCode>General</c:formatCode>
                <c:ptCount val="148"/>
                <c:pt idx="0">
                  <c:v>1.9085000000000001</c:v>
                </c:pt>
                <c:pt idx="1">
                  <c:v>2.0855000000000001</c:v>
                </c:pt>
                <c:pt idx="2">
                  <c:v>2.1884999999999999</c:v>
                </c:pt>
                <c:pt idx="3">
                  <c:v>4.1314000000000002</c:v>
                </c:pt>
                <c:pt idx="4">
                  <c:v>1.7603</c:v>
                </c:pt>
                <c:pt idx="5">
                  <c:v>3.4691999999999998</c:v>
                </c:pt>
                <c:pt idx="6">
                  <c:v>5.8395000000000001</c:v>
                </c:pt>
                <c:pt idx="7">
                  <c:v>2.9508999999999999</c:v>
                </c:pt>
                <c:pt idx="8">
                  <c:v>6.9355000000000002</c:v>
                </c:pt>
                <c:pt idx="9">
                  <c:v>1.7478</c:v>
                </c:pt>
                <c:pt idx="10">
                  <c:v>2.6703999999999999</c:v>
                </c:pt>
                <c:pt idx="11">
                  <c:v>1.992</c:v>
                </c:pt>
                <c:pt idx="12">
                  <c:v>1.9111</c:v>
                </c:pt>
                <c:pt idx="13">
                  <c:v>2.7441</c:v>
                </c:pt>
                <c:pt idx="14">
                  <c:v>3.1756000000000002</c:v>
                </c:pt>
                <c:pt idx="15">
                  <c:v>3.0207000000000002</c:v>
                </c:pt>
                <c:pt idx="16">
                  <c:v>2.9150999999999998</c:v>
                </c:pt>
                <c:pt idx="17">
                  <c:v>3.4807000000000001</c:v>
                </c:pt>
                <c:pt idx="18">
                  <c:v>2.6568999999999998</c:v>
                </c:pt>
                <c:pt idx="19">
                  <c:v>2.9125999999999999</c:v>
                </c:pt>
                <c:pt idx="20">
                  <c:v>5.8993000000000002</c:v>
                </c:pt>
                <c:pt idx="21">
                  <c:v>1.7284999999999999</c:v>
                </c:pt>
                <c:pt idx="22">
                  <c:v>1.5891999999999999</c:v>
                </c:pt>
                <c:pt idx="23">
                  <c:v>3.5367000000000002</c:v>
                </c:pt>
                <c:pt idx="24">
                  <c:v>5.1661999999999999</c:v>
                </c:pt>
                <c:pt idx="25">
                  <c:v>2.1791999999999998</c:v>
                </c:pt>
                <c:pt idx="26">
                  <c:v>4.2843999999999998</c:v>
                </c:pt>
                <c:pt idx="27">
                  <c:v>1.4123000000000001</c:v>
                </c:pt>
                <c:pt idx="28">
                  <c:v>2.2250999999999999</c:v>
                </c:pt>
                <c:pt idx="29">
                  <c:v>1.8701000000000001</c:v>
                </c:pt>
                <c:pt idx="30">
                  <c:v>2.9984999999999999</c:v>
                </c:pt>
                <c:pt idx="31">
                  <c:v>1.9331</c:v>
                </c:pt>
                <c:pt idx="32">
                  <c:v>1.5141</c:v>
                </c:pt>
                <c:pt idx="33">
                  <c:v>2.1234000000000002</c:v>
                </c:pt>
                <c:pt idx="34">
                  <c:v>2.1259999999999999</c:v>
                </c:pt>
                <c:pt idx="35">
                  <c:v>4.1214000000000004</c:v>
                </c:pt>
                <c:pt idx="36">
                  <c:v>1.6816</c:v>
                </c:pt>
                <c:pt idx="37">
                  <c:v>0.67600000000000005</c:v>
                </c:pt>
                <c:pt idx="38">
                  <c:v>2.085</c:v>
                </c:pt>
                <c:pt idx="39">
                  <c:v>6.08E-2</c:v>
                </c:pt>
                <c:pt idx="40">
                  <c:v>0.2082</c:v>
                </c:pt>
                <c:pt idx="41">
                  <c:v>6.3200000000000006E-2</c:v>
                </c:pt>
                <c:pt idx="42">
                  <c:v>0.1991</c:v>
                </c:pt>
                <c:pt idx="43">
                  <c:v>0.16420000000000001</c:v>
                </c:pt>
                <c:pt idx="44">
                  <c:v>0.19439999999999999</c:v>
                </c:pt>
                <c:pt idx="45">
                  <c:v>0.2026</c:v>
                </c:pt>
                <c:pt idx="46">
                  <c:v>1.5309999999999999</c:v>
                </c:pt>
                <c:pt idx="47">
                  <c:v>1.5026999999999999</c:v>
                </c:pt>
                <c:pt idx="48">
                  <c:v>1.1432</c:v>
                </c:pt>
                <c:pt idx="49">
                  <c:v>2.6522999999999999</c:v>
                </c:pt>
                <c:pt idx="50">
                  <c:v>0.63990000000000002</c:v>
                </c:pt>
                <c:pt idx="51">
                  <c:v>1.2587999999999999</c:v>
                </c:pt>
                <c:pt idx="52">
                  <c:v>1.0210999999999999</c:v>
                </c:pt>
                <c:pt idx="53">
                  <c:v>0.74060000000000004</c:v>
                </c:pt>
                <c:pt idx="54">
                  <c:v>0.86380000000000001</c:v>
                </c:pt>
                <c:pt idx="55">
                  <c:v>2.0007999999999999</c:v>
                </c:pt>
                <c:pt idx="56">
                  <c:v>0.59750000000000003</c:v>
                </c:pt>
                <c:pt idx="57">
                  <c:v>0.17560000000000001</c:v>
                </c:pt>
                <c:pt idx="58">
                  <c:v>0.63780000000000003</c:v>
                </c:pt>
                <c:pt idx="59">
                  <c:v>0.65349999999999997</c:v>
                </c:pt>
                <c:pt idx="60">
                  <c:v>0.50549999999999995</c:v>
                </c:pt>
                <c:pt idx="61">
                  <c:v>0.79149999999999998</c:v>
                </c:pt>
                <c:pt idx="62">
                  <c:v>0.33479999999999999</c:v>
                </c:pt>
                <c:pt idx="63">
                  <c:v>1.0112000000000001</c:v>
                </c:pt>
                <c:pt idx="64">
                  <c:v>0.1245</c:v>
                </c:pt>
                <c:pt idx="65">
                  <c:v>0.2356</c:v>
                </c:pt>
                <c:pt idx="66">
                  <c:v>1.1299999999999999E-2</c:v>
                </c:pt>
                <c:pt idx="67">
                  <c:v>2.9000000000000001E-2</c:v>
                </c:pt>
                <c:pt idx="68">
                  <c:v>7.4499999999999997E-2</c:v>
                </c:pt>
                <c:pt idx="69">
                  <c:v>2.86E-2</c:v>
                </c:pt>
                <c:pt idx="70">
                  <c:v>6.0299999999999999E-2</c:v>
                </c:pt>
                <c:pt idx="71">
                  <c:v>5.3199999999999997E-2</c:v>
                </c:pt>
                <c:pt idx="72">
                  <c:v>0</c:v>
                </c:pt>
                <c:pt idx="73">
                  <c:v>5.3800000000000001E-2</c:v>
                </c:pt>
                <c:pt idx="74">
                  <c:v>0.23530000000000001</c:v>
                </c:pt>
                <c:pt idx="75">
                  <c:v>9.6500000000000002E-2</c:v>
                </c:pt>
                <c:pt idx="76">
                  <c:v>7.0900000000000005E-2</c:v>
                </c:pt>
                <c:pt idx="77">
                  <c:v>0</c:v>
                </c:pt>
                <c:pt idx="78">
                  <c:v>0.10639999999999999</c:v>
                </c:pt>
                <c:pt idx="79">
                  <c:v>0.15720000000000001</c:v>
                </c:pt>
                <c:pt idx="80">
                  <c:v>1.3100000000000001E-2</c:v>
                </c:pt>
                <c:pt idx="81">
                  <c:v>2.06E-2</c:v>
                </c:pt>
                <c:pt idx="82">
                  <c:v>0</c:v>
                </c:pt>
                <c:pt idx="83">
                  <c:v>1.47E-2</c:v>
                </c:pt>
                <c:pt idx="84">
                  <c:v>7.1999999999999998E-3</c:v>
                </c:pt>
                <c:pt idx="85">
                  <c:v>2.2700000000000001E-2</c:v>
                </c:pt>
                <c:pt idx="86">
                  <c:v>0</c:v>
                </c:pt>
                <c:pt idx="87">
                  <c:v>0</c:v>
                </c:pt>
                <c:pt idx="88">
                  <c:v>1.43E-2</c:v>
                </c:pt>
                <c:pt idx="89">
                  <c:v>4.0099999999999997E-2</c:v>
                </c:pt>
                <c:pt idx="90">
                  <c:v>2.4899999999999999E-2</c:v>
                </c:pt>
                <c:pt idx="91">
                  <c:v>5.7000000000000002E-3</c:v>
                </c:pt>
                <c:pt idx="92">
                  <c:v>2.7E-2</c:v>
                </c:pt>
                <c:pt idx="93">
                  <c:v>1.2E-2</c:v>
                </c:pt>
                <c:pt idx="94">
                  <c:v>2.69E-2</c:v>
                </c:pt>
                <c:pt idx="95">
                  <c:v>7.3000000000000001E-3</c:v>
                </c:pt>
                <c:pt idx="96">
                  <c:v>1.09E-2</c:v>
                </c:pt>
                <c:pt idx="97">
                  <c:v>7.9299999999999995E-2</c:v>
                </c:pt>
                <c:pt idx="98">
                  <c:v>7.0000000000000001E-3</c:v>
                </c:pt>
                <c:pt idx="99">
                  <c:v>1.2699999999999999E-2</c:v>
                </c:pt>
                <c:pt idx="100">
                  <c:v>6.3E-3</c:v>
                </c:pt>
                <c:pt idx="101">
                  <c:v>0</c:v>
                </c:pt>
                <c:pt idx="102">
                  <c:v>8.6999999999999994E-3</c:v>
                </c:pt>
                <c:pt idx="103">
                  <c:v>0</c:v>
                </c:pt>
                <c:pt idx="104">
                  <c:v>0</c:v>
                </c:pt>
                <c:pt idx="105">
                  <c:v>9.2999999999999992E-3</c:v>
                </c:pt>
                <c:pt idx="106">
                  <c:v>0</c:v>
                </c:pt>
                <c:pt idx="107">
                  <c:v>1.21E-2</c:v>
                </c:pt>
                <c:pt idx="108">
                  <c:v>0</c:v>
                </c:pt>
                <c:pt idx="109">
                  <c:v>0.11799999999999999</c:v>
                </c:pt>
                <c:pt idx="110">
                  <c:v>0.24</c:v>
                </c:pt>
                <c:pt idx="111">
                  <c:v>0</c:v>
                </c:pt>
                <c:pt idx="112">
                  <c:v>1.23E-2</c:v>
                </c:pt>
                <c:pt idx="113">
                  <c:v>3.3999999999999998E-3</c:v>
                </c:pt>
                <c:pt idx="114">
                  <c:v>0.98470000000000002</c:v>
                </c:pt>
                <c:pt idx="115">
                  <c:v>2.488</c:v>
                </c:pt>
                <c:pt idx="116">
                  <c:v>2.7515000000000001</c:v>
                </c:pt>
                <c:pt idx="117">
                  <c:v>0.96340000000000003</c:v>
                </c:pt>
                <c:pt idx="118">
                  <c:v>1.7350000000000001</c:v>
                </c:pt>
                <c:pt idx="119">
                  <c:v>2.0836999999999999</c:v>
                </c:pt>
                <c:pt idx="120">
                  <c:v>3.5236000000000001</c:v>
                </c:pt>
                <c:pt idx="121">
                  <c:v>0.83450000000000002</c:v>
                </c:pt>
                <c:pt idx="122">
                  <c:v>0.13469999999999999</c:v>
                </c:pt>
                <c:pt idx="123">
                  <c:v>8.8300000000000003E-2</c:v>
                </c:pt>
                <c:pt idx="124">
                  <c:v>6.5000000000000002E-2</c:v>
                </c:pt>
                <c:pt idx="125">
                  <c:v>4.19E-2</c:v>
                </c:pt>
                <c:pt idx="126">
                  <c:v>7.2300000000000003E-2</c:v>
                </c:pt>
                <c:pt idx="127">
                  <c:v>0.1857</c:v>
                </c:pt>
                <c:pt idx="128">
                  <c:v>0.82509999999999994</c:v>
                </c:pt>
                <c:pt idx="129">
                  <c:v>3.9E-2</c:v>
                </c:pt>
                <c:pt idx="130">
                  <c:v>1.4999999999999999E-2</c:v>
                </c:pt>
                <c:pt idx="131">
                  <c:v>6.6699999999999995E-2</c:v>
                </c:pt>
                <c:pt idx="132">
                  <c:v>3.7499999999999999E-2</c:v>
                </c:pt>
                <c:pt idx="133">
                  <c:v>8.6300000000000002E-2</c:v>
                </c:pt>
                <c:pt idx="134">
                  <c:v>5.7099999999999998E-2</c:v>
                </c:pt>
                <c:pt idx="135">
                  <c:v>0</c:v>
                </c:pt>
                <c:pt idx="136">
                  <c:v>6.1600000000000002E-2</c:v>
                </c:pt>
                <c:pt idx="137">
                  <c:v>2.75E-2</c:v>
                </c:pt>
                <c:pt idx="138">
                  <c:v>6.3600000000000004E-2</c:v>
                </c:pt>
                <c:pt idx="139">
                  <c:v>0.1166</c:v>
                </c:pt>
                <c:pt idx="140">
                  <c:v>0.10539999999999999</c:v>
                </c:pt>
                <c:pt idx="141">
                  <c:v>5.5999999999999999E-3</c:v>
                </c:pt>
                <c:pt idx="142">
                  <c:v>0.30520000000000003</c:v>
                </c:pt>
                <c:pt idx="143">
                  <c:v>1.2E-2</c:v>
                </c:pt>
                <c:pt idx="144">
                  <c:v>6.54E-2</c:v>
                </c:pt>
                <c:pt idx="145">
                  <c:v>1.03E-2</c:v>
                </c:pt>
                <c:pt idx="146">
                  <c:v>2.06E-2</c:v>
                </c:pt>
                <c:pt idx="147">
                  <c:v>0.64139999999999997</c:v>
                </c:pt>
              </c:numCache>
            </c:numRef>
          </c:val>
        </c:ser>
        <c:dLbls>
          <c:showLegendKey val="0"/>
          <c:showVal val="0"/>
          <c:showCatName val="0"/>
          <c:showSerName val="0"/>
          <c:showPercent val="0"/>
          <c:showBubbleSize val="0"/>
        </c:dLbls>
        <c:gapWidth val="150"/>
        <c:axId val="302060832"/>
        <c:axId val="302053776"/>
      </c:barChart>
      <c:catAx>
        <c:axId val="302060832"/>
        <c:scaling>
          <c:orientation val="minMax"/>
        </c:scaling>
        <c:delete val="0"/>
        <c:axPos val="b"/>
        <c:title>
          <c:tx>
            <c:rich>
              <a:bodyPr rot="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r>
                  <a:rPr lang="en-US" sz="1400" b="1">
                    <a:solidFill>
                      <a:sysClr val="windowText" lastClr="000000"/>
                    </a:solidFill>
                  </a:rPr>
                  <a:t>EMBRYOGENESIS</a:t>
                </a:r>
                <a:r>
                  <a:rPr lang="en-US" sz="1400" b="1" baseline="0">
                    <a:solidFill>
                      <a:sysClr val="windowText" lastClr="000000"/>
                    </a:solidFill>
                  </a:rPr>
                  <a:t> STAGE</a:t>
                </a:r>
                <a:endParaRPr lang="en-US" sz="1400" b="1">
                  <a:solidFill>
                    <a:sysClr val="windowText" lastClr="000000"/>
                  </a:solidFill>
                </a:endParaRPr>
              </a:p>
            </c:rich>
          </c:tx>
          <c:overlay val="0"/>
          <c:spPr>
            <a:noFill/>
            <a:ln>
              <a:noFill/>
            </a:ln>
            <a:effectLst/>
          </c:spPr>
          <c:txPr>
            <a:bodyPr rot="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mn-lt"/>
                <a:ea typeface="+mn-ea"/>
                <a:cs typeface="+mn-cs"/>
              </a:defRPr>
            </a:pPr>
            <a:endParaRPr lang="en-US"/>
          </a:p>
        </c:txPr>
        <c:crossAx val="302053776"/>
        <c:crosses val="autoZero"/>
        <c:auto val="1"/>
        <c:lblAlgn val="ctr"/>
        <c:lblOffset val="100"/>
        <c:noMultiLvlLbl val="0"/>
      </c:catAx>
      <c:valAx>
        <c:axId val="302053776"/>
        <c:scaling>
          <c:orientation val="minMax"/>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r>
                  <a:rPr lang="en-US" sz="1400" b="1">
                    <a:solidFill>
                      <a:sysClr val="windowText" lastClr="000000"/>
                    </a:solidFill>
                  </a:rPr>
                  <a:t>HPAT4</a:t>
                </a:r>
                <a:r>
                  <a:rPr lang="en-US" sz="1400" b="1" baseline="0">
                    <a:solidFill>
                      <a:sysClr val="windowText" lastClr="000000"/>
                    </a:solidFill>
                  </a:rPr>
                  <a:t> EXPRESSION</a:t>
                </a:r>
                <a:endParaRPr lang="en-US" sz="1400" b="1">
                  <a:solidFill>
                    <a:sysClr val="windowText" lastClr="000000"/>
                  </a:solidFill>
                </a:endParaRPr>
              </a:p>
            </c:rich>
          </c:tx>
          <c:layout>
            <c:manualLayout>
              <c:xMode val="edge"/>
              <c:yMode val="edge"/>
              <c:x val="1.3192770500272627E-2"/>
              <c:y val="0.3005908626180811"/>
            </c:manualLayout>
          </c:layout>
          <c:overlay val="0"/>
          <c:spPr>
            <a:noFill/>
            <a:ln>
              <a:noFill/>
            </a:ln>
            <a:effectLst/>
          </c:spPr>
          <c:txPr>
            <a:bodyPr rot="-54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mn-lt"/>
                <a:ea typeface="+mn-ea"/>
                <a:cs typeface="+mn-cs"/>
              </a:defRPr>
            </a:pPr>
            <a:endParaRPr lang="en-US"/>
          </a:p>
        </c:txPr>
        <c:crossAx val="302060832"/>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lumMod val="65000"/>
                    <a:lumOff val="35000"/>
                  </a:sysClr>
                </a:solidFill>
                <a:latin typeface="+mn-lt"/>
                <a:ea typeface="+mn-ea"/>
                <a:cs typeface="+mn-cs"/>
              </a:defRPr>
            </a:pPr>
            <a:r>
              <a:rPr lang="en-US" sz="1800" b="1" i="0" baseline="0">
                <a:effectLst/>
              </a:rPr>
              <a:t>Single cell analysis of the HPAT1 expression in human embryos</a:t>
            </a:r>
            <a:endParaRPr lang="en-US">
              <a:effectLst/>
            </a:endParaRPr>
          </a:p>
        </c:rich>
      </c:tx>
      <c:overlay val="0"/>
      <c:spPr>
        <a:noFill/>
        <a:ln>
          <a:noFill/>
        </a:ln>
        <a:effectLst/>
      </c:spPr>
      <c:txPr>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lumMod val="65000"/>
                  <a:lumOff val="35000"/>
                </a:sysClr>
              </a:solidFill>
              <a:latin typeface="+mn-lt"/>
              <a:ea typeface="+mn-ea"/>
              <a:cs typeface="+mn-cs"/>
            </a:defRPr>
          </a:pPr>
          <a:endParaRPr lang="en-US"/>
        </a:p>
      </c:txPr>
    </c:title>
    <c:autoTitleDeleted val="0"/>
    <c:plotArea>
      <c:layout>
        <c:manualLayout>
          <c:layoutTarget val="inner"/>
          <c:xMode val="edge"/>
          <c:yMode val="edge"/>
          <c:x val="0.12196491253989575"/>
          <c:y val="7.7573933354640009E-2"/>
          <c:w val="0.86191059018199334"/>
          <c:h val="0.72320153408033883"/>
        </c:manualLayout>
      </c:layout>
      <c:barChart>
        <c:barDir val="col"/>
        <c:grouping val="clustered"/>
        <c:varyColors val="0"/>
        <c:ser>
          <c:idx val="0"/>
          <c:order val="0"/>
          <c:tx>
            <c:strRef>
              <c:f>Sheet5!$D$32</c:f>
              <c:strCache>
                <c:ptCount val="1"/>
                <c:pt idx="0">
                  <c:v>HPAT1</c:v>
                </c:pt>
              </c:strCache>
            </c:strRef>
          </c:tx>
          <c:spPr>
            <a:solidFill>
              <a:schemeClr val="accent1"/>
            </a:solidFill>
            <a:ln>
              <a:solidFill>
                <a:schemeClr val="accent1"/>
              </a:solidFill>
            </a:ln>
            <a:effectLst/>
          </c:spPr>
          <c:invertIfNegative val="0"/>
          <c:cat>
            <c:strRef>
              <c:f>Sheet5!$E$31:$EV$31</c:f>
              <c:strCache>
                <c:ptCount val="148"/>
                <c:pt idx="0">
                  <c:v>Oocyte</c:v>
                </c:pt>
                <c:pt idx="1">
                  <c:v>Oocyte</c:v>
                </c:pt>
                <c:pt idx="2">
                  <c:v>Oocyte</c:v>
                </c:pt>
                <c:pt idx="3">
                  <c:v>Oocyte</c:v>
                </c:pt>
                <c:pt idx="4">
                  <c:v>Oocyte</c:v>
                </c:pt>
                <c:pt idx="5">
                  <c:v>Oocyte</c:v>
                </c:pt>
                <c:pt idx="6">
                  <c:v>Pronuclei</c:v>
                </c:pt>
                <c:pt idx="7">
                  <c:v>Pronuclei</c:v>
                </c:pt>
                <c:pt idx="8">
                  <c:v>Pronuclei</c:v>
                </c:pt>
                <c:pt idx="9">
                  <c:v>Zygote</c:v>
                </c:pt>
                <c:pt idx="10">
                  <c:v>Zygote</c:v>
                </c:pt>
                <c:pt idx="11">
                  <c:v>Zygote</c:v>
                </c:pt>
                <c:pt idx="12">
                  <c:v>Zygote</c:v>
                </c:pt>
                <c:pt idx="13">
                  <c:v>Zygote</c:v>
                </c:pt>
                <c:pt idx="14">
                  <c:v>2-cell</c:v>
                </c:pt>
                <c:pt idx="15">
                  <c:v>2-cell</c:v>
                </c:pt>
                <c:pt idx="16">
                  <c:v>2-cell</c:v>
                </c:pt>
                <c:pt idx="17">
                  <c:v>2-cell</c:v>
                </c:pt>
                <c:pt idx="18">
                  <c:v>2-cell</c:v>
                </c:pt>
                <c:pt idx="19">
                  <c:v>2-cell</c:v>
                </c:pt>
                <c:pt idx="20">
                  <c:v>2-cell</c:v>
                </c:pt>
                <c:pt idx="21">
                  <c:v>2-cell</c:v>
                </c:pt>
                <c:pt idx="22">
                  <c:v>2-cell</c:v>
                </c:pt>
                <c:pt idx="23">
                  <c:v>4-cell</c:v>
                </c:pt>
                <c:pt idx="24">
                  <c:v>4-cell</c:v>
                </c:pt>
                <c:pt idx="25">
                  <c:v>4-cell</c:v>
                </c:pt>
                <c:pt idx="26">
                  <c:v>4-cell</c:v>
                </c:pt>
                <c:pt idx="27">
                  <c:v>4-cell</c:v>
                </c:pt>
                <c:pt idx="28">
                  <c:v>4-cell</c:v>
                </c:pt>
                <c:pt idx="29">
                  <c:v>4-cell</c:v>
                </c:pt>
                <c:pt idx="30">
                  <c:v>4-cell</c:v>
                </c:pt>
                <c:pt idx="31">
                  <c:v>4-cell</c:v>
                </c:pt>
                <c:pt idx="32">
                  <c:v>4-cell</c:v>
                </c:pt>
                <c:pt idx="33">
                  <c:v>4-cell</c:v>
                </c:pt>
                <c:pt idx="34">
                  <c:v>4-cell</c:v>
                </c:pt>
                <c:pt idx="35">
                  <c:v>4-cell</c:v>
                </c:pt>
                <c:pt idx="36">
                  <c:v>4-cell</c:v>
                </c:pt>
                <c:pt idx="37">
                  <c:v>4-cell</c:v>
                </c:pt>
                <c:pt idx="38">
                  <c:v>4-cell</c:v>
                </c:pt>
                <c:pt idx="39">
                  <c:v>8-cell</c:v>
                </c:pt>
                <c:pt idx="40">
                  <c:v>8-cell</c:v>
                </c:pt>
                <c:pt idx="41">
                  <c:v>8-cell</c:v>
                </c:pt>
                <c:pt idx="42">
                  <c:v>8-cell</c:v>
                </c:pt>
                <c:pt idx="43">
                  <c:v>8-cell</c:v>
                </c:pt>
                <c:pt idx="44">
                  <c:v>8-cell</c:v>
                </c:pt>
                <c:pt idx="45">
                  <c:v>8-cell</c:v>
                </c:pt>
                <c:pt idx="46">
                  <c:v>8-cell</c:v>
                </c:pt>
                <c:pt idx="47">
                  <c:v>8-cell</c:v>
                </c:pt>
                <c:pt idx="48">
                  <c:v>8-cell</c:v>
                </c:pt>
                <c:pt idx="49">
                  <c:v>8-cell</c:v>
                </c:pt>
                <c:pt idx="50">
                  <c:v>8-cell</c:v>
                </c:pt>
                <c:pt idx="51">
                  <c:v>8-cell</c:v>
                </c:pt>
                <c:pt idx="52">
                  <c:v>8-cell</c:v>
                </c:pt>
                <c:pt idx="53">
                  <c:v>8-cell</c:v>
                </c:pt>
                <c:pt idx="54">
                  <c:v>8-cell</c:v>
                </c:pt>
                <c:pt idx="55">
                  <c:v>8-cell</c:v>
                </c:pt>
                <c:pt idx="56">
                  <c:v>8-cell</c:v>
                </c:pt>
                <c:pt idx="57">
                  <c:v>8-cell</c:v>
                </c:pt>
                <c:pt idx="58">
                  <c:v>8-cell</c:v>
                </c:pt>
                <c:pt idx="59">
                  <c:v>8-cell</c:v>
                </c:pt>
                <c:pt idx="60">
                  <c:v>8-cell</c:v>
                </c:pt>
                <c:pt idx="61">
                  <c:v>8-cell</c:v>
                </c:pt>
                <c:pt idx="62">
                  <c:v>8-cell</c:v>
                </c:pt>
                <c:pt idx="63">
                  <c:v>8-cell</c:v>
                </c:pt>
                <c:pt idx="64">
                  <c:v>8-cell</c:v>
                </c:pt>
                <c:pt idx="65">
                  <c:v>Morulae</c:v>
                </c:pt>
                <c:pt idx="66">
                  <c:v>Morulae</c:v>
                </c:pt>
                <c:pt idx="67">
                  <c:v>Morulae</c:v>
                </c:pt>
                <c:pt idx="68">
                  <c:v>Morulae</c:v>
                </c:pt>
                <c:pt idx="69">
                  <c:v>Morulae</c:v>
                </c:pt>
                <c:pt idx="70">
                  <c:v>Morulae</c:v>
                </c:pt>
                <c:pt idx="71">
                  <c:v>Morulae</c:v>
                </c:pt>
                <c:pt idx="72">
                  <c:v>Morulae</c:v>
                </c:pt>
                <c:pt idx="73">
                  <c:v>Morulae</c:v>
                </c:pt>
                <c:pt idx="74">
                  <c:v>Morulae</c:v>
                </c:pt>
                <c:pt idx="75">
                  <c:v>Morulae</c:v>
                </c:pt>
                <c:pt idx="76">
                  <c:v>Morulae</c:v>
                </c:pt>
                <c:pt idx="77">
                  <c:v>Morulae</c:v>
                </c:pt>
                <c:pt idx="78">
                  <c:v>Morulae</c:v>
                </c:pt>
                <c:pt idx="79">
                  <c:v>Morulae</c:v>
                </c:pt>
                <c:pt idx="80">
                  <c:v>Morulae</c:v>
                </c:pt>
                <c:pt idx="81">
                  <c:v>Morulae</c:v>
                </c:pt>
                <c:pt idx="82">
                  <c:v>Morulae</c:v>
                </c:pt>
                <c:pt idx="83">
                  <c:v>Morulae</c:v>
                </c:pt>
                <c:pt idx="84">
                  <c:v>Late_blastocyst</c:v>
                </c:pt>
                <c:pt idx="85">
                  <c:v>Late_blastocyst</c:v>
                </c:pt>
                <c:pt idx="86">
                  <c:v>Late_blastocyst</c:v>
                </c:pt>
                <c:pt idx="87">
                  <c:v>Late_blastocyst</c:v>
                </c:pt>
                <c:pt idx="88">
                  <c:v>Late_blastocyst</c:v>
                </c:pt>
                <c:pt idx="89">
                  <c:v>Late_blastocyst</c:v>
                </c:pt>
                <c:pt idx="90">
                  <c:v>Late_blastocyst</c:v>
                </c:pt>
                <c:pt idx="91">
                  <c:v>Late_blastocyst</c:v>
                </c:pt>
                <c:pt idx="92">
                  <c:v>Late_blastocyst</c:v>
                </c:pt>
                <c:pt idx="93">
                  <c:v>Late_blastocyst</c:v>
                </c:pt>
                <c:pt idx="94">
                  <c:v>Late_blastocyst</c:v>
                </c:pt>
                <c:pt idx="95">
                  <c:v>Late_blastocyst</c:v>
                </c:pt>
                <c:pt idx="96">
                  <c:v>Late_blastocyst</c:v>
                </c:pt>
                <c:pt idx="97">
                  <c:v>Late_blastocyst</c:v>
                </c:pt>
                <c:pt idx="98">
                  <c:v>Late_blastocyst</c:v>
                </c:pt>
                <c:pt idx="99">
                  <c:v>Late_blastocyst</c:v>
                </c:pt>
                <c:pt idx="100">
                  <c:v>Late_blastocyst</c:v>
                </c:pt>
                <c:pt idx="101">
                  <c:v>Late_blastocyst</c:v>
                </c:pt>
                <c:pt idx="102">
                  <c:v>Late_blastocyst</c:v>
                </c:pt>
                <c:pt idx="103">
                  <c:v>Late_blastocyst</c:v>
                </c:pt>
                <c:pt idx="104">
                  <c:v>Late_blastocyst</c:v>
                </c:pt>
                <c:pt idx="105">
                  <c:v>Late_blastocyst</c:v>
                </c:pt>
                <c:pt idx="106">
                  <c:v>Late_blastocyst</c:v>
                </c:pt>
                <c:pt idx="107">
                  <c:v>Late_blastocyst</c:v>
                </c:pt>
                <c:pt idx="108">
                  <c:v>Late_blastocyst</c:v>
                </c:pt>
                <c:pt idx="109">
                  <c:v>Late_blastocyst</c:v>
                </c:pt>
                <c:pt idx="110">
                  <c:v>Late_blastocyst</c:v>
                </c:pt>
                <c:pt idx="111">
                  <c:v>Late_blastocyst</c:v>
                </c:pt>
                <c:pt idx="112">
                  <c:v>Late_blastocyst</c:v>
                </c:pt>
                <c:pt idx="113">
                  <c:v>Late_blastocyst</c:v>
                </c:pt>
                <c:pt idx="114">
                  <c:v>hESC_P0</c:v>
                </c:pt>
                <c:pt idx="115">
                  <c:v>hESC_P0</c:v>
                </c:pt>
                <c:pt idx="116">
                  <c:v>hESC_P0</c:v>
                </c:pt>
                <c:pt idx="117">
                  <c:v>hESC_P0</c:v>
                </c:pt>
                <c:pt idx="118">
                  <c:v>hESC_P0</c:v>
                </c:pt>
                <c:pt idx="119">
                  <c:v>hESC_P0</c:v>
                </c:pt>
                <c:pt idx="120">
                  <c:v>hESC_P0</c:v>
                </c:pt>
                <c:pt idx="121">
                  <c:v>hESC_P0</c:v>
                </c:pt>
                <c:pt idx="122">
                  <c:v>hESC_P10</c:v>
                </c:pt>
                <c:pt idx="123">
                  <c:v>hESC_P10</c:v>
                </c:pt>
                <c:pt idx="124">
                  <c:v>hESC_P10</c:v>
                </c:pt>
                <c:pt idx="125">
                  <c:v>hESC_P10</c:v>
                </c:pt>
                <c:pt idx="126">
                  <c:v>hESC_P10</c:v>
                </c:pt>
                <c:pt idx="127">
                  <c:v>hESC_P10</c:v>
                </c:pt>
                <c:pt idx="128">
                  <c:v>hESC_P10</c:v>
                </c:pt>
                <c:pt idx="129">
                  <c:v>hESC_P10</c:v>
                </c:pt>
                <c:pt idx="130">
                  <c:v>hESC_P10</c:v>
                </c:pt>
                <c:pt idx="131">
                  <c:v>hESC_P10</c:v>
                </c:pt>
                <c:pt idx="132">
                  <c:v>hESC_P10</c:v>
                </c:pt>
                <c:pt idx="133">
                  <c:v>hESC_P10</c:v>
                </c:pt>
                <c:pt idx="134">
                  <c:v>hESC_P10</c:v>
                </c:pt>
                <c:pt idx="135">
                  <c:v>hESC_P10</c:v>
                </c:pt>
                <c:pt idx="136">
                  <c:v>hESC_P10</c:v>
                </c:pt>
                <c:pt idx="137">
                  <c:v>hESC_P10</c:v>
                </c:pt>
                <c:pt idx="138">
                  <c:v>hESC_P10</c:v>
                </c:pt>
                <c:pt idx="139">
                  <c:v>hESC_P10</c:v>
                </c:pt>
                <c:pt idx="140">
                  <c:v>hESC_P10</c:v>
                </c:pt>
                <c:pt idx="141">
                  <c:v>hESC_P10</c:v>
                </c:pt>
                <c:pt idx="142">
                  <c:v>hESC_P10</c:v>
                </c:pt>
                <c:pt idx="143">
                  <c:v>hESC_P10</c:v>
                </c:pt>
                <c:pt idx="144">
                  <c:v>hESC_P10</c:v>
                </c:pt>
                <c:pt idx="145">
                  <c:v>hESC_P10</c:v>
                </c:pt>
                <c:pt idx="146">
                  <c:v>hESC_P10</c:v>
                </c:pt>
                <c:pt idx="147">
                  <c:v>hESC_P10</c:v>
                </c:pt>
              </c:strCache>
            </c:strRef>
          </c:cat>
          <c:val>
            <c:numRef>
              <c:f>Sheet5!$E$32:$EV$32</c:f>
              <c:numCache>
                <c:formatCode>General</c:formatCode>
                <c:ptCount val="148"/>
                <c:pt idx="0">
                  <c:v>0.15659999999999999</c:v>
                </c:pt>
                <c:pt idx="1">
                  <c:v>0.1797</c:v>
                </c:pt>
                <c:pt idx="2">
                  <c:v>0.16009999999999999</c:v>
                </c:pt>
                <c:pt idx="3">
                  <c:v>0</c:v>
                </c:pt>
                <c:pt idx="4">
                  <c:v>0.28149999999999997</c:v>
                </c:pt>
                <c:pt idx="5">
                  <c:v>2.8000000000000001E-2</c:v>
                </c:pt>
                <c:pt idx="6">
                  <c:v>6.6600000000000006E-2</c:v>
                </c:pt>
                <c:pt idx="7">
                  <c:v>3.2899999999999999E-2</c:v>
                </c:pt>
                <c:pt idx="8">
                  <c:v>7.5800000000000006E-2</c:v>
                </c:pt>
                <c:pt idx="9">
                  <c:v>0.1802</c:v>
                </c:pt>
                <c:pt idx="10">
                  <c:v>0.1678</c:v>
                </c:pt>
                <c:pt idx="11">
                  <c:v>0.21229999999999999</c:v>
                </c:pt>
                <c:pt idx="12">
                  <c:v>7.4000000000000003E-3</c:v>
                </c:pt>
                <c:pt idx="13">
                  <c:v>0.15490000000000001</c:v>
                </c:pt>
                <c:pt idx="14">
                  <c:v>0.22020000000000001</c:v>
                </c:pt>
                <c:pt idx="15">
                  <c:v>0.16089999999999999</c:v>
                </c:pt>
                <c:pt idx="16">
                  <c:v>0.20619999999999999</c:v>
                </c:pt>
                <c:pt idx="17">
                  <c:v>0.24390000000000001</c:v>
                </c:pt>
                <c:pt idx="18">
                  <c:v>0.1095</c:v>
                </c:pt>
                <c:pt idx="19">
                  <c:v>9.9199999999999997E-2</c:v>
                </c:pt>
                <c:pt idx="20">
                  <c:v>1.5900000000000001E-2</c:v>
                </c:pt>
                <c:pt idx="21">
                  <c:v>0.20349999999999999</c:v>
                </c:pt>
                <c:pt idx="22">
                  <c:v>0.2266</c:v>
                </c:pt>
                <c:pt idx="23">
                  <c:v>0.94879999999999998</c:v>
                </c:pt>
                <c:pt idx="24">
                  <c:v>0.44879999999999998</c:v>
                </c:pt>
                <c:pt idx="25">
                  <c:v>3.8E-3</c:v>
                </c:pt>
                <c:pt idx="26">
                  <c:v>0</c:v>
                </c:pt>
                <c:pt idx="27">
                  <c:v>0.1012</c:v>
                </c:pt>
                <c:pt idx="28">
                  <c:v>0.34279999999999999</c:v>
                </c:pt>
                <c:pt idx="29">
                  <c:v>6.9699999999999998E-2</c:v>
                </c:pt>
                <c:pt idx="30">
                  <c:v>8.2100000000000006E-2</c:v>
                </c:pt>
                <c:pt idx="31">
                  <c:v>0.33979999999999999</c:v>
                </c:pt>
                <c:pt idx="32">
                  <c:v>7.7600000000000002E-2</c:v>
                </c:pt>
                <c:pt idx="33">
                  <c:v>1.83E-2</c:v>
                </c:pt>
                <c:pt idx="34">
                  <c:v>3.9699999999999999E-2</c:v>
                </c:pt>
                <c:pt idx="35">
                  <c:v>0.1043</c:v>
                </c:pt>
                <c:pt idx="36">
                  <c:v>4.3E-3</c:v>
                </c:pt>
                <c:pt idx="37">
                  <c:v>0</c:v>
                </c:pt>
                <c:pt idx="38">
                  <c:v>7.3000000000000001E-3</c:v>
                </c:pt>
                <c:pt idx="39">
                  <c:v>5.5999999999999999E-3</c:v>
                </c:pt>
                <c:pt idx="40">
                  <c:v>0</c:v>
                </c:pt>
                <c:pt idx="41">
                  <c:v>3.2099999999999997E-2</c:v>
                </c:pt>
                <c:pt idx="42">
                  <c:v>2.58E-2</c:v>
                </c:pt>
                <c:pt idx="43">
                  <c:v>1.0999999999999999E-2</c:v>
                </c:pt>
                <c:pt idx="44">
                  <c:v>1.89E-2</c:v>
                </c:pt>
                <c:pt idx="45">
                  <c:v>0.1449</c:v>
                </c:pt>
                <c:pt idx="46">
                  <c:v>3.6499999999999998E-2</c:v>
                </c:pt>
                <c:pt idx="47">
                  <c:v>0.2802</c:v>
                </c:pt>
                <c:pt idx="48">
                  <c:v>3.5999999999999997E-2</c:v>
                </c:pt>
                <c:pt idx="49">
                  <c:v>0.35799999999999998</c:v>
                </c:pt>
                <c:pt idx="50">
                  <c:v>1.4800000000000001E-2</c:v>
                </c:pt>
                <c:pt idx="51">
                  <c:v>0.5222</c:v>
                </c:pt>
                <c:pt idx="52">
                  <c:v>0</c:v>
                </c:pt>
                <c:pt idx="53">
                  <c:v>0</c:v>
                </c:pt>
                <c:pt idx="54">
                  <c:v>0.34870000000000001</c:v>
                </c:pt>
                <c:pt idx="55">
                  <c:v>0</c:v>
                </c:pt>
                <c:pt idx="56">
                  <c:v>0</c:v>
                </c:pt>
                <c:pt idx="57">
                  <c:v>4.1000000000000003E-3</c:v>
                </c:pt>
                <c:pt idx="58">
                  <c:v>0</c:v>
                </c:pt>
                <c:pt idx="59">
                  <c:v>0</c:v>
                </c:pt>
                <c:pt idx="60">
                  <c:v>2.3800000000000002E-2</c:v>
                </c:pt>
                <c:pt idx="61">
                  <c:v>8.3999999999999995E-3</c:v>
                </c:pt>
                <c:pt idx="62">
                  <c:v>0</c:v>
                </c:pt>
                <c:pt idx="63">
                  <c:v>4.1000000000000003E-3</c:v>
                </c:pt>
                <c:pt idx="64">
                  <c:v>0</c:v>
                </c:pt>
                <c:pt idx="65">
                  <c:v>1.2E-2</c:v>
                </c:pt>
                <c:pt idx="66">
                  <c:v>1.24E-2</c:v>
                </c:pt>
                <c:pt idx="67">
                  <c:v>0</c:v>
                </c:pt>
                <c:pt idx="68">
                  <c:v>4.5999999999999999E-3</c:v>
                </c:pt>
                <c:pt idx="69">
                  <c:v>5.1999999999999998E-3</c:v>
                </c:pt>
                <c:pt idx="70">
                  <c:v>0</c:v>
                </c:pt>
                <c:pt idx="71">
                  <c:v>0</c:v>
                </c:pt>
                <c:pt idx="72">
                  <c:v>0</c:v>
                </c:pt>
                <c:pt idx="73">
                  <c:v>0</c:v>
                </c:pt>
                <c:pt idx="74">
                  <c:v>0</c:v>
                </c:pt>
                <c:pt idx="75">
                  <c:v>0</c:v>
                </c:pt>
                <c:pt idx="76">
                  <c:v>0</c:v>
                </c:pt>
                <c:pt idx="77">
                  <c:v>0</c:v>
                </c:pt>
                <c:pt idx="78">
                  <c:v>4.8999999999999998E-3</c:v>
                </c:pt>
                <c:pt idx="79">
                  <c:v>0</c:v>
                </c:pt>
                <c:pt idx="80">
                  <c:v>0</c:v>
                </c:pt>
                <c:pt idx="81">
                  <c:v>0</c:v>
                </c:pt>
                <c:pt idx="82">
                  <c:v>2.7199999999999998E-2</c:v>
                </c:pt>
                <c:pt idx="83">
                  <c:v>0.34339999999999998</c:v>
                </c:pt>
                <c:pt idx="84">
                  <c:v>7.9000000000000008E-3</c:v>
                </c:pt>
                <c:pt idx="85">
                  <c:v>8.3000000000000001E-3</c:v>
                </c:pt>
                <c:pt idx="86">
                  <c:v>5.3E-3</c:v>
                </c:pt>
                <c:pt idx="87">
                  <c:v>4.7999999999999996E-3</c:v>
                </c:pt>
                <c:pt idx="88">
                  <c:v>5.3E-3</c:v>
                </c:pt>
                <c:pt idx="89">
                  <c:v>7.4000000000000003E-3</c:v>
                </c:pt>
                <c:pt idx="90">
                  <c:v>1.09E-2</c:v>
                </c:pt>
                <c:pt idx="91">
                  <c:v>1.89E-2</c:v>
                </c:pt>
                <c:pt idx="92">
                  <c:v>2.6499999999999999E-2</c:v>
                </c:pt>
                <c:pt idx="93">
                  <c:v>1.3299999999999999E-2</c:v>
                </c:pt>
                <c:pt idx="94">
                  <c:v>9.9000000000000008E-3</c:v>
                </c:pt>
                <c:pt idx="95">
                  <c:v>8.0999999999999996E-3</c:v>
                </c:pt>
                <c:pt idx="96">
                  <c:v>0.03</c:v>
                </c:pt>
                <c:pt idx="97">
                  <c:v>0.15590000000000001</c:v>
                </c:pt>
                <c:pt idx="98">
                  <c:v>0.87819999999999998</c:v>
                </c:pt>
                <c:pt idx="99">
                  <c:v>7.0000000000000001E-3</c:v>
                </c:pt>
                <c:pt idx="100">
                  <c:v>0</c:v>
                </c:pt>
                <c:pt idx="101">
                  <c:v>1.2800000000000001E-2</c:v>
                </c:pt>
                <c:pt idx="102">
                  <c:v>0</c:v>
                </c:pt>
                <c:pt idx="103">
                  <c:v>0</c:v>
                </c:pt>
                <c:pt idx="104">
                  <c:v>1.0500000000000001E-2</c:v>
                </c:pt>
                <c:pt idx="105">
                  <c:v>1.0200000000000001E-2</c:v>
                </c:pt>
                <c:pt idx="106">
                  <c:v>3.6299999999999999E-2</c:v>
                </c:pt>
                <c:pt idx="107">
                  <c:v>0</c:v>
                </c:pt>
                <c:pt idx="108">
                  <c:v>0</c:v>
                </c:pt>
                <c:pt idx="109">
                  <c:v>0.61109999999999998</c:v>
                </c:pt>
                <c:pt idx="110">
                  <c:v>8.09E-2</c:v>
                </c:pt>
                <c:pt idx="111">
                  <c:v>0</c:v>
                </c:pt>
                <c:pt idx="112">
                  <c:v>0</c:v>
                </c:pt>
                <c:pt idx="113">
                  <c:v>3.7000000000000002E-3</c:v>
                </c:pt>
                <c:pt idx="114">
                  <c:v>0.28520000000000001</c:v>
                </c:pt>
                <c:pt idx="115">
                  <c:v>0.42459999999999998</c:v>
                </c:pt>
                <c:pt idx="116">
                  <c:v>0.54059999999999997</c:v>
                </c:pt>
                <c:pt idx="117">
                  <c:v>0.55349999999999999</c:v>
                </c:pt>
                <c:pt idx="118">
                  <c:v>0.10929999999999999</c:v>
                </c:pt>
                <c:pt idx="119">
                  <c:v>0.41860000000000003</c:v>
                </c:pt>
                <c:pt idx="120">
                  <c:v>0.38900000000000001</c:v>
                </c:pt>
                <c:pt idx="121">
                  <c:v>0.41120000000000001</c:v>
                </c:pt>
                <c:pt idx="122">
                  <c:v>2.9600000000000001E-2</c:v>
                </c:pt>
                <c:pt idx="123">
                  <c:v>3.7999999999999999E-2</c:v>
                </c:pt>
                <c:pt idx="124">
                  <c:v>5.62E-2</c:v>
                </c:pt>
                <c:pt idx="125">
                  <c:v>5.1000000000000004E-3</c:v>
                </c:pt>
                <c:pt idx="126">
                  <c:v>0.62150000000000005</c:v>
                </c:pt>
                <c:pt idx="127">
                  <c:v>3.2300000000000002E-2</c:v>
                </c:pt>
                <c:pt idx="128">
                  <c:v>6.4000000000000003E-3</c:v>
                </c:pt>
                <c:pt idx="129">
                  <c:v>0.1358</c:v>
                </c:pt>
                <c:pt idx="130">
                  <c:v>1.6500000000000001E-2</c:v>
                </c:pt>
                <c:pt idx="131">
                  <c:v>1.7504</c:v>
                </c:pt>
                <c:pt idx="132">
                  <c:v>2.75E-2</c:v>
                </c:pt>
                <c:pt idx="133">
                  <c:v>0.95509999999999995</c:v>
                </c:pt>
                <c:pt idx="134">
                  <c:v>5.7099999999999998E-2</c:v>
                </c:pt>
                <c:pt idx="135">
                  <c:v>0.1978</c:v>
                </c:pt>
                <c:pt idx="136">
                  <c:v>3.5528</c:v>
                </c:pt>
                <c:pt idx="137">
                  <c:v>0.72219999999999995</c:v>
                </c:pt>
                <c:pt idx="138">
                  <c:v>0.24510000000000001</c:v>
                </c:pt>
                <c:pt idx="139">
                  <c:v>3.3898999999999999</c:v>
                </c:pt>
                <c:pt idx="140">
                  <c:v>1.8035000000000001</c:v>
                </c:pt>
                <c:pt idx="141">
                  <c:v>0.82489999999999997</c:v>
                </c:pt>
                <c:pt idx="142">
                  <c:v>0.37069999999999997</c:v>
                </c:pt>
                <c:pt idx="143">
                  <c:v>1.32E-2</c:v>
                </c:pt>
                <c:pt idx="144">
                  <c:v>7.1900000000000006E-2</c:v>
                </c:pt>
                <c:pt idx="145">
                  <c:v>0.22639999999999999</c:v>
                </c:pt>
                <c:pt idx="146">
                  <c:v>0.67330000000000001</c:v>
                </c:pt>
                <c:pt idx="147">
                  <c:v>6.6000000000000003E-2</c:v>
                </c:pt>
              </c:numCache>
            </c:numRef>
          </c:val>
        </c:ser>
        <c:dLbls>
          <c:showLegendKey val="0"/>
          <c:showVal val="0"/>
          <c:showCatName val="0"/>
          <c:showSerName val="0"/>
          <c:showPercent val="0"/>
          <c:showBubbleSize val="0"/>
        </c:dLbls>
        <c:gapWidth val="150"/>
        <c:axId val="302058480"/>
        <c:axId val="302054952"/>
      </c:barChart>
      <c:catAx>
        <c:axId val="302058480"/>
        <c:scaling>
          <c:orientation val="minMax"/>
        </c:scaling>
        <c:delete val="0"/>
        <c:axPos val="b"/>
        <c:title>
          <c:tx>
            <c:rich>
              <a:bodyPr rot="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r>
                  <a:rPr lang="en-US" sz="1400" b="1">
                    <a:solidFill>
                      <a:sysClr val="windowText" lastClr="000000"/>
                    </a:solidFill>
                  </a:rPr>
                  <a:t>EMBRYOGENESIS</a:t>
                </a:r>
                <a:r>
                  <a:rPr lang="en-US" sz="1400" b="1" baseline="0">
                    <a:solidFill>
                      <a:sysClr val="windowText" lastClr="000000"/>
                    </a:solidFill>
                  </a:rPr>
                  <a:t> STAGE</a:t>
                </a:r>
                <a:endParaRPr lang="en-US" sz="1400" b="1">
                  <a:solidFill>
                    <a:sysClr val="windowText" lastClr="000000"/>
                  </a:solidFill>
                </a:endParaRPr>
              </a:p>
            </c:rich>
          </c:tx>
          <c:overlay val="0"/>
          <c:spPr>
            <a:noFill/>
            <a:ln>
              <a:noFill/>
            </a:ln>
            <a:effectLst/>
          </c:spPr>
          <c:txPr>
            <a:bodyPr rot="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mn-lt"/>
                <a:ea typeface="+mn-ea"/>
                <a:cs typeface="+mn-cs"/>
              </a:defRPr>
            </a:pPr>
            <a:endParaRPr lang="en-US"/>
          </a:p>
        </c:txPr>
        <c:crossAx val="302054952"/>
        <c:crosses val="autoZero"/>
        <c:auto val="1"/>
        <c:lblAlgn val="ctr"/>
        <c:lblOffset val="100"/>
        <c:noMultiLvlLbl val="0"/>
      </c:catAx>
      <c:valAx>
        <c:axId val="302054952"/>
        <c:scaling>
          <c:orientation val="minMax"/>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r>
                  <a:rPr lang="en-US" sz="1400" b="1">
                    <a:solidFill>
                      <a:sysClr val="windowText" lastClr="000000"/>
                    </a:solidFill>
                  </a:rPr>
                  <a:t>HPAT1</a:t>
                </a:r>
                <a:r>
                  <a:rPr lang="en-US" sz="1400" b="1" baseline="0">
                    <a:solidFill>
                      <a:sysClr val="windowText" lastClr="000000"/>
                    </a:solidFill>
                  </a:rPr>
                  <a:t> EXPRESSION</a:t>
                </a:r>
                <a:endParaRPr lang="en-US" sz="1400" b="1">
                  <a:solidFill>
                    <a:sysClr val="windowText" lastClr="000000"/>
                  </a:solidFill>
                </a:endParaRPr>
              </a:p>
            </c:rich>
          </c:tx>
          <c:layout>
            <c:manualLayout>
              <c:xMode val="edge"/>
              <c:yMode val="edge"/>
              <c:x val="3.2248994556221981E-2"/>
              <c:y val="0.31763922081184781"/>
            </c:manualLayout>
          </c:layout>
          <c:overlay val="0"/>
          <c:spPr>
            <a:noFill/>
            <a:ln>
              <a:noFill/>
            </a:ln>
            <a:effectLst/>
          </c:spPr>
          <c:txPr>
            <a:bodyPr rot="-54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mn-lt"/>
                <a:ea typeface="+mn-ea"/>
                <a:cs typeface="+mn-cs"/>
              </a:defRPr>
            </a:pPr>
            <a:endParaRPr lang="en-US"/>
          </a:p>
        </c:txPr>
        <c:crossAx val="302058480"/>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7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ln w="9525" cap="flat" cmpd="sng" algn="ctr">
        <a:solidFill>
          <a:schemeClr val="tx1">
            <a:lumMod val="15000"/>
            <a:lumOff val="85000"/>
          </a:schemeClr>
        </a:solidFill>
        <a:round/>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7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ln w="9525" cap="flat" cmpd="sng" algn="ctr">
        <a:solidFill>
          <a:schemeClr val="tx1">
            <a:lumMod val="15000"/>
            <a:lumOff val="85000"/>
          </a:schemeClr>
        </a:solidFill>
        <a:round/>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7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ln w="9525" cap="flat" cmpd="sng" algn="ctr">
        <a:solidFill>
          <a:schemeClr val="tx1">
            <a:lumMod val="15000"/>
            <a:lumOff val="85000"/>
          </a:schemeClr>
        </a:solidFill>
        <a:round/>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7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ln w="9525" cap="flat" cmpd="sng" algn="ctr">
        <a:solidFill>
          <a:schemeClr val="tx1">
            <a:lumMod val="15000"/>
            <a:lumOff val="85000"/>
          </a:schemeClr>
        </a:solidFill>
        <a:round/>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7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ln w="9525" cap="flat" cmpd="sng" algn="ctr">
        <a:solidFill>
          <a:schemeClr val="tx1">
            <a:lumMod val="15000"/>
            <a:lumOff val="85000"/>
          </a:schemeClr>
        </a:solidFill>
        <a:round/>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7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ln w="9525" cap="flat" cmpd="sng" algn="ctr">
        <a:solidFill>
          <a:schemeClr val="tx1">
            <a:lumMod val="15000"/>
            <a:lumOff val="85000"/>
          </a:schemeClr>
        </a:solidFill>
        <a:round/>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 = '1.0' encoding = 'UTF-8' standalone = 'yes'?>
<Relationships xmlns="http://schemas.openxmlformats.org/package/2006/relationships">
   <Relationship Id="rId1" Type="http://schemas.openxmlformats.org/officeDocument/2006/relationships/theme" Target="../theme/theme2.xml"/>
</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BBA0860-CD0F-4111-A88D-97823E48FAA2}" type="datetimeFigureOut">
              <a:rPr lang="en-US" smtClean="0"/>
              <a:t>5/31/2018</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426E606-3D27-4AB1-8873-A0DD79BBB60F}" type="slidenum">
              <a:rPr lang="en-US" smtClean="0"/>
              <a:t>‹#›</a:t>
            </a:fld>
            <a:endParaRPr lang="en-US"/>
          </a:p>
        </p:txBody>
      </p:sp>
    </p:spTree>
    <p:extLst>
      <p:ext uri="{BB962C8B-B14F-4D97-AF65-F5344CB8AC3E}">
        <p14:creationId xmlns:p14="http://schemas.microsoft.com/office/powerpoint/2010/main" val="182111973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10.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11.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2.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3.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4.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5.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6.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7.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8.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9.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5/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42538569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5/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41358049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5/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33635840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5/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72681281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865C0C0-B12A-4BA8-8A83-1D012D019158}" type="datetimeFigureOut">
              <a:rPr lang="en-US" smtClean="0"/>
              <a:t>5/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2939024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8865C0C0-B12A-4BA8-8A83-1D012D019158}" type="datetimeFigureOut">
              <a:rPr lang="en-US" smtClean="0"/>
              <a:t>5/3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32548812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8865C0C0-B12A-4BA8-8A83-1D012D019158}" type="datetimeFigureOut">
              <a:rPr lang="en-US" smtClean="0"/>
              <a:t>5/31/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17106517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8865C0C0-B12A-4BA8-8A83-1D012D019158}" type="datetimeFigureOut">
              <a:rPr lang="en-US" smtClean="0"/>
              <a:t>5/31/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10012374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865C0C0-B12A-4BA8-8A83-1D012D019158}" type="datetimeFigureOut">
              <a:rPr lang="en-US" smtClean="0"/>
              <a:t>5/31/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5334664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865C0C0-B12A-4BA8-8A83-1D012D019158}" type="datetimeFigureOut">
              <a:rPr lang="en-US" smtClean="0"/>
              <a:t>5/3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8526337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865C0C0-B12A-4BA8-8A83-1D012D019158}" type="datetimeFigureOut">
              <a:rPr lang="en-US" smtClean="0"/>
              <a:t>5/3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1379744470"/>
      </p:ext>
    </p:extLst>
  </p:cSld>
  <p:clrMapOvr>
    <a:masterClrMapping/>
  </p:clrMapOvr>
</p:sldLayout>
</file>

<file path=ppt/slideMasters/_rels/slideMaster1.xml.rels><?xml version = '1.0' encoding = 'UTF-8' standalone = 'yes'?>
<Relationships xmlns="http://schemas.openxmlformats.org/package/2006/relationships">
   <Relationship Id="rId1" Type="http://schemas.openxmlformats.org/officeDocument/2006/relationships/slideLayout" Target="../slideLayouts/slideLayout1.xml"/>
   <Relationship Id="rId10" Type="http://schemas.openxmlformats.org/officeDocument/2006/relationships/slideLayout" Target="../slideLayouts/slideLayout10.xml"/>
   <Relationship Id="rId11" Type="http://schemas.openxmlformats.org/officeDocument/2006/relationships/slideLayout" Target="../slideLayouts/slideLayout11.xml"/>
   <Relationship Id="rId12" Type="http://schemas.openxmlformats.org/officeDocument/2006/relationships/theme" Target="../theme/theme1.xml"/>
   <Relationship Id="rId2" Type="http://schemas.openxmlformats.org/officeDocument/2006/relationships/slideLayout" Target="../slideLayouts/slideLayout2.xml"/>
   <Relationship Id="rId3" Type="http://schemas.openxmlformats.org/officeDocument/2006/relationships/slideLayout" Target="../slideLayouts/slideLayout3.xml"/>
   <Relationship Id="rId4" Type="http://schemas.openxmlformats.org/officeDocument/2006/relationships/slideLayout" Target="../slideLayouts/slideLayout4.xml"/>
   <Relationship Id="rId5" Type="http://schemas.openxmlformats.org/officeDocument/2006/relationships/slideLayout" Target="../slideLayouts/slideLayout5.xml"/>
   <Relationship Id="rId6" Type="http://schemas.openxmlformats.org/officeDocument/2006/relationships/slideLayout" Target="../slideLayouts/slideLayout6.xml"/>
   <Relationship Id="rId7" Type="http://schemas.openxmlformats.org/officeDocument/2006/relationships/slideLayout" Target="../slideLayouts/slideLayout7.xml"/>
   <Relationship Id="rId8" Type="http://schemas.openxmlformats.org/officeDocument/2006/relationships/slideLayout" Target="../slideLayouts/slideLayout8.xml"/>
   <Relationship Id="rId9" Type="http://schemas.openxmlformats.org/officeDocument/2006/relationships/slideLayout" Target="../slideLayouts/slideLayout9.xml"/>
</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865C0C0-B12A-4BA8-8A83-1D012D019158}" type="datetimeFigureOut">
              <a:rPr lang="en-US" smtClean="0"/>
              <a:t>5/31/2018</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BCB4C7F-67AB-4CD2-85B5-72AB5B0D54BD}" type="slidenum">
              <a:rPr lang="en-US" smtClean="0"/>
              <a:t>‹#›</a:t>
            </a:fld>
            <a:endParaRPr lang="en-US"/>
          </a:p>
        </p:txBody>
      </p:sp>
    </p:spTree>
    <p:extLst>
      <p:ext uri="{BB962C8B-B14F-4D97-AF65-F5344CB8AC3E}">
        <p14:creationId xmlns:p14="http://schemas.microsoft.com/office/powerpoint/2010/main" val="19808446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 = '1.0' encoding = 'UTF-8' standalone = 'yes'?>
<Relationships xmlns="http://schemas.openxmlformats.org/package/2006/relationships">
   <Relationship Id="rId1" Type="http://schemas.openxmlformats.org/officeDocument/2006/relationships/slideLayout" Target="../slideLayouts/slideLayout7.xml"/>
</Relationships>
</file>

<file path=ppt/slides/_rels/slide10.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9.xml"/>
</Relationships>
</file>

<file path=ppt/slides/_rels/slide11.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10.xml"/>
</Relationships>
</file>

<file path=ppt/slides/_rels/slide2.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1.xml"/>
</Relationships>
</file>

<file path=ppt/slides/_rels/slide3.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2.xml"/>
</Relationships>
</file>

<file path=ppt/slides/_rels/slide4.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3.xml"/>
</Relationships>
</file>

<file path=ppt/slides/_rels/slide5.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4.xml"/>
</Relationships>
</file>

<file path=ppt/slides/_rels/slide6.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5.xml"/>
</Relationships>
</file>

<file path=ppt/slides/_rels/slide7.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6.xml"/>
</Relationships>
</file>

<file path=ppt/slides/_rels/slide8.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7.xml"/>
</Relationships>
</file>

<file path=ppt/slides/_rels/slide9.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8.xml"/>
</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504968" y="2246607"/>
            <a:ext cx="11286698" cy="1697901"/>
          </a:xfrm>
          <a:prstGeom prst="rect">
            <a:avLst/>
          </a:prstGeom>
        </p:spPr>
        <p:txBody>
          <a:bodyPr wrap="square">
            <a:spAutoFit/>
          </a:bodyPr>
          <a:lstStyle/>
          <a:p>
            <a:pPr algn="ctr">
              <a:spcAft>
                <a:spcPts val="1000"/>
              </a:spcAft>
            </a:pPr>
            <a:r>
              <a:rPr lang="en-US" sz="1600" b="1" dirty="0">
                <a:latin typeface="Arial" panose="020B0604020202020204" pitchFamily="34" charset="0"/>
                <a:ea typeface="Calibri" panose="020F0502020204030204" pitchFamily="34" charset="0"/>
                <a:cs typeface="Arial" panose="020B0604020202020204" pitchFamily="34" charset="0"/>
              </a:rPr>
              <a:t>Supplemental Figure S2.2.</a:t>
            </a:r>
            <a:r>
              <a:rPr lang="en-US" sz="1600" dirty="0">
                <a:latin typeface="Arial" panose="020B0604020202020204" pitchFamily="34" charset="0"/>
                <a:ea typeface="Calibri" panose="020F0502020204030204" pitchFamily="34" charset="0"/>
                <a:cs typeface="Arial" panose="020B0604020202020204" pitchFamily="34" charset="0"/>
              </a:rPr>
              <a:t> Dynamics of expression changes in human preimplantation embryos of HERV regulatory loci associated with HPAT </a:t>
            </a:r>
            <a:r>
              <a:rPr lang="en-US" sz="1600" dirty="0" err="1">
                <a:latin typeface="Arial" panose="020B0604020202020204" pitchFamily="34" charset="0"/>
                <a:ea typeface="Calibri" panose="020F0502020204030204" pitchFamily="34" charset="0"/>
                <a:cs typeface="Arial" panose="020B0604020202020204" pitchFamily="34" charset="0"/>
              </a:rPr>
              <a:t>lincRNAs</a:t>
            </a:r>
            <a:r>
              <a:rPr lang="en-US" sz="1600" dirty="0">
                <a:latin typeface="Arial" panose="020B0604020202020204" pitchFamily="34" charset="0"/>
                <a:ea typeface="Calibri" panose="020F0502020204030204" pitchFamily="34" charset="0"/>
                <a:cs typeface="Arial" panose="020B0604020202020204" pitchFamily="34" charset="0"/>
              </a:rPr>
              <a:t>. </a:t>
            </a:r>
          </a:p>
          <a:p>
            <a:pPr algn="ctr">
              <a:spcAft>
                <a:spcPts val="1000"/>
              </a:spcAft>
            </a:pPr>
            <a:r>
              <a:rPr lang="en-US" sz="1600" dirty="0">
                <a:latin typeface="Arial" panose="020B0604020202020204" pitchFamily="34" charset="0"/>
                <a:ea typeface="Calibri" panose="020F0502020204030204" pitchFamily="34" charset="0"/>
                <a:cs typeface="Arial" panose="020B0604020202020204" pitchFamily="34" charset="0"/>
              </a:rPr>
              <a:t>Panels (A-F) show the patterns of expression changes defined by the mean expression values of transcripts encoded by the designated loci at corresponding stages of human embryogenesis. Panels (G-J) report the expression values of designated transcripts in 156 individual cells recovered from the human embryos at the designated developmental stages. Results of the additional analyses are reported in the Supplemental Fig. S3. </a:t>
            </a:r>
            <a:endParaRPr lang="en-US" sz="1600" dirty="0">
              <a:effectLst/>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13921973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noGrp="1"/>
          </p:cNvGraphicFramePr>
          <p:nvPr>
            <p:extLst>
              <p:ext uri="{D42A27DB-BD31-4B8C-83A1-F6EECF244321}">
                <p14:modId xmlns:p14="http://schemas.microsoft.com/office/powerpoint/2010/main" val="2323093147"/>
              </p:ext>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3" name="TextBox 2"/>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I</a:t>
            </a:r>
          </a:p>
        </p:txBody>
      </p:sp>
    </p:spTree>
    <p:extLst>
      <p:ext uri="{BB962C8B-B14F-4D97-AF65-F5344CB8AC3E}">
        <p14:creationId xmlns:p14="http://schemas.microsoft.com/office/powerpoint/2010/main" val="2864920135"/>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noGrp="1"/>
          </p:cNvGraphicFramePr>
          <p:nvPr>
            <p:extLst>
              <p:ext uri="{D42A27DB-BD31-4B8C-83A1-F6EECF244321}">
                <p14:modId xmlns:p14="http://schemas.microsoft.com/office/powerpoint/2010/main" val="4199418778"/>
              </p:ext>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3" name="TextBox 2"/>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J</a:t>
            </a:r>
          </a:p>
        </p:txBody>
      </p:sp>
    </p:spTree>
    <p:extLst>
      <p:ext uri="{BB962C8B-B14F-4D97-AF65-F5344CB8AC3E}">
        <p14:creationId xmlns:p14="http://schemas.microsoft.com/office/powerpoint/2010/main" val="83359933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noGrp="1"/>
          </p:cNvGraphicFramePr>
          <p:nvPr>
            <p:extLst>
              <p:ext uri="{D42A27DB-BD31-4B8C-83A1-F6EECF244321}">
                <p14:modId xmlns:p14="http://schemas.microsoft.com/office/powerpoint/2010/main" val="2406357560"/>
              </p:ext>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3" name="TextBox 2"/>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1272312449"/>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noGrp="1"/>
          </p:cNvGraphicFramePr>
          <p:nvPr>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3" name="TextBox 2"/>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1240608208"/>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noGrp="1"/>
          </p:cNvGraphicFramePr>
          <p:nvPr>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3" name="TextBox 2"/>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C</a:t>
            </a:r>
          </a:p>
        </p:txBody>
      </p:sp>
    </p:spTree>
    <p:extLst>
      <p:ext uri="{BB962C8B-B14F-4D97-AF65-F5344CB8AC3E}">
        <p14:creationId xmlns:p14="http://schemas.microsoft.com/office/powerpoint/2010/main" val="398632989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noGrp="1"/>
          </p:cNvGraphicFramePr>
          <p:nvPr>
            <p:extLst>
              <p:ext uri="{D42A27DB-BD31-4B8C-83A1-F6EECF244321}">
                <p14:modId xmlns:p14="http://schemas.microsoft.com/office/powerpoint/2010/main" val="1026523572"/>
              </p:ext>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3" name="TextBox 2"/>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1385437100"/>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noGrp="1"/>
          </p:cNvGraphicFramePr>
          <p:nvPr>
            <p:extLst>
              <p:ext uri="{D42A27DB-BD31-4B8C-83A1-F6EECF244321}">
                <p14:modId xmlns:p14="http://schemas.microsoft.com/office/powerpoint/2010/main" val="1256089392"/>
              </p:ext>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3" name="TextBox 2"/>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E</a:t>
            </a:r>
          </a:p>
        </p:txBody>
      </p:sp>
    </p:spTree>
    <p:extLst>
      <p:ext uri="{BB962C8B-B14F-4D97-AF65-F5344CB8AC3E}">
        <p14:creationId xmlns:p14="http://schemas.microsoft.com/office/powerpoint/2010/main" val="2322867553"/>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noGrp="1"/>
          </p:cNvGraphicFramePr>
          <p:nvPr>
            <p:extLst>
              <p:ext uri="{D42A27DB-BD31-4B8C-83A1-F6EECF244321}">
                <p14:modId xmlns:p14="http://schemas.microsoft.com/office/powerpoint/2010/main" val="336416803"/>
              </p:ext>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3" name="TextBox 2"/>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a:t>
            </a:r>
          </a:p>
        </p:txBody>
      </p:sp>
    </p:spTree>
    <p:extLst>
      <p:ext uri="{BB962C8B-B14F-4D97-AF65-F5344CB8AC3E}">
        <p14:creationId xmlns:p14="http://schemas.microsoft.com/office/powerpoint/2010/main" val="1209569117"/>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Chart 2"/>
          <p:cNvGraphicFramePr>
            <a:graphicFrameLocks noGrp="1"/>
          </p:cNvGraphicFramePr>
          <p:nvPr>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4" name="TextBox 3"/>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G</a:t>
            </a:r>
          </a:p>
        </p:txBody>
      </p:sp>
    </p:spTree>
    <p:extLst>
      <p:ext uri="{BB962C8B-B14F-4D97-AF65-F5344CB8AC3E}">
        <p14:creationId xmlns:p14="http://schemas.microsoft.com/office/powerpoint/2010/main" val="3594227694"/>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noGrp="1"/>
          </p:cNvGraphicFramePr>
          <p:nvPr>
            <p:extLst>
              <p:ext uri="{D42A27DB-BD31-4B8C-83A1-F6EECF244321}">
                <p14:modId xmlns:p14="http://schemas.microsoft.com/office/powerpoint/2010/main" val="1543214116"/>
              </p:ext>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3" name="TextBox 2"/>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H</a:t>
            </a:r>
          </a:p>
        </p:txBody>
      </p:sp>
    </p:spTree>
    <p:extLst>
      <p:ext uri="{BB962C8B-B14F-4D97-AF65-F5344CB8AC3E}">
        <p14:creationId xmlns:p14="http://schemas.microsoft.com/office/powerpoint/2010/main" val="1709731070"/>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050</TotalTime>
  <Words>273</Words>
  <Application>Microsoft Office PowerPoint</Application>
  <PresentationFormat>Widescreen</PresentationFormat>
  <Paragraphs>36</Paragraphs>
  <Slides>1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Manager/>
  <Company/>
  <LinksUpToDate>false</LinksUpToDate>
  <SharedDoc>false</SharedDoc>
  <HyperlinkBase/>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xsi="http://www.w3.org/2001/XMLSchema-instance"/>
</file>